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Ex1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73" r:id="rId3"/>
    <p:sldId id="274" r:id="rId4"/>
    <p:sldId id="277" r:id="rId5"/>
    <p:sldId id="258" r:id="rId6"/>
    <p:sldId id="275" r:id="rId7"/>
    <p:sldId id="276" r:id="rId8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4" autoAdjust="0"/>
    <p:restoredTop sz="94660"/>
  </p:normalViewPr>
  <p:slideViewPr>
    <p:cSldViewPr snapToGrid="0">
      <p:cViewPr>
        <p:scale>
          <a:sx n="200" d="100"/>
          <a:sy n="200" d="100"/>
        </p:scale>
        <p:origin x="-230" y="-226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userId="7ffbdccd425169d1" providerId="LiveId" clId="{83AACE35-95E5-45B5-82D2-C9FD9A6EA21B}"/>
    <pc:docChg chg="modSld">
      <pc:chgData name="" userId="7ffbdccd425169d1" providerId="LiveId" clId="{83AACE35-95E5-45B5-82D2-C9FD9A6EA21B}" dt="2022-01-27T13:53:57.708" v="2"/>
      <pc:docMkLst>
        <pc:docMk/>
      </pc:docMkLst>
      <pc:sldChg chg="modSp">
        <pc:chgData name="" userId="7ffbdccd425169d1" providerId="LiveId" clId="{83AACE35-95E5-45B5-82D2-C9FD9A6EA21B}" dt="2022-01-27T13:53:57.708" v="2"/>
        <pc:sldMkLst>
          <pc:docMk/>
          <pc:sldMk cId="3637131456" sldId="274"/>
        </pc:sldMkLst>
        <pc:spChg chg="mod">
          <ac:chgData name="" userId="7ffbdccd425169d1" providerId="LiveId" clId="{83AACE35-95E5-45B5-82D2-C9FD9A6EA21B}" dt="2022-01-27T13:53:57.708" v="2"/>
          <ac:spMkLst>
            <pc:docMk/>
            <pc:sldMk cId="3637131456" sldId="274"/>
            <ac:spMk id="5" creationId="{EB01E280-162E-491E-BB70-B7437570B277}"/>
          </ac:spMkLst>
        </pc:spChg>
      </pc:sldChg>
    </pc:docChg>
  </pc:docChgLst>
  <pc:docChgLst>
    <pc:chgData userId="7ffbdccd425169d1" providerId="LiveId" clId="{FD8BA5CB-2DC1-4EFB-9878-64D8C8EE83F5}"/>
    <pc:docChg chg="undo custSel addSld delSld modSld">
      <pc:chgData name="" userId="7ffbdccd425169d1" providerId="LiveId" clId="{FD8BA5CB-2DC1-4EFB-9878-64D8C8EE83F5}" dt="2022-01-16T16:11:44.081" v="389" actId="20577"/>
      <pc:docMkLst>
        <pc:docMk/>
      </pc:docMkLst>
      <pc:sldChg chg="addSp delSp modSp">
        <pc:chgData name="" userId="7ffbdccd425169d1" providerId="LiveId" clId="{FD8BA5CB-2DC1-4EFB-9878-64D8C8EE83F5}" dt="2022-01-16T15:04:58.343" v="79" actId="20577"/>
        <pc:sldMkLst>
          <pc:docMk/>
          <pc:sldMk cId="1385977370" sldId="256"/>
        </pc:sldMkLst>
        <pc:spChg chg="mod">
          <ac:chgData name="" userId="7ffbdccd425169d1" providerId="LiveId" clId="{FD8BA5CB-2DC1-4EFB-9878-64D8C8EE83F5}" dt="2022-01-16T15:04:58.343" v="79" actId="20577"/>
          <ac:spMkLst>
            <pc:docMk/>
            <pc:sldMk cId="1385977370" sldId="256"/>
            <ac:spMk id="5" creationId="{EB01E280-162E-491E-BB70-B7437570B277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00" creationId="{CF10B78C-154F-4DF7-88A6-F3AE74935715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01" creationId="{7A688126-2508-468D-8394-9F8DC7B4DEB5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02" creationId="{DB6A88F6-5E9D-4980-913F-B7618726520B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03" creationId="{A0775730-B9AD-40A1-AA33-6A6A49A2E775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04" creationId="{771620B8-2E31-4D9A-9805-295FF6478AD6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11" creationId="{A2E169E7-E342-4F83-A8B0-D55FF71E38D4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12" creationId="{2864CAE9-ABF3-4E81-ACE3-FF39BA8593A0}"/>
          </ac:spMkLst>
        </pc:spChg>
        <pc:spChg chg="mod">
          <ac:chgData name="" userId="7ffbdccd425169d1" providerId="LiveId" clId="{FD8BA5CB-2DC1-4EFB-9878-64D8C8EE83F5}" dt="2022-01-16T15:03:51.522" v="35" actId="122"/>
          <ac:spMkLst>
            <pc:docMk/>
            <pc:sldMk cId="1385977370" sldId="256"/>
            <ac:spMk id="113" creationId="{DC5A9532-09EB-4C58-957A-8FEDB71FA169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14" creationId="{EF672D19-A7C5-4272-A39F-C36DD58F3CCD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15" creationId="{55A29BA1-73C6-419C-8F83-40051B945FC2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16" creationId="{159FD05D-CFE3-4AE3-8DCB-668654645C9E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17" creationId="{106B9B36-B7EC-42A5-AF51-CB95E45B12C8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18" creationId="{70B450D4-EFE9-428E-8D9C-8E2B362CD131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19" creationId="{F94D20A4-6AF4-4B5A-A964-CE29D1BFCE28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20" creationId="{E34F41CC-2ABE-4E7B-9BA4-930002171B4B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21" creationId="{EFA9769A-AFF3-4B87-9B8E-4ECB688A9987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22" creationId="{765DAAA9-0696-4A79-81D0-7C31EF24CD13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23" creationId="{A1F61F43-C040-4D9B-8FD1-D7816F26F050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26" creationId="{68DBDAEF-D858-4889-B075-DCB29EE54AB4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27" creationId="{3B8880C6-3A76-46A3-8A4C-11EB708D02E3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28" creationId="{435C1445-BCA2-4447-8FA4-6938B60B9703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29" creationId="{C4075F59-6F87-4E5E-B7CC-273B98F48615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30" creationId="{A451BB4B-A385-474E-AFCF-D7B170CF9589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36" creationId="{EB53F10F-EACF-4584-BE28-72182E832F94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37" creationId="{065287BC-9F5A-449A-BB97-4158075F4CC4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38" creationId="{67B449B1-4166-41C3-973F-40E0403C4C2E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39" creationId="{198585BE-38DE-4616-8BEC-F80FB59209B9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40" creationId="{5F6D7A2A-A64D-4471-B878-F9615F21632B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41" creationId="{D1C5FD6E-10EE-47A5-B48F-A040AD4D02FF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42" creationId="{B6BC9E12-0AB7-473F-9544-DC159826CD81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43" creationId="{4E0B37FB-08E0-4599-BC18-422D1279ACBA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44" creationId="{3EDF7C71-8323-4FB7-8B90-B021906A6CF2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45" creationId="{41C2BA9E-73CD-4247-A76D-48726CB47805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46" creationId="{D0E92B9D-A8F9-45FA-ABE2-D87EE8E31464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52" creationId="{A02BFFC4-0499-43F4-AE88-83FA59A7DD78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53" creationId="{5F267CB0-3FF1-4893-B864-2EDEAD7BC147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54" creationId="{4F5B010D-BF06-43F4-B701-61ECD58E8D80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55" creationId="{5B376A68-E708-4DDA-8088-C982CE2CA4B2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56" creationId="{13BA5285-397B-45EB-82B7-19E1EDF598B5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62" creationId="{5CA618D3-DD6F-4BE6-9D90-FD6E2EB29A28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63" creationId="{E2B3BAF5-98CD-4F19-B67A-C4343FC0780F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64" creationId="{69129B24-5853-409C-8E38-EE133476BD62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65" creationId="{1981B632-26AE-4672-BD7B-3573CD5367EF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66" creationId="{8BE8E158-CE18-45F9-B9CF-EF854B99CFD5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67" creationId="{D678EBFA-35CA-4A24-8B12-DED5EA549D71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68" creationId="{0AD1B5F4-295B-4405-839A-39B1DD5D995E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69" creationId="{BE449E79-D74E-4195-B10B-EABED53E27A0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70" creationId="{2945EB14-0FF6-497B-9A8E-8E2EEEA5739F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71" creationId="{9F502333-725F-437E-8405-BE3E83A31C6A}"/>
          </ac:spMkLst>
        </pc:spChg>
        <pc:spChg chg="mod">
          <ac:chgData name="" userId="7ffbdccd425169d1" providerId="LiveId" clId="{FD8BA5CB-2DC1-4EFB-9878-64D8C8EE83F5}" dt="2022-01-16T15:03:52.429" v="36" actId="122"/>
          <ac:spMkLst>
            <pc:docMk/>
            <pc:sldMk cId="1385977370" sldId="256"/>
            <ac:spMk id="172" creationId="{2FB45E00-55AC-41C1-82C3-B28431760453}"/>
          </ac:spMkLst>
        </pc:spChg>
        <pc:grpChg chg="add del">
          <ac:chgData name="" userId="7ffbdccd425169d1" providerId="LiveId" clId="{FD8BA5CB-2DC1-4EFB-9878-64D8C8EE83F5}" dt="2022-01-16T14:55:38.768" v="9"/>
          <ac:grpSpMkLst>
            <pc:docMk/>
            <pc:sldMk cId="1385977370" sldId="256"/>
            <ac:grpSpMk id="7" creationId="{F6419C73-AC84-40EC-BEF2-C52C77411442}"/>
          </ac:grpSpMkLst>
        </pc:grpChg>
        <pc:grpChg chg="add del">
          <ac:chgData name="" userId="7ffbdccd425169d1" providerId="LiveId" clId="{FD8BA5CB-2DC1-4EFB-9878-64D8C8EE83F5}" dt="2022-01-16T15:03:43.667" v="32"/>
          <ac:grpSpMkLst>
            <pc:docMk/>
            <pc:sldMk cId="1385977370" sldId="256"/>
            <ac:grpSpMk id="17" creationId="{236F0626-1F6E-4A79-A197-660B12E96680}"/>
          </ac:grpSpMkLst>
        </pc:grpChg>
        <pc:grpChg chg="add del">
          <ac:chgData name="" userId="7ffbdccd425169d1" providerId="LiveId" clId="{FD8BA5CB-2DC1-4EFB-9878-64D8C8EE83F5}" dt="2022-01-16T15:03:43.667" v="32"/>
          <ac:grpSpMkLst>
            <pc:docMk/>
            <pc:sldMk cId="1385977370" sldId="256"/>
            <ac:grpSpMk id="44" creationId="{86A149B8-FCDA-47FA-81BA-500653DEE64A}"/>
          </ac:grpSpMkLst>
        </pc:grpChg>
        <pc:grpChg chg="add del">
          <ac:chgData name="" userId="7ffbdccd425169d1" providerId="LiveId" clId="{FD8BA5CB-2DC1-4EFB-9878-64D8C8EE83F5}" dt="2022-01-16T15:03:43.667" v="32"/>
          <ac:grpSpMkLst>
            <pc:docMk/>
            <pc:sldMk cId="1385977370" sldId="256"/>
            <ac:grpSpMk id="67" creationId="{DD4C4783-2FFC-485C-8235-4FCFCEC512FA}"/>
          </ac:grpSpMkLst>
        </pc:grpChg>
        <pc:grpChg chg="add mod">
          <ac:chgData name="" userId="7ffbdccd425169d1" providerId="LiveId" clId="{FD8BA5CB-2DC1-4EFB-9878-64D8C8EE83F5}" dt="2022-01-16T15:03:57.886" v="37" actId="1076"/>
          <ac:grpSpMkLst>
            <pc:docMk/>
            <pc:sldMk cId="1385977370" sldId="256"/>
            <ac:grpSpMk id="97" creationId="{3EC67DF6-77D6-4759-8428-784865F3E490}"/>
          </ac:grpSpMkLst>
        </pc:grpChg>
        <pc:grpChg chg="add mod">
          <ac:chgData name="" userId="7ffbdccd425169d1" providerId="LiveId" clId="{FD8BA5CB-2DC1-4EFB-9878-64D8C8EE83F5}" dt="2022-01-16T15:03:57.886" v="37" actId="1076"/>
          <ac:grpSpMkLst>
            <pc:docMk/>
            <pc:sldMk cId="1385977370" sldId="256"/>
            <ac:grpSpMk id="124" creationId="{5FA7F8EC-0383-4C05-BAED-12D51AC238A5}"/>
          </ac:grpSpMkLst>
        </pc:grpChg>
        <pc:grpChg chg="add mod">
          <ac:chgData name="" userId="7ffbdccd425169d1" providerId="LiveId" clId="{FD8BA5CB-2DC1-4EFB-9878-64D8C8EE83F5}" dt="2022-01-16T15:03:57.886" v="37" actId="1076"/>
          <ac:grpSpMkLst>
            <pc:docMk/>
            <pc:sldMk cId="1385977370" sldId="256"/>
            <ac:grpSpMk id="147" creationId="{97B2F105-45AE-43EB-9228-F103A46533AD}"/>
          </ac:grpSpMkLst>
        </pc:grpChg>
        <pc:picChg chg="del">
          <ac:chgData name="" userId="7ffbdccd425169d1" providerId="LiveId" clId="{FD8BA5CB-2DC1-4EFB-9878-64D8C8EE83F5}" dt="2022-01-16T15:03:41.690" v="30" actId="478"/>
          <ac:picMkLst>
            <pc:docMk/>
            <pc:sldMk cId="1385977370" sldId="256"/>
            <ac:picMk id="6" creationId="{C0E03731-4728-49A4-BB9C-1CE16D4796F4}"/>
          </ac:picMkLst>
        </pc:picChg>
        <pc:picChg chg="add del">
          <ac:chgData name="" userId="7ffbdccd425169d1" providerId="LiveId" clId="{FD8BA5CB-2DC1-4EFB-9878-64D8C8EE83F5}" dt="2022-01-16T15:03:43.667" v="32"/>
          <ac:picMkLst>
            <pc:docMk/>
            <pc:sldMk cId="1385977370" sldId="256"/>
            <ac:picMk id="15" creationId="{3EBED086-DBEE-433C-B9D3-B958ADB034FC}"/>
          </ac:picMkLst>
        </pc:picChg>
        <pc:picChg chg="add del">
          <ac:chgData name="" userId="7ffbdccd425169d1" providerId="LiveId" clId="{FD8BA5CB-2DC1-4EFB-9878-64D8C8EE83F5}" dt="2022-01-16T15:03:43.667" v="32"/>
          <ac:picMkLst>
            <pc:docMk/>
            <pc:sldMk cId="1385977370" sldId="256"/>
            <ac:picMk id="16" creationId="{15CBF663-446B-4205-8D99-385D62F9FA3D}"/>
          </ac:picMkLst>
        </pc:picChg>
        <pc:picChg chg="add mod">
          <ac:chgData name="" userId="7ffbdccd425169d1" providerId="LiveId" clId="{FD8BA5CB-2DC1-4EFB-9878-64D8C8EE83F5}" dt="2022-01-16T15:03:57.886" v="37" actId="1076"/>
          <ac:picMkLst>
            <pc:docMk/>
            <pc:sldMk cId="1385977370" sldId="256"/>
            <ac:picMk id="95" creationId="{07F14610-6CFA-42C8-BD6F-4233DE839D1B}"/>
          </ac:picMkLst>
        </pc:picChg>
        <pc:picChg chg="add mod">
          <ac:chgData name="" userId="7ffbdccd425169d1" providerId="LiveId" clId="{FD8BA5CB-2DC1-4EFB-9878-64D8C8EE83F5}" dt="2022-01-16T15:03:57.886" v="37" actId="1076"/>
          <ac:picMkLst>
            <pc:docMk/>
            <pc:sldMk cId="1385977370" sldId="256"/>
            <ac:picMk id="96" creationId="{2AAAB80E-B6C1-4090-A053-F580A59A6F5E}"/>
          </ac:picMkLst>
        </pc:picChg>
        <pc:cxnChg chg="add del">
          <ac:chgData name="" userId="7ffbdccd425169d1" providerId="LiveId" clId="{FD8BA5CB-2DC1-4EFB-9878-64D8C8EE83F5}" dt="2022-01-16T15:03:43.667" v="32"/>
          <ac:cxnSpMkLst>
            <pc:docMk/>
            <pc:sldMk cId="1385977370" sldId="256"/>
            <ac:cxnSpMk id="93" creationId="{F2AA7799-7465-42F7-B84B-7A4C4865052F}"/>
          </ac:cxnSpMkLst>
        </pc:cxnChg>
        <pc:cxnChg chg="add del">
          <ac:chgData name="" userId="7ffbdccd425169d1" providerId="LiveId" clId="{FD8BA5CB-2DC1-4EFB-9878-64D8C8EE83F5}" dt="2022-01-16T15:03:43.667" v="32"/>
          <ac:cxnSpMkLst>
            <pc:docMk/>
            <pc:sldMk cId="1385977370" sldId="256"/>
            <ac:cxnSpMk id="94" creationId="{1E7B08E7-401E-46AC-BDC7-E7EC3D1D53DF}"/>
          </ac:cxnSpMkLst>
        </pc:cxnChg>
        <pc:cxnChg chg="add mod">
          <ac:chgData name="" userId="7ffbdccd425169d1" providerId="LiveId" clId="{FD8BA5CB-2DC1-4EFB-9878-64D8C8EE83F5}" dt="2022-01-16T15:03:57.886" v="37" actId="1076"/>
          <ac:cxnSpMkLst>
            <pc:docMk/>
            <pc:sldMk cId="1385977370" sldId="256"/>
            <ac:cxnSpMk id="173" creationId="{52E1B4AE-8E63-40C2-BC24-C58CAB938C38}"/>
          </ac:cxnSpMkLst>
        </pc:cxnChg>
        <pc:cxnChg chg="add mod">
          <ac:chgData name="" userId="7ffbdccd425169d1" providerId="LiveId" clId="{FD8BA5CB-2DC1-4EFB-9878-64D8C8EE83F5}" dt="2022-01-16T15:03:57.886" v="37" actId="1076"/>
          <ac:cxnSpMkLst>
            <pc:docMk/>
            <pc:sldMk cId="1385977370" sldId="256"/>
            <ac:cxnSpMk id="174" creationId="{6259D7A4-4DEF-4B9A-B631-13560FDD8E85}"/>
          </ac:cxnSpMkLst>
        </pc:cxnChg>
      </pc:sldChg>
      <pc:sldChg chg="addSp delSp modSp add">
        <pc:chgData name="" userId="7ffbdccd425169d1" providerId="LiveId" clId="{FD8BA5CB-2DC1-4EFB-9878-64D8C8EE83F5}" dt="2022-01-16T15:45:38.508" v="292" actId="1076"/>
        <pc:sldMkLst>
          <pc:docMk/>
          <pc:sldMk cId="3641326051" sldId="258"/>
        </pc:sldMkLst>
        <pc:spChg chg="add del">
          <ac:chgData name="" userId="7ffbdccd425169d1" providerId="LiveId" clId="{FD8BA5CB-2DC1-4EFB-9878-64D8C8EE83F5}" dt="2022-01-16T15:41:09.773" v="238"/>
          <ac:spMkLst>
            <pc:docMk/>
            <pc:sldMk cId="3641326051" sldId="258"/>
            <ac:spMk id="2" creationId="{7D368185-DCA3-44D1-A398-E5E68C3A6447}"/>
          </ac:spMkLst>
        </pc:spChg>
        <pc:spChg chg="mod">
          <ac:chgData name="" userId="7ffbdccd425169d1" providerId="LiveId" clId="{FD8BA5CB-2DC1-4EFB-9878-64D8C8EE83F5}" dt="2022-01-16T15:45:38.508" v="292" actId="1076"/>
          <ac:spMkLst>
            <pc:docMk/>
            <pc:sldMk cId="3641326051" sldId="258"/>
            <ac:spMk id="5" creationId="{EB01E280-162E-491E-BB70-B7437570B277}"/>
          </ac:spMkLst>
        </pc:spChg>
        <pc:picChg chg="add mod">
          <ac:chgData name="" userId="7ffbdccd425169d1" providerId="LiveId" clId="{FD8BA5CB-2DC1-4EFB-9878-64D8C8EE83F5}" dt="2022-01-16T15:45:34.243" v="291" actId="1076"/>
          <ac:picMkLst>
            <pc:docMk/>
            <pc:sldMk cId="3641326051" sldId="258"/>
            <ac:picMk id="4" creationId="{EAEDA42B-C2CE-41EE-B6B7-D4F4A525A18F}"/>
          </ac:picMkLst>
        </pc:picChg>
        <pc:picChg chg="del">
          <ac:chgData name="" userId="7ffbdccd425169d1" providerId="LiveId" clId="{FD8BA5CB-2DC1-4EFB-9878-64D8C8EE83F5}" dt="2022-01-16T15:45:20.409" v="288" actId="478"/>
          <ac:picMkLst>
            <pc:docMk/>
            <pc:sldMk cId="3641326051" sldId="258"/>
            <ac:picMk id="6" creationId="{C0E03731-4728-49A4-BB9C-1CE16D4796F4}"/>
          </ac:picMkLst>
        </pc:picChg>
      </pc:sldChg>
      <pc:sldChg chg="addSp delSp modSp add">
        <pc:chgData name="" userId="7ffbdccd425169d1" providerId="LiveId" clId="{FD8BA5CB-2DC1-4EFB-9878-64D8C8EE83F5}" dt="2022-01-16T15:23:00.502" v="83" actId="20577"/>
        <pc:sldMkLst>
          <pc:docMk/>
          <pc:sldMk cId="3305337475" sldId="273"/>
        </pc:sldMkLst>
        <pc:spChg chg="del">
          <ac:chgData name="" userId="7ffbdccd425169d1" providerId="LiveId" clId="{FD8BA5CB-2DC1-4EFB-9878-64D8C8EE83F5}" dt="2022-01-16T14:57:42.286" v="22" actId="478"/>
          <ac:spMkLst>
            <pc:docMk/>
            <pc:sldMk cId="3305337475" sldId="273"/>
            <ac:spMk id="6" creationId="{1B86F8D1-24BD-4A3C-96E6-4D2BB9D75630}"/>
          </ac:spMkLst>
        </pc:spChg>
        <pc:spChg chg="del">
          <ac:chgData name="" userId="7ffbdccd425169d1" providerId="LiveId" clId="{FD8BA5CB-2DC1-4EFB-9878-64D8C8EE83F5}" dt="2022-01-16T14:57:42.286" v="22" actId="478"/>
          <ac:spMkLst>
            <pc:docMk/>
            <pc:sldMk cId="3305337475" sldId="273"/>
            <ac:spMk id="7" creationId="{52BFF8AD-5423-41CB-B39E-C63EC43E8EF5}"/>
          </ac:spMkLst>
        </pc:spChg>
        <pc:spChg chg="del">
          <ac:chgData name="" userId="7ffbdccd425169d1" providerId="LiveId" clId="{FD8BA5CB-2DC1-4EFB-9878-64D8C8EE83F5}" dt="2022-01-16T14:57:42.286" v="22" actId="478"/>
          <ac:spMkLst>
            <pc:docMk/>
            <pc:sldMk cId="3305337475" sldId="273"/>
            <ac:spMk id="8" creationId="{2968D633-49B8-411C-AAB5-E63287D7E923}"/>
          </ac:spMkLst>
        </pc:spChg>
        <pc:spChg chg="del">
          <ac:chgData name="" userId="7ffbdccd425169d1" providerId="LiveId" clId="{FD8BA5CB-2DC1-4EFB-9878-64D8C8EE83F5}" dt="2022-01-16T14:57:42.286" v="22" actId="478"/>
          <ac:spMkLst>
            <pc:docMk/>
            <pc:sldMk cId="3305337475" sldId="273"/>
            <ac:spMk id="9" creationId="{647C016D-FE16-427F-9FBA-A706974D306F}"/>
          </ac:spMkLst>
        </pc:spChg>
        <pc:spChg chg="del">
          <ac:chgData name="" userId="7ffbdccd425169d1" providerId="LiveId" clId="{FD8BA5CB-2DC1-4EFB-9878-64D8C8EE83F5}" dt="2022-01-16T14:57:42.286" v="22" actId="478"/>
          <ac:spMkLst>
            <pc:docMk/>
            <pc:sldMk cId="3305337475" sldId="273"/>
            <ac:spMk id="10" creationId="{D410EC4C-8528-471A-AB03-7BBE032689B2}"/>
          </ac:spMkLst>
        </pc:spChg>
        <pc:spChg chg="del">
          <ac:chgData name="" userId="7ffbdccd425169d1" providerId="LiveId" clId="{FD8BA5CB-2DC1-4EFB-9878-64D8C8EE83F5}" dt="2022-01-16T14:57:42.286" v="22" actId="478"/>
          <ac:spMkLst>
            <pc:docMk/>
            <pc:sldMk cId="3305337475" sldId="273"/>
            <ac:spMk id="14" creationId="{B3E9A5F6-59D8-422C-B163-2DCD5179D69F}"/>
          </ac:spMkLst>
        </pc:spChg>
        <pc:spChg chg="del">
          <ac:chgData name="" userId="7ffbdccd425169d1" providerId="LiveId" clId="{FD8BA5CB-2DC1-4EFB-9878-64D8C8EE83F5}" dt="2022-01-16T14:57:42.286" v="22" actId="478"/>
          <ac:spMkLst>
            <pc:docMk/>
            <pc:sldMk cId="3305337475" sldId="273"/>
            <ac:spMk id="16" creationId="{DF27A971-BAB5-4661-8AB1-08C8A1EE24F1}"/>
          </ac:spMkLst>
        </pc:spChg>
        <pc:spChg chg="del">
          <ac:chgData name="" userId="7ffbdccd425169d1" providerId="LiveId" clId="{FD8BA5CB-2DC1-4EFB-9878-64D8C8EE83F5}" dt="2022-01-16T14:57:42.286" v="22" actId="478"/>
          <ac:spMkLst>
            <pc:docMk/>
            <pc:sldMk cId="3305337475" sldId="273"/>
            <ac:spMk id="19" creationId="{3E91F359-C3C7-42F5-BC06-03A8CEBE2752}"/>
          </ac:spMkLst>
        </pc:spChg>
        <pc:spChg chg="del">
          <ac:chgData name="" userId="7ffbdccd425169d1" providerId="LiveId" clId="{FD8BA5CB-2DC1-4EFB-9878-64D8C8EE83F5}" dt="2022-01-16T14:57:42.286" v="22" actId="478"/>
          <ac:spMkLst>
            <pc:docMk/>
            <pc:sldMk cId="3305337475" sldId="273"/>
            <ac:spMk id="20" creationId="{D4AB723E-73C1-4D29-BDE9-F2CAF7036B10}"/>
          </ac:spMkLst>
        </pc:spChg>
        <pc:spChg chg="del">
          <ac:chgData name="" userId="7ffbdccd425169d1" providerId="LiveId" clId="{FD8BA5CB-2DC1-4EFB-9878-64D8C8EE83F5}" dt="2022-01-16T14:57:43.756" v="23" actId="478"/>
          <ac:spMkLst>
            <pc:docMk/>
            <pc:sldMk cId="3305337475" sldId="273"/>
            <ac:spMk id="21" creationId="{A8AFADE8-BF57-4F24-9320-B83415E145FF}"/>
          </ac:spMkLst>
        </pc:spChg>
        <pc:spChg chg="add mod">
          <ac:chgData name="" userId="7ffbdccd425169d1" providerId="LiveId" clId="{FD8BA5CB-2DC1-4EFB-9878-64D8C8EE83F5}" dt="2022-01-16T15:23:00.502" v="83" actId="20577"/>
          <ac:spMkLst>
            <pc:docMk/>
            <pc:sldMk cId="3305337475" sldId="273"/>
            <ac:spMk id="32" creationId="{15F19F09-CA21-478D-A66D-5FCA6BA983AA}"/>
          </ac:spMkLst>
        </pc:spChg>
        <pc:graphicFrameChg chg="del">
          <ac:chgData name="" userId="7ffbdccd425169d1" providerId="LiveId" clId="{FD8BA5CB-2DC1-4EFB-9878-64D8C8EE83F5}" dt="2022-01-16T14:57:38.924" v="21" actId="478"/>
          <ac:graphicFrameMkLst>
            <pc:docMk/>
            <pc:sldMk cId="3305337475" sldId="273"/>
            <ac:graphicFrameMk id="4" creationId="{6D2A241A-A367-4DA7-88D8-FFDF4CA1D454}"/>
          </ac:graphicFrameMkLst>
        </pc:graphicFrameChg>
        <pc:graphicFrameChg chg="del">
          <ac:chgData name="" userId="7ffbdccd425169d1" providerId="LiveId" clId="{FD8BA5CB-2DC1-4EFB-9878-64D8C8EE83F5}" dt="2022-01-16T14:57:38.924" v="21" actId="478"/>
          <ac:graphicFrameMkLst>
            <pc:docMk/>
            <pc:sldMk cId="3305337475" sldId="273"/>
            <ac:graphicFrameMk id="13" creationId="{53DC55E0-6721-41F4-9A89-D176A17B6928}"/>
          </ac:graphicFrameMkLst>
        </pc:graphicFrameChg>
        <pc:graphicFrameChg chg="del">
          <ac:chgData name="" userId="7ffbdccd425169d1" providerId="LiveId" clId="{FD8BA5CB-2DC1-4EFB-9878-64D8C8EE83F5}" dt="2022-01-16T14:57:38.924" v="21" actId="478"/>
          <ac:graphicFrameMkLst>
            <pc:docMk/>
            <pc:sldMk cId="3305337475" sldId="273"/>
            <ac:graphicFrameMk id="18" creationId="{1C7B182B-AD67-4051-BA7F-B9D38FE6A9C3}"/>
          </ac:graphicFrameMkLst>
        </pc:graphicFrameChg>
      </pc:sldChg>
      <pc:sldChg chg="modSp add">
        <pc:chgData name="" userId="7ffbdccd425169d1" providerId="LiveId" clId="{FD8BA5CB-2DC1-4EFB-9878-64D8C8EE83F5}" dt="2022-01-16T15:06:42.744" v="81" actId="20577"/>
        <pc:sldMkLst>
          <pc:docMk/>
          <pc:sldMk cId="3637131456" sldId="274"/>
        </pc:sldMkLst>
        <pc:spChg chg="mod">
          <ac:chgData name="" userId="7ffbdccd425169d1" providerId="LiveId" clId="{FD8BA5CB-2DC1-4EFB-9878-64D8C8EE83F5}" dt="2022-01-16T15:06:42.744" v="81" actId="20577"/>
          <ac:spMkLst>
            <pc:docMk/>
            <pc:sldMk cId="3637131456" sldId="274"/>
            <ac:spMk id="5" creationId="{EB01E280-162E-491E-BB70-B7437570B277}"/>
          </ac:spMkLst>
        </pc:spChg>
      </pc:sldChg>
      <pc:sldChg chg="addSp delSp modSp add">
        <pc:chgData name="" userId="7ffbdccd425169d1" providerId="LiveId" clId="{FD8BA5CB-2DC1-4EFB-9878-64D8C8EE83F5}" dt="2022-01-16T15:42:14.228" v="247" actId="1076"/>
        <pc:sldMkLst>
          <pc:docMk/>
          <pc:sldMk cId="1565094334" sldId="275"/>
        </pc:sldMkLst>
        <pc:spChg chg="add mod">
          <ac:chgData name="" userId="7ffbdccd425169d1" providerId="LiveId" clId="{FD8BA5CB-2DC1-4EFB-9878-64D8C8EE83F5}" dt="2022-01-16T15:42:08.365" v="245" actId="1076"/>
          <ac:spMkLst>
            <pc:docMk/>
            <pc:sldMk cId="1565094334" sldId="275"/>
            <ac:spMk id="4" creationId="{AC7792ED-78DA-48D2-8803-DADA748CBB0A}"/>
          </ac:spMkLst>
        </pc:spChg>
        <pc:spChg chg="mod">
          <ac:chgData name="" userId="7ffbdccd425169d1" providerId="LiveId" clId="{FD8BA5CB-2DC1-4EFB-9878-64D8C8EE83F5}" dt="2022-01-16T15:42:14.228" v="247" actId="1076"/>
          <ac:spMkLst>
            <pc:docMk/>
            <pc:sldMk cId="1565094334" sldId="275"/>
            <ac:spMk id="5" creationId="{EB01E280-162E-491E-BB70-B7437570B277}"/>
          </ac:spMkLst>
        </pc:spChg>
        <pc:spChg chg="add mod">
          <ac:chgData name="" userId="7ffbdccd425169d1" providerId="LiveId" clId="{FD8BA5CB-2DC1-4EFB-9878-64D8C8EE83F5}" dt="2022-01-16T15:42:08.365" v="245" actId="1076"/>
          <ac:spMkLst>
            <pc:docMk/>
            <pc:sldMk cId="1565094334" sldId="275"/>
            <ac:spMk id="8" creationId="{8FA5F3FA-093F-44EE-AFA1-315EDA473F80}"/>
          </ac:spMkLst>
        </pc:spChg>
        <pc:spChg chg="add mod">
          <ac:chgData name="" userId="7ffbdccd425169d1" providerId="LiveId" clId="{FD8BA5CB-2DC1-4EFB-9878-64D8C8EE83F5}" dt="2022-01-16T15:42:08.365" v="245" actId="1076"/>
          <ac:spMkLst>
            <pc:docMk/>
            <pc:sldMk cId="1565094334" sldId="275"/>
            <ac:spMk id="9" creationId="{05A897AA-8B34-422E-BCFC-DA5D0D190E81}"/>
          </ac:spMkLst>
        </pc:spChg>
        <pc:spChg chg="add mod">
          <ac:chgData name="" userId="7ffbdccd425169d1" providerId="LiveId" clId="{FD8BA5CB-2DC1-4EFB-9878-64D8C8EE83F5}" dt="2022-01-16T15:42:08.365" v="245" actId="1076"/>
          <ac:spMkLst>
            <pc:docMk/>
            <pc:sldMk cId="1565094334" sldId="275"/>
            <ac:spMk id="10" creationId="{D63EB8FA-2E4C-41DF-8A66-91652CD1048E}"/>
          </ac:spMkLst>
        </pc:spChg>
        <pc:spChg chg="add mod">
          <ac:chgData name="" userId="7ffbdccd425169d1" providerId="LiveId" clId="{FD8BA5CB-2DC1-4EFB-9878-64D8C8EE83F5}" dt="2022-01-16T15:42:08.365" v="245" actId="1076"/>
          <ac:spMkLst>
            <pc:docMk/>
            <pc:sldMk cId="1565094334" sldId="275"/>
            <ac:spMk id="17" creationId="{99815400-F736-468C-8B17-96A279AF652A}"/>
          </ac:spMkLst>
        </pc:spChg>
        <pc:spChg chg="add mod">
          <ac:chgData name="" userId="7ffbdccd425169d1" providerId="LiveId" clId="{FD8BA5CB-2DC1-4EFB-9878-64D8C8EE83F5}" dt="2022-01-16T15:42:08.365" v="245" actId="1076"/>
          <ac:spMkLst>
            <pc:docMk/>
            <pc:sldMk cId="1565094334" sldId="275"/>
            <ac:spMk id="18" creationId="{932CC06D-2C01-400F-B033-8C5E6D279320}"/>
          </ac:spMkLst>
        </pc:spChg>
        <pc:graphicFrameChg chg="add mod">
          <ac:chgData name="" userId="7ffbdccd425169d1" providerId="LiveId" clId="{FD8BA5CB-2DC1-4EFB-9878-64D8C8EE83F5}" dt="2022-01-16T15:42:08.365" v="245" actId="1076"/>
          <ac:graphicFrameMkLst>
            <pc:docMk/>
            <pc:sldMk cId="1565094334" sldId="275"/>
            <ac:graphicFrameMk id="7" creationId="{36286848-776D-4C60-A786-06A9401B099D}"/>
          </ac:graphicFrameMkLst>
        </pc:graphicFrameChg>
        <pc:picChg chg="del">
          <ac:chgData name="" userId="7ffbdccd425169d1" providerId="LiveId" clId="{FD8BA5CB-2DC1-4EFB-9878-64D8C8EE83F5}" dt="2022-01-16T15:42:02.004" v="243" actId="478"/>
          <ac:picMkLst>
            <pc:docMk/>
            <pc:sldMk cId="1565094334" sldId="275"/>
            <ac:picMk id="6" creationId="{C0E03731-4728-49A4-BB9C-1CE16D4796F4}"/>
          </ac:picMkLst>
        </pc:picChg>
        <pc:cxnChg chg="add mod">
          <ac:chgData name="" userId="7ffbdccd425169d1" providerId="LiveId" clId="{FD8BA5CB-2DC1-4EFB-9878-64D8C8EE83F5}" dt="2022-01-16T15:42:08.365" v="245" actId="1076"/>
          <ac:cxnSpMkLst>
            <pc:docMk/>
            <pc:sldMk cId="1565094334" sldId="275"/>
            <ac:cxnSpMk id="11" creationId="{6B804F96-1432-4FF3-8B1C-1A19661BFFF8}"/>
          </ac:cxnSpMkLst>
        </pc:cxnChg>
        <pc:cxnChg chg="add mod">
          <ac:chgData name="" userId="7ffbdccd425169d1" providerId="LiveId" clId="{FD8BA5CB-2DC1-4EFB-9878-64D8C8EE83F5}" dt="2022-01-16T15:42:08.365" v="245" actId="1076"/>
          <ac:cxnSpMkLst>
            <pc:docMk/>
            <pc:sldMk cId="1565094334" sldId="275"/>
            <ac:cxnSpMk id="12" creationId="{FFA3321F-CA8C-4CDF-98F7-40462E84F92D}"/>
          </ac:cxnSpMkLst>
        </pc:cxnChg>
        <pc:cxnChg chg="add mod">
          <ac:chgData name="" userId="7ffbdccd425169d1" providerId="LiveId" clId="{FD8BA5CB-2DC1-4EFB-9878-64D8C8EE83F5}" dt="2022-01-16T15:42:08.365" v="245" actId="1076"/>
          <ac:cxnSpMkLst>
            <pc:docMk/>
            <pc:sldMk cId="1565094334" sldId="275"/>
            <ac:cxnSpMk id="13" creationId="{A8D882D0-64FE-4E26-A21F-D07C88F001E0}"/>
          </ac:cxnSpMkLst>
        </pc:cxnChg>
        <pc:cxnChg chg="add mod">
          <ac:chgData name="" userId="7ffbdccd425169d1" providerId="LiveId" clId="{FD8BA5CB-2DC1-4EFB-9878-64D8C8EE83F5}" dt="2022-01-16T15:42:08.365" v="245" actId="1076"/>
          <ac:cxnSpMkLst>
            <pc:docMk/>
            <pc:sldMk cId="1565094334" sldId="275"/>
            <ac:cxnSpMk id="14" creationId="{E6981896-C6E8-442D-8A1D-49100E0FBF63}"/>
          </ac:cxnSpMkLst>
        </pc:cxnChg>
        <pc:cxnChg chg="add mod">
          <ac:chgData name="" userId="7ffbdccd425169d1" providerId="LiveId" clId="{FD8BA5CB-2DC1-4EFB-9878-64D8C8EE83F5}" dt="2022-01-16T15:42:08.365" v="245" actId="1076"/>
          <ac:cxnSpMkLst>
            <pc:docMk/>
            <pc:sldMk cId="1565094334" sldId="275"/>
            <ac:cxnSpMk id="15" creationId="{E82F070E-2A96-4710-948A-9BE0CC0C6082}"/>
          </ac:cxnSpMkLst>
        </pc:cxnChg>
        <pc:cxnChg chg="add mod">
          <ac:chgData name="" userId="7ffbdccd425169d1" providerId="LiveId" clId="{FD8BA5CB-2DC1-4EFB-9878-64D8C8EE83F5}" dt="2022-01-16T15:42:08.365" v="245" actId="1076"/>
          <ac:cxnSpMkLst>
            <pc:docMk/>
            <pc:sldMk cId="1565094334" sldId="275"/>
            <ac:cxnSpMk id="16" creationId="{B8248CF5-004B-4135-AB4C-E962230A0547}"/>
          </ac:cxnSpMkLst>
        </pc:cxnChg>
      </pc:sldChg>
      <pc:sldChg chg="addSp delSp modSp add">
        <pc:chgData name="" userId="7ffbdccd425169d1" providerId="LiveId" clId="{FD8BA5CB-2DC1-4EFB-9878-64D8C8EE83F5}" dt="2022-01-16T16:11:44.081" v="389" actId="20577"/>
        <pc:sldMkLst>
          <pc:docMk/>
          <pc:sldMk cId="3228089283" sldId="276"/>
        </pc:sldMkLst>
        <pc:spChg chg="add del">
          <ac:chgData name="" userId="7ffbdccd425169d1" providerId="LiveId" clId="{FD8BA5CB-2DC1-4EFB-9878-64D8C8EE83F5}" dt="2022-01-16T15:48:05.005" v="303"/>
          <ac:spMkLst>
            <pc:docMk/>
            <pc:sldMk cId="3228089283" sldId="276"/>
            <ac:spMk id="2" creationId="{2FC4C76F-1022-4745-9698-14F207C7A710}"/>
          </ac:spMkLst>
        </pc:spChg>
        <pc:spChg chg="del">
          <ac:chgData name="" userId="7ffbdccd425169d1" providerId="LiveId" clId="{FD8BA5CB-2DC1-4EFB-9878-64D8C8EE83F5}" dt="2022-01-16T15:48:39.424" v="311" actId="478"/>
          <ac:spMkLst>
            <pc:docMk/>
            <pc:sldMk cId="3228089283" sldId="276"/>
            <ac:spMk id="4" creationId="{AC7792ED-78DA-48D2-8803-DADA748CBB0A}"/>
          </ac:spMkLst>
        </pc:spChg>
        <pc:spChg chg="mod">
          <ac:chgData name="" userId="7ffbdccd425169d1" providerId="LiveId" clId="{FD8BA5CB-2DC1-4EFB-9878-64D8C8EE83F5}" dt="2022-01-16T16:11:44.081" v="389" actId="20577"/>
          <ac:spMkLst>
            <pc:docMk/>
            <pc:sldMk cId="3228089283" sldId="276"/>
            <ac:spMk id="5" creationId="{EB01E280-162E-491E-BB70-B7437570B277}"/>
          </ac:spMkLst>
        </pc:spChg>
        <pc:spChg chg="del">
          <ac:chgData name="" userId="7ffbdccd425169d1" providerId="LiveId" clId="{FD8BA5CB-2DC1-4EFB-9878-64D8C8EE83F5}" dt="2022-01-16T15:48:39.424" v="311" actId="478"/>
          <ac:spMkLst>
            <pc:docMk/>
            <pc:sldMk cId="3228089283" sldId="276"/>
            <ac:spMk id="8" creationId="{8FA5F3FA-093F-44EE-AFA1-315EDA473F80}"/>
          </ac:spMkLst>
        </pc:spChg>
        <pc:spChg chg="del">
          <ac:chgData name="" userId="7ffbdccd425169d1" providerId="LiveId" clId="{FD8BA5CB-2DC1-4EFB-9878-64D8C8EE83F5}" dt="2022-01-16T15:48:39.424" v="311" actId="478"/>
          <ac:spMkLst>
            <pc:docMk/>
            <pc:sldMk cId="3228089283" sldId="276"/>
            <ac:spMk id="9" creationId="{05A897AA-8B34-422E-BCFC-DA5D0D190E81}"/>
          </ac:spMkLst>
        </pc:spChg>
        <pc:spChg chg="del">
          <ac:chgData name="" userId="7ffbdccd425169d1" providerId="LiveId" clId="{FD8BA5CB-2DC1-4EFB-9878-64D8C8EE83F5}" dt="2022-01-16T15:48:39.424" v="311" actId="478"/>
          <ac:spMkLst>
            <pc:docMk/>
            <pc:sldMk cId="3228089283" sldId="276"/>
            <ac:spMk id="10" creationId="{D63EB8FA-2E4C-41DF-8A66-91652CD1048E}"/>
          </ac:spMkLst>
        </pc:spChg>
        <pc:spChg chg="del">
          <ac:chgData name="" userId="7ffbdccd425169d1" providerId="LiveId" clId="{FD8BA5CB-2DC1-4EFB-9878-64D8C8EE83F5}" dt="2022-01-16T15:48:39.424" v="311" actId="478"/>
          <ac:spMkLst>
            <pc:docMk/>
            <pc:sldMk cId="3228089283" sldId="276"/>
            <ac:spMk id="17" creationId="{99815400-F736-468C-8B17-96A279AF652A}"/>
          </ac:spMkLst>
        </pc:spChg>
        <pc:spChg chg="del">
          <ac:chgData name="" userId="7ffbdccd425169d1" providerId="LiveId" clId="{FD8BA5CB-2DC1-4EFB-9878-64D8C8EE83F5}" dt="2022-01-16T15:48:39.424" v="311" actId="478"/>
          <ac:spMkLst>
            <pc:docMk/>
            <pc:sldMk cId="3228089283" sldId="276"/>
            <ac:spMk id="18" creationId="{932CC06D-2C01-400F-B033-8C5E6D279320}"/>
          </ac:spMkLst>
        </pc:spChg>
        <pc:spChg chg="add del">
          <ac:chgData name="" userId="7ffbdccd425169d1" providerId="LiveId" clId="{FD8BA5CB-2DC1-4EFB-9878-64D8C8EE83F5}" dt="2022-01-16T15:52:23.348" v="313"/>
          <ac:spMkLst>
            <pc:docMk/>
            <pc:sldMk cId="3228089283" sldId="276"/>
            <ac:spMk id="19" creationId="{6EB3906A-3077-40F9-A69B-80F14A08279F}"/>
          </ac:spMkLst>
        </pc:spChg>
        <pc:spChg chg="add del">
          <ac:chgData name="" userId="7ffbdccd425169d1" providerId="LiveId" clId="{FD8BA5CB-2DC1-4EFB-9878-64D8C8EE83F5}" dt="2022-01-16T15:52:23.348" v="313"/>
          <ac:spMkLst>
            <pc:docMk/>
            <pc:sldMk cId="3228089283" sldId="276"/>
            <ac:spMk id="21" creationId="{1E366DC4-DB62-4330-A13C-6EC6500E6D5D}"/>
          </ac:spMkLst>
        </pc:spChg>
        <pc:spChg chg="add del">
          <ac:chgData name="" userId="7ffbdccd425169d1" providerId="LiveId" clId="{FD8BA5CB-2DC1-4EFB-9878-64D8C8EE83F5}" dt="2022-01-16T15:52:23.348" v="313"/>
          <ac:spMkLst>
            <pc:docMk/>
            <pc:sldMk cId="3228089283" sldId="276"/>
            <ac:spMk id="22" creationId="{EFB30E18-E506-4FA6-B26C-BA1FD62BB723}"/>
          </ac:spMkLst>
        </pc:spChg>
        <pc:spChg chg="add del">
          <ac:chgData name="" userId="7ffbdccd425169d1" providerId="LiveId" clId="{FD8BA5CB-2DC1-4EFB-9878-64D8C8EE83F5}" dt="2022-01-16T15:52:23.348" v="313"/>
          <ac:spMkLst>
            <pc:docMk/>
            <pc:sldMk cId="3228089283" sldId="276"/>
            <ac:spMk id="23" creationId="{8DA7765D-617B-481B-AB0C-F195E1E6F1E9}"/>
          </ac:spMkLst>
        </pc:spChg>
        <pc:spChg chg="add del">
          <ac:chgData name="" userId="7ffbdccd425169d1" providerId="LiveId" clId="{FD8BA5CB-2DC1-4EFB-9878-64D8C8EE83F5}" dt="2022-01-16T15:52:23.348" v="313"/>
          <ac:spMkLst>
            <pc:docMk/>
            <pc:sldMk cId="3228089283" sldId="276"/>
            <ac:spMk id="24" creationId="{8AABEADA-D6C6-4262-9741-4DA798532751}"/>
          </ac:spMkLst>
        </pc:spChg>
        <pc:spChg chg="add del">
          <ac:chgData name="" userId="7ffbdccd425169d1" providerId="LiveId" clId="{FD8BA5CB-2DC1-4EFB-9878-64D8C8EE83F5}" dt="2022-01-16T15:52:23.348" v="313"/>
          <ac:spMkLst>
            <pc:docMk/>
            <pc:sldMk cId="3228089283" sldId="276"/>
            <ac:spMk id="25" creationId="{7C00FAB3-4632-4CDA-B1D7-2BFF7CFB7078}"/>
          </ac:spMkLst>
        </pc:spChg>
        <pc:spChg chg="add mod">
          <ac:chgData name="" userId="7ffbdccd425169d1" providerId="LiveId" clId="{FD8BA5CB-2DC1-4EFB-9878-64D8C8EE83F5}" dt="2022-01-16T15:56:31.715" v="386" actId="404"/>
          <ac:spMkLst>
            <pc:docMk/>
            <pc:sldMk cId="3228089283" sldId="276"/>
            <ac:spMk id="28" creationId="{EADF8BD8-8F11-4459-A605-2EE07C37610B}"/>
          </ac:spMkLst>
        </pc:spChg>
        <pc:spChg chg="add del mod">
          <ac:chgData name="" userId="7ffbdccd425169d1" providerId="LiveId" clId="{FD8BA5CB-2DC1-4EFB-9878-64D8C8EE83F5}" dt="2022-01-16T15:54:37.078" v="347" actId="478"/>
          <ac:spMkLst>
            <pc:docMk/>
            <pc:sldMk cId="3228089283" sldId="276"/>
            <ac:spMk id="30" creationId="{EECD3065-4930-4AE8-9A23-AEAF3FA32349}"/>
          </ac:spMkLst>
        </pc:spChg>
        <pc:spChg chg="add mod">
          <ac:chgData name="" userId="7ffbdccd425169d1" providerId="LiveId" clId="{FD8BA5CB-2DC1-4EFB-9878-64D8C8EE83F5}" dt="2022-01-16T15:56:31.715" v="386" actId="404"/>
          <ac:spMkLst>
            <pc:docMk/>
            <pc:sldMk cId="3228089283" sldId="276"/>
            <ac:spMk id="31" creationId="{1E704A64-1790-4DDC-89F6-A1436FE66EB8}"/>
          </ac:spMkLst>
        </pc:spChg>
        <pc:spChg chg="add del mod">
          <ac:chgData name="" userId="7ffbdccd425169d1" providerId="LiveId" clId="{FD8BA5CB-2DC1-4EFB-9878-64D8C8EE83F5}" dt="2022-01-16T15:54:37.078" v="347" actId="478"/>
          <ac:spMkLst>
            <pc:docMk/>
            <pc:sldMk cId="3228089283" sldId="276"/>
            <ac:spMk id="32" creationId="{D8B9FEBF-DDAB-4F62-A0AE-6ECC26038FEE}"/>
          </ac:spMkLst>
        </pc:spChg>
        <pc:spChg chg="add mod">
          <ac:chgData name="" userId="7ffbdccd425169d1" providerId="LiveId" clId="{FD8BA5CB-2DC1-4EFB-9878-64D8C8EE83F5}" dt="2022-01-16T15:56:38.894" v="387" actId="1076"/>
          <ac:spMkLst>
            <pc:docMk/>
            <pc:sldMk cId="3228089283" sldId="276"/>
            <ac:spMk id="33" creationId="{04AA833A-15AE-4DA9-841A-079BB85A45C7}"/>
          </ac:spMkLst>
        </pc:spChg>
        <pc:spChg chg="add del">
          <ac:chgData name="" userId="7ffbdccd425169d1" providerId="LiveId" clId="{FD8BA5CB-2DC1-4EFB-9878-64D8C8EE83F5}" dt="2022-01-16T15:54:40.725" v="349" actId="478"/>
          <ac:spMkLst>
            <pc:docMk/>
            <pc:sldMk cId="3228089283" sldId="276"/>
            <ac:spMk id="34" creationId="{916B6E5B-B5CC-4A1C-90DB-0715A7070B6E}"/>
          </ac:spMkLst>
        </pc:spChg>
        <pc:spChg chg="add mod">
          <ac:chgData name="" userId="7ffbdccd425169d1" providerId="LiveId" clId="{FD8BA5CB-2DC1-4EFB-9878-64D8C8EE83F5}" dt="2022-01-16T15:55:12.579" v="359" actId="1076"/>
          <ac:spMkLst>
            <pc:docMk/>
            <pc:sldMk cId="3228089283" sldId="276"/>
            <ac:spMk id="37" creationId="{12B365CC-0C3A-4BD0-A87D-C990B37AFF6C}"/>
          </ac:spMkLst>
        </pc:spChg>
        <pc:spChg chg="add mod">
          <ac:chgData name="" userId="7ffbdccd425169d1" providerId="LiveId" clId="{FD8BA5CB-2DC1-4EFB-9878-64D8C8EE83F5}" dt="2022-01-16T15:56:12.665" v="382" actId="1076"/>
          <ac:spMkLst>
            <pc:docMk/>
            <pc:sldMk cId="3228089283" sldId="276"/>
            <ac:spMk id="38" creationId="{9123674A-FE28-46CD-B899-AFAE08FF90DA}"/>
          </ac:spMkLst>
        </pc:spChg>
        <pc:spChg chg="add mod">
          <ac:chgData name="" userId="7ffbdccd425169d1" providerId="LiveId" clId="{FD8BA5CB-2DC1-4EFB-9878-64D8C8EE83F5}" dt="2022-01-16T15:56:12.665" v="382" actId="1076"/>
          <ac:spMkLst>
            <pc:docMk/>
            <pc:sldMk cId="3228089283" sldId="276"/>
            <ac:spMk id="39" creationId="{D4742708-134E-4159-8928-8859FCF5ED95}"/>
          </ac:spMkLst>
        </pc:spChg>
        <pc:graphicFrameChg chg="del">
          <ac:chgData name="" userId="7ffbdccd425169d1" providerId="LiveId" clId="{FD8BA5CB-2DC1-4EFB-9878-64D8C8EE83F5}" dt="2022-01-16T15:48:39.424" v="311" actId="478"/>
          <ac:graphicFrameMkLst>
            <pc:docMk/>
            <pc:sldMk cId="3228089283" sldId="276"/>
            <ac:graphicFrameMk id="7" creationId="{36286848-776D-4C60-A786-06A9401B099D}"/>
          </ac:graphicFrameMkLst>
        </pc:graphicFrameChg>
        <pc:picChg chg="add del">
          <ac:chgData name="" userId="7ffbdccd425169d1" providerId="LiveId" clId="{FD8BA5CB-2DC1-4EFB-9878-64D8C8EE83F5}" dt="2022-01-16T15:52:23.348" v="313"/>
          <ac:picMkLst>
            <pc:docMk/>
            <pc:sldMk cId="3228089283" sldId="276"/>
            <ac:picMk id="20" creationId="{AA8BD795-82D7-4232-9644-6C35EFD45C58}"/>
          </ac:picMkLst>
        </pc:picChg>
        <pc:picChg chg="add del">
          <ac:chgData name="" userId="7ffbdccd425169d1" providerId="LiveId" clId="{FD8BA5CB-2DC1-4EFB-9878-64D8C8EE83F5}" dt="2022-01-16T15:52:23.348" v="313"/>
          <ac:picMkLst>
            <pc:docMk/>
            <pc:sldMk cId="3228089283" sldId="276"/>
            <ac:picMk id="26" creationId="{5346E675-718E-4BED-935B-51A1CBBA292A}"/>
          </ac:picMkLst>
        </pc:picChg>
        <pc:picChg chg="add del">
          <ac:chgData name="" userId="7ffbdccd425169d1" providerId="LiveId" clId="{FD8BA5CB-2DC1-4EFB-9878-64D8C8EE83F5}" dt="2022-01-16T15:52:23.348" v="313"/>
          <ac:picMkLst>
            <pc:docMk/>
            <pc:sldMk cId="3228089283" sldId="276"/>
            <ac:picMk id="27" creationId="{B850E595-07CD-4FF6-BFE5-4CF1C60BB8B8}"/>
          </ac:picMkLst>
        </pc:picChg>
        <pc:picChg chg="add mod">
          <ac:chgData name="" userId="7ffbdccd425169d1" providerId="LiveId" clId="{FD8BA5CB-2DC1-4EFB-9878-64D8C8EE83F5}" dt="2022-01-16T15:54:26.674" v="346" actId="1076"/>
          <ac:picMkLst>
            <pc:docMk/>
            <pc:sldMk cId="3228089283" sldId="276"/>
            <ac:picMk id="29" creationId="{A940E22B-2026-40BE-AB5F-E5B23719B38F}"/>
          </ac:picMkLst>
        </pc:picChg>
        <pc:picChg chg="add mod">
          <ac:chgData name="" userId="7ffbdccd425169d1" providerId="LiveId" clId="{FD8BA5CB-2DC1-4EFB-9878-64D8C8EE83F5}" dt="2022-01-16T15:56:12.665" v="382" actId="1076"/>
          <ac:picMkLst>
            <pc:docMk/>
            <pc:sldMk cId="3228089283" sldId="276"/>
            <ac:picMk id="35" creationId="{D27848BC-A4D2-4A76-AF35-5D80BC4B4A0B}"/>
          </ac:picMkLst>
        </pc:picChg>
        <pc:picChg chg="add mod">
          <ac:chgData name="" userId="7ffbdccd425169d1" providerId="LiveId" clId="{FD8BA5CB-2DC1-4EFB-9878-64D8C8EE83F5}" dt="2022-01-16T15:56:12.665" v="382" actId="1076"/>
          <ac:picMkLst>
            <pc:docMk/>
            <pc:sldMk cId="3228089283" sldId="276"/>
            <ac:picMk id="36" creationId="{BE796F58-B93F-4CA5-BC7A-5F844DE3F147}"/>
          </ac:picMkLst>
        </pc:picChg>
        <pc:cxnChg chg="del">
          <ac:chgData name="" userId="7ffbdccd425169d1" providerId="LiveId" clId="{FD8BA5CB-2DC1-4EFB-9878-64D8C8EE83F5}" dt="2022-01-16T15:48:39.424" v="311" actId="478"/>
          <ac:cxnSpMkLst>
            <pc:docMk/>
            <pc:sldMk cId="3228089283" sldId="276"/>
            <ac:cxnSpMk id="11" creationId="{6B804F96-1432-4FF3-8B1C-1A19661BFFF8}"/>
          </ac:cxnSpMkLst>
        </pc:cxnChg>
        <pc:cxnChg chg="del">
          <ac:chgData name="" userId="7ffbdccd425169d1" providerId="LiveId" clId="{FD8BA5CB-2DC1-4EFB-9878-64D8C8EE83F5}" dt="2022-01-16T15:48:39.424" v="311" actId="478"/>
          <ac:cxnSpMkLst>
            <pc:docMk/>
            <pc:sldMk cId="3228089283" sldId="276"/>
            <ac:cxnSpMk id="12" creationId="{FFA3321F-CA8C-4CDF-98F7-40462E84F92D}"/>
          </ac:cxnSpMkLst>
        </pc:cxnChg>
        <pc:cxnChg chg="del">
          <ac:chgData name="" userId="7ffbdccd425169d1" providerId="LiveId" clId="{FD8BA5CB-2DC1-4EFB-9878-64D8C8EE83F5}" dt="2022-01-16T15:48:39.424" v="311" actId="478"/>
          <ac:cxnSpMkLst>
            <pc:docMk/>
            <pc:sldMk cId="3228089283" sldId="276"/>
            <ac:cxnSpMk id="13" creationId="{A8D882D0-64FE-4E26-A21F-D07C88F001E0}"/>
          </ac:cxnSpMkLst>
        </pc:cxnChg>
        <pc:cxnChg chg="del">
          <ac:chgData name="" userId="7ffbdccd425169d1" providerId="LiveId" clId="{FD8BA5CB-2DC1-4EFB-9878-64D8C8EE83F5}" dt="2022-01-16T15:48:39.424" v="311" actId="478"/>
          <ac:cxnSpMkLst>
            <pc:docMk/>
            <pc:sldMk cId="3228089283" sldId="276"/>
            <ac:cxnSpMk id="14" creationId="{E6981896-C6E8-442D-8A1D-49100E0FBF63}"/>
          </ac:cxnSpMkLst>
        </pc:cxnChg>
        <pc:cxnChg chg="del">
          <ac:chgData name="" userId="7ffbdccd425169d1" providerId="LiveId" clId="{FD8BA5CB-2DC1-4EFB-9878-64D8C8EE83F5}" dt="2022-01-16T15:48:39.424" v="311" actId="478"/>
          <ac:cxnSpMkLst>
            <pc:docMk/>
            <pc:sldMk cId="3228089283" sldId="276"/>
            <ac:cxnSpMk id="15" creationId="{E82F070E-2A96-4710-948A-9BE0CC0C6082}"/>
          </ac:cxnSpMkLst>
        </pc:cxnChg>
        <pc:cxnChg chg="del">
          <ac:chgData name="" userId="7ffbdccd425169d1" providerId="LiveId" clId="{FD8BA5CB-2DC1-4EFB-9878-64D8C8EE83F5}" dt="2022-01-16T15:48:39.424" v="311" actId="478"/>
          <ac:cxnSpMkLst>
            <pc:docMk/>
            <pc:sldMk cId="3228089283" sldId="276"/>
            <ac:cxnSpMk id="16" creationId="{B8248CF5-004B-4135-AB4C-E962230A0547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C:\Users\Yuanyy\Desktop\Long\1.4&#32472;&#22270;\1.4&#32472;&#22270;\&#25968;&#2545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Y 值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-0.23207150043300248"/>
                  <c:y val="1.5792327167279293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 sz="800" b="0" i="0" u="none" strike="noStrike" kern="1200" baseline="0">
                      <a:solidFill>
                        <a:srgbClr val="FF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A$2:$A$405</c:f>
              <c:numCache>
                <c:formatCode>General</c:formatCode>
                <c:ptCount val="404"/>
                <c:pt idx="0">
                  <c:v>1449</c:v>
                </c:pt>
                <c:pt idx="1">
                  <c:v>1178</c:v>
                </c:pt>
                <c:pt idx="2">
                  <c:v>1167</c:v>
                </c:pt>
                <c:pt idx="3">
                  <c:v>1155</c:v>
                </c:pt>
                <c:pt idx="4">
                  <c:v>1135</c:v>
                </c:pt>
                <c:pt idx="5">
                  <c:v>1125</c:v>
                </c:pt>
                <c:pt idx="6">
                  <c:v>1117</c:v>
                </c:pt>
                <c:pt idx="7">
                  <c:v>1088</c:v>
                </c:pt>
                <c:pt idx="8">
                  <c:v>1075</c:v>
                </c:pt>
                <c:pt idx="9">
                  <c:v>1042</c:v>
                </c:pt>
                <c:pt idx="10">
                  <c:v>1025</c:v>
                </c:pt>
                <c:pt idx="11">
                  <c:v>935</c:v>
                </c:pt>
                <c:pt idx="12">
                  <c:v>929</c:v>
                </c:pt>
                <c:pt idx="13">
                  <c:v>885</c:v>
                </c:pt>
                <c:pt idx="14">
                  <c:v>851</c:v>
                </c:pt>
                <c:pt idx="15">
                  <c:v>844</c:v>
                </c:pt>
                <c:pt idx="16">
                  <c:v>838</c:v>
                </c:pt>
                <c:pt idx="17">
                  <c:v>825</c:v>
                </c:pt>
                <c:pt idx="18">
                  <c:v>808</c:v>
                </c:pt>
                <c:pt idx="19">
                  <c:v>799</c:v>
                </c:pt>
                <c:pt idx="20">
                  <c:v>798</c:v>
                </c:pt>
                <c:pt idx="21">
                  <c:v>792</c:v>
                </c:pt>
                <c:pt idx="22">
                  <c:v>785</c:v>
                </c:pt>
                <c:pt idx="23">
                  <c:v>783</c:v>
                </c:pt>
                <c:pt idx="24">
                  <c:v>775</c:v>
                </c:pt>
                <c:pt idx="25">
                  <c:v>744</c:v>
                </c:pt>
                <c:pt idx="26">
                  <c:v>737</c:v>
                </c:pt>
                <c:pt idx="27">
                  <c:v>711</c:v>
                </c:pt>
                <c:pt idx="28">
                  <c:v>680</c:v>
                </c:pt>
                <c:pt idx="29">
                  <c:v>676</c:v>
                </c:pt>
                <c:pt idx="30">
                  <c:v>663</c:v>
                </c:pt>
                <c:pt idx="31">
                  <c:v>631</c:v>
                </c:pt>
                <c:pt idx="32">
                  <c:v>624</c:v>
                </c:pt>
                <c:pt idx="33">
                  <c:v>621</c:v>
                </c:pt>
                <c:pt idx="34">
                  <c:v>616</c:v>
                </c:pt>
                <c:pt idx="35">
                  <c:v>612</c:v>
                </c:pt>
                <c:pt idx="36">
                  <c:v>592</c:v>
                </c:pt>
                <c:pt idx="37">
                  <c:v>585</c:v>
                </c:pt>
                <c:pt idx="38">
                  <c:v>581</c:v>
                </c:pt>
                <c:pt idx="39">
                  <c:v>575</c:v>
                </c:pt>
                <c:pt idx="40">
                  <c:v>572</c:v>
                </c:pt>
                <c:pt idx="41">
                  <c:v>566</c:v>
                </c:pt>
                <c:pt idx="42">
                  <c:v>561</c:v>
                </c:pt>
                <c:pt idx="43">
                  <c:v>557</c:v>
                </c:pt>
                <c:pt idx="44">
                  <c:v>554</c:v>
                </c:pt>
                <c:pt idx="45">
                  <c:v>542</c:v>
                </c:pt>
                <c:pt idx="46">
                  <c:v>536</c:v>
                </c:pt>
                <c:pt idx="47">
                  <c:v>534</c:v>
                </c:pt>
                <c:pt idx="48">
                  <c:v>530</c:v>
                </c:pt>
                <c:pt idx="49">
                  <c:v>526</c:v>
                </c:pt>
                <c:pt idx="50">
                  <c:v>524</c:v>
                </c:pt>
                <c:pt idx="51">
                  <c:v>518</c:v>
                </c:pt>
                <c:pt idx="52">
                  <c:v>516</c:v>
                </c:pt>
                <c:pt idx="53">
                  <c:v>514</c:v>
                </c:pt>
                <c:pt idx="54">
                  <c:v>503</c:v>
                </c:pt>
                <c:pt idx="55">
                  <c:v>494</c:v>
                </c:pt>
                <c:pt idx="56">
                  <c:v>491</c:v>
                </c:pt>
                <c:pt idx="57">
                  <c:v>490</c:v>
                </c:pt>
                <c:pt idx="58">
                  <c:v>482</c:v>
                </c:pt>
                <c:pt idx="59">
                  <c:v>479</c:v>
                </c:pt>
                <c:pt idx="60">
                  <c:v>479</c:v>
                </c:pt>
                <c:pt idx="61">
                  <c:v>477</c:v>
                </c:pt>
                <c:pt idx="62">
                  <c:v>474</c:v>
                </c:pt>
                <c:pt idx="63">
                  <c:v>473</c:v>
                </c:pt>
                <c:pt idx="64">
                  <c:v>472</c:v>
                </c:pt>
                <c:pt idx="65">
                  <c:v>463</c:v>
                </c:pt>
                <c:pt idx="66">
                  <c:v>460</c:v>
                </c:pt>
                <c:pt idx="67">
                  <c:v>457</c:v>
                </c:pt>
                <c:pt idx="68">
                  <c:v>448</c:v>
                </c:pt>
                <c:pt idx="69">
                  <c:v>447</c:v>
                </c:pt>
                <c:pt idx="70">
                  <c:v>443</c:v>
                </c:pt>
                <c:pt idx="71">
                  <c:v>434</c:v>
                </c:pt>
                <c:pt idx="72">
                  <c:v>433</c:v>
                </c:pt>
                <c:pt idx="73">
                  <c:v>432</c:v>
                </c:pt>
                <c:pt idx="74">
                  <c:v>431</c:v>
                </c:pt>
                <c:pt idx="75">
                  <c:v>431</c:v>
                </c:pt>
                <c:pt idx="76">
                  <c:v>428</c:v>
                </c:pt>
                <c:pt idx="77">
                  <c:v>425</c:v>
                </c:pt>
                <c:pt idx="78">
                  <c:v>418</c:v>
                </c:pt>
                <c:pt idx="79">
                  <c:v>417</c:v>
                </c:pt>
                <c:pt idx="80">
                  <c:v>414</c:v>
                </c:pt>
                <c:pt idx="81">
                  <c:v>413</c:v>
                </c:pt>
                <c:pt idx="82">
                  <c:v>413</c:v>
                </c:pt>
                <c:pt idx="83">
                  <c:v>411</c:v>
                </c:pt>
                <c:pt idx="84">
                  <c:v>411</c:v>
                </c:pt>
                <c:pt idx="85">
                  <c:v>409</c:v>
                </c:pt>
                <c:pt idx="86">
                  <c:v>402</c:v>
                </c:pt>
                <c:pt idx="87">
                  <c:v>397</c:v>
                </c:pt>
                <c:pt idx="88">
                  <c:v>396</c:v>
                </c:pt>
                <c:pt idx="89">
                  <c:v>395</c:v>
                </c:pt>
                <c:pt idx="90">
                  <c:v>386</c:v>
                </c:pt>
                <c:pt idx="91">
                  <c:v>378</c:v>
                </c:pt>
                <c:pt idx="92">
                  <c:v>376</c:v>
                </c:pt>
                <c:pt idx="93">
                  <c:v>376</c:v>
                </c:pt>
                <c:pt idx="94">
                  <c:v>375</c:v>
                </c:pt>
                <c:pt idx="95">
                  <c:v>374</c:v>
                </c:pt>
                <c:pt idx="96">
                  <c:v>373</c:v>
                </c:pt>
                <c:pt idx="97">
                  <c:v>368</c:v>
                </c:pt>
                <c:pt idx="98">
                  <c:v>367</c:v>
                </c:pt>
                <c:pt idx="99">
                  <c:v>363</c:v>
                </c:pt>
                <c:pt idx="100">
                  <c:v>362</c:v>
                </c:pt>
                <c:pt idx="101">
                  <c:v>362</c:v>
                </c:pt>
                <c:pt idx="102">
                  <c:v>362</c:v>
                </c:pt>
                <c:pt idx="103">
                  <c:v>359</c:v>
                </c:pt>
                <c:pt idx="104">
                  <c:v>353</c:v>
                </c:pt>
                <c:pt idx="105">
                  <c:v>351</c:v>
                </c:pt>
                <c:pt idx="106">
                  <c:v>349</c:v>
                </c:pt>
                <c:pt idx="107">
                  <c:v>345</c:v>
                </c:pt>
                <c:pt idx="108">
                  <c:v>339</c:v>
                </c:pt>
                <c:pt idx="109">
                  <c:v>333</c:v>
                </c:pt>
                <c:pt idx="110">
                  <c:v>332</c:v>
                </c:pt>
                <c:pt idx="111">
                  <c:v>330</c:v>
                </c:pt>
                <c:pt idx="112">
                  <c:v>329</c:v>
                </c:pt>
                <c:pt idx="113">
                  <c:v>328</c:v>
                </c:pt>
                <c:pt idx="114">
                  <c:v>326</c:v>
                </c:pt>
                <c:pt idx="115">
                  <c:v>322</c:v>
                </c:pt>
                <c:pt idx="116">
                  <c:v>318</c:v>
                </c:pt>
                <c:pt idx="117">
                  <c:v>318</c:v>
                </c:pt>
                <c:pt idx="118">
                  <c:v>312</c:v>
                </c:pt>
                <c:pt idx="119">
                  <c:v>311</c:v>
                </c:pt>
                <c:pt idx="120">
                  <c:v>309</c:v>
                </c:pt>
                <c:pt idx="121">
                  <c:v>308</c:v>
                </c:pt>
                <c:pt idx="122">
                  <c:v>308</c:v>
                </c:pt>
                <c:pt idx="123">
                  <c:v>306</c:v>
                </c:pt>
                <c:pt idx="124">
                  <c:v>303</c:v>
                </c:pt>
                <c:pt idx="125">
                  <c:v>298</c:v>
                </c:pt>
                <c:pt idx="126">
                  <c:v>298</c:v>
                </c:pt>
                <c:pt idx="127">
                  <c:v>297</c:v>
                </c:pt>
                <c:pt idx="128">
                  <c:v>296</c:v>
                </c:pt>
                <c:pt idx="129">
                  <c:v>292</c:v>
                </c:pt>
                <c:pt idx="130">
                  <c:v>292</c:v>
                </c:pt>
                <c:pt idx="131">
                  <c:v>291</c:v>
                </c:pt>
                <c:pt idx="132">
                  <c:v>289</c:v>
                </c:pt>
                <c:pt idx="133">
                  <c:v>287</c:v>
                </c:pt>
                <c:pt idx="134">
                  <c:v>286</c:v>
                </c:pt>
                <c:pt idx="135">
                  <c:v>284</c:v>
                </c:pt>
                <c:pt idx="136">
                  <c:v>283</c:v>
                </c:pt>
                <c:pt idx="137">
                  <c:v>283</c:v>
                </c:pt>
                <c:pt idx="138">
                  <c:v>282</c:v>
                </c:pt>
                <c:pt idx="139">
                  <c:v>279</c:v>
                </c:pt>
                <c:pt idx="140">
                  <c:v>279</c:v>
                </c:pt>
                <c:pt idx="141">
                  <c:v>279</c:v>
                </c:pt>
                <c:pt idx="142">
                  <c:v>278</c:v>
                </c:pt>
                <c:pt idx="143">
                  <c:v>278</c:v>
                </c:pt>
                <c:pt idx="144">
                  <c:v>276</c:v>
                </c:pt>
                <c:pt idx="145">
                  <c:v>276</c:v>
                </c:pt>
                <c:pt idx="146">
                  <c:v>274</c:v>
                </c:pt>
                <c:pt idx="147">
                  <c:v>272</c:v>
                </c:pt>
                <c:pt idx="148">
                  <c:v>271</c:v>
                </c:pt>
                <c:pt idx="149">
                  <c:v>271</c:v>
                </c:pt>
                <c:pt idx="150">
                  <c:v>271</c:v>
                </c:pt>
                <c:pt idx="151">
                  <c:v>270</c:v>
                </c:pt>
                <c:pt idx="152">
                  <c:v>269</c:v>
                </c:pt>
                <c:pt idx="153">
                  <c:v>269</c:v>
                </c:pt>
                <c:pt idx="154">
                  <c:v>267</c:v>
                </c:pt>
                <c:pt idx="155">
                  <c:v>266</c:v>
                </c:pt>
                <c:pt idx="156">
                  <c:v>266</c:v>
                </c:pt>
                <c:pt idx="157">
                  <c:v>262</c:v>
                </c:pt>
                <c:pt idx="158">
                  <c:v>260</c:v>
                </c:pt>
                <c:pt idx="159">
                  <c:v>259</c:v>
                </c:pt>
                <c:pt idx="160">
                  <c:v>257</c:v>
                </c:pt>
                <c:pt idx="161">
                  <c:v>256</c:v>
                </c:pt>
                <c:pt idx="162">
                  <c:v>254</c:v>
                </c:pt>
                <c:pt idx="163">
                  <c:v>252</c:v>
                </c:pt>
                <c:pt idx="164">
                  <c:v>250</c:v>
                </c:pt>
                <c:pt idx="165">
                  <c:v>247</c:v>
                </c:pt>
                <c:pt idx="166">
                  <c:v>246</c:v>
                </c:pt>
                <c:pt idx="167">
                  <c:v>246</c:v>
                </c:pt>
                <c:pt idx="168">
                  <c:v>246</c:v>
                </c:pt>
                <c:pt idx="169">
                  <c:v>245</c:v>
                </c:pt>
                <c:pt idx="170">
                  <c:v>244</c:v>
                </c:pt>
                <c:pt idx="171">
                  <c:v>243</c:v>
                </c:pt>
                <c:pt idx="172">
                  <c:v>243</c:v>
                </c:pt>
                <c:pt idx="173">
                  <c:v>240</c:v>
                </c:pt>
                <c:pt idx="174">
                  <c:v>239</c:v>
                </c:pt>
                <c:pt idx="175">
                  <c:v>239</c:v>
                </c:pt>
                <c:pt idx="176">
                  <c:v>239</c:v>
                </c:pt>
                <c:pt idx="177">
                  <c:v>238</c:v>
                </c:pt>
                <c:pt idx="178">
                  <c:v>234</c:v>
                </c:pt>
                <c:pt idx="179">
                  <c:v>233</c:v>
                </c:pt>
                <c:pt idx="180">
                  <c:v>232</c:v>
                </c:pt>
                <c:pt idx="181">
                  <c:v>232</c:v>
                </c:pt>
                <c:pt idx="182">
                  <c:v>229</c:v>
                </c:pt>
                <c:pt idx="183">
                  <c:v>228</c:v>
                </c:pt>
                <c:pt idx="184">
                  <c:v>228</c:v>
                </c:pt>
                <c:pt idx="185">
                  <c:v>227</c:v>
                </c:pt>
                <c:pt idx="186">
                  <c:v>226</c:v>
                </c:pt>
                <c:pt idx="187">
                  <c:v>226</c:v>
                </c:pt>
                <c:pt idx="188">
                  <c:v>223</c:v>
                </c:pt>
                <c:pt idx="189">
                  <c:v>222</c:v>
                </c:pt>
                <c:pt idx="190">
                  <c:v>220</c:v>
                </c:pt>
                <c:pt idx="191">
                  <c:v>219</c:v>
                </c:pt>
                <c:pt idx="192">
                  <c:v>215</c:v>
                </c:pt>
                <c:pt idx="193">
                  <c:v>214</c:v>
                </c:pt>
                <c:pt idx="194">
                  <c:v>214</c:v>
                </c:pt>
                <c:pt idx="195">
                  <c:v>213</c:v>
                </c:pt>
                <c:pt idx="196">
                  <c:v>213</c:v>
                </c:pt>
                <c:pt idx="197">
                  <c:v>209</c:v>
                </c:pt>
                <c:pt idx="198">
                  <c:v>209</c:v>
                </c:pt>
                <c:pt idx="199">
                  <c:v>209</c:v>
                </c:pt>
                <c:pt idx="200">
                  <c:v>208</c:v>
                </c:pt>
                <c:pt idx="201">
                  <c:v>206</c:v>
                </c:pt>
                <c:pt idx="202">
                  <c:v>205</c:v>
                </c:pt>
                <c:pt idx="203">
                  <c:v>204</c:v>
                </c:pt>
                <c:pt idx="204">
                  <c:v>204</c:v>
                </c:pt>
                <c:pt idx="205">
                  <c:v>202</c:v>
                </c:pt>
                <c:pt idx="206">
                  <c:v>202</c:v>
                </c:pt>
                <c:pt idx="207">
                  <c:v>201</c:v>
                </c:pt>
                <c:pt idx="208">
                  <c:v>200</c:v>
                </c:pt>
                <c:pt idx="209">
                  <c:v>197</c:v>
                </c:pt>
                <c:pt idx="210">
                  <c:v>196</c:v>
                </c:pt>
                <c:pt idx="211">
                  <c:v>195</c:v>
                </c:pt>
                <c:pt idx="212">
                  <c:v>195</c:v>
                </c:pt>
                <c:pt idx="213">
                  <c:v>193</c:v>
                </c:pt>
                <c:pt idx="214">
                  <c:v>192</c:v>
                </c:pt>
                <c:pt idx="215">
                  <c:v>192</c:v>
                </c:pt>
                <c:pt idx="216">
                  <c:v>191</c:v>
                </c:pt>
                <c:pt idx="217">
                  <c:v>190</c:v>
                </c:pt>
                <c:pt idx="218">
                  <c:v>190</c:v>
                </c:pt>
                <c:pt idx="219">
                  <c:v>186</c:v>
                </c:pt>
                <c:pt idx="220">
                  <c:v>186</c:v>
                </c:pt>
                <c:pt idx="221">
                  <c:v>186</c:v>
                </c:pt>
                <c:pt idx="222">
                  <c:v>183</c:v>
                </c:pt>
                <c:pt idx="223">
                  <c:v>183</c:v>
                </c:pt>
                <c:pt idx="224">
                  <c:v>182</c:v>
                </c:pt>
                <c:pt idx="225">
                  <c:v>181</c:v>
                </c:pt>
                <c:pt idx="226">
                  <c:v>180</c:v>
                </c:pt>
                <c:pt idx="227">
                  <c:v>178</c:v>
                </c:pt>
                <c:pt idx="228">
                  <c:v>178</c:v>
                </c:pt>
                <c:pt idx="229">
                  <c:v>178</c:v>
                </c:pt>
                <c:pt idx="230">
                  <c:v>177</c:v>
                </c:pt>
                <c:pt idx="231">
                  <c:v>177</c:v>
                </c:pt>
                <c:pt idx="232">
                  <c:v>176</c:v>
                </c:pt>
                <c:pt idx="233">
                  <c:v>175</c:v>
                </c:pt>
                <c:pt idx="234">
                  <c:v>173</c:v>
                </c:pt>
                <c:pt idx="235">
                  <c:v>171</c:v>
                </c:pt>
                <c:pt idx="236">
                  <c:v>168</c:v>
                </c:pt>
                <c:pt idx="237">
                  <c:v>168</c:v>
                </c:pt>
                <c:pt idx="238">
                  <c:v>167</c:v>
                </c:pt>
                <c:pt idx="239">
                  <c:v>167</c:v>
                </c:pt>
                <c:pt idx="240">
                  <c:v>166</c:v>
                </c:pt>
                <c:pt idx="241">
                  <c:v>166</c:v>
                </c:pt>
                <c:pt idx="242">
                  <c:v>165</c:v>
                </c:pt>
                <c:pt idx="243">
                  <c:v>164</c:v>
                </c:pt>
                <c:pt idx="244">
                  <c:v>163</c:v>
                </c:pt>
                <c:pt idx="245">
                  <c:v>161</c:v>
                </c:pt>
                <c:pt idx="246">
                  <c:v>160</c:v>
                </c:pt>
                <c:pt idx="247">
                  <c:v>159</c:v>
                </c:pt>
                <c:pt idx="248">
                  <c:v>159</c:v>
                </c:pt>
                <c:pt idx="249">
                  <c:v>158</c:v>
                </c:pt>
                <c:pt idx="250">
                  <c:v>157</c:v>
                </c:pt>
                <c:pt idx="251">
                  <c:v>156</c:v>
                </c:pt>
                <c:pt idx="252">
                  <c:v>155</c:v>
                </c:pt>
                <c:pt idx="253">
                  <c:v>155</c:v>
                </c:pt>
                <c:pt idx="254">
                  <c:v>154</c:v>
                </c:pt>
                <c:pt idx="255">
                  <c:v>153</c:v>
                </c:pt>
                <c:pt idx="256">
                  <c:v>153</c:v>
                </c:pt>
                <c:pt idx="257">
                  <c:v>153</c:v>
                </c:pt>
                <c:pt idx="258">
                  <c:v>153</c:v>
                </c:pt>
                <c:pt idx="259">
                  <c:v>151</c:v>
                </c:pt>
                <c:pt idx="260">
                  <c:v>149</c:v>
                </c:pt>
                <c:pt idx="261">
                  <c:v>148</c:v>
                </c:pt>
                <c:pt idx="262">
                  <c:v>147</c:v>
                </c:pt>
                <c:pt idx="263">
                  <c:v>145</c:v>
                </c:pt>
                <c:pt idx="264">
                  <c:v>145</c:v>
                </c:pt>
                <c:pt idx="265">
                  <c:v>145</c:v>
                </c:pt>
                <c:pt idx="266">
                  <c:v>141</c:v>
                </c:pt>
                <c:pt idx="267">
                  <c:v>140</c:v>
                </c:pt>
                <c:pt idx="268">
                  <c:v>139</c:v>
                </c:pt>
                <c:pt idx="269">
                  <c:v>138</c:v>
                </c:pt>
                <c:pt idx="270">
                  <c:v>138</c:v>
                </c:pt>
                <c:pt idx="271">
                  <c:v>137</c:v>
                </c:pt>
                <c:pt idx="272">
                  <c:v>136</c:v>
                </c:pt>
                <c:pt idx="273">
                  <c:v>134</c:v>
                </c:pt>
                <c:pt idx="274">
                  <c:v>133</c:v>
                </c:pt>
                <c:pt idx="275">
                  <c:v>133</c:v>
                </c:pt>
                <c:pt idx="276">
                  <c:v>132</c:v>
                </c:pt>
                <c:pt idx="277">
                  <c:v>132</c:v>
                </c:pt>
                <c:pt idx="278">
                  <c:v>132</c:v>
                </c:pt>
                <c:pt idx="279">
                  <c:v>132</c:v>
                </c:pt>
                <c:pt idx="280">
                  <c:v>131</c:v>
                </c:pt>
                <c:pt idx="281">
                  <c:v>131</c:v>
                </c:pt>
                <c:pt idx="282">
                  <c:v>130</c:v>
                </c:pt>
                <c:pt idx="283">
                  <c:v>129</c:v>
                </c:pt>
                <c:pt idx="284">
                  <c:v>128</c:v>
                </c:pt>
                <c:pt idx="285">
                  <c:v>122</c:v>
                </c:pt>
                <c:pt idx="286">
                  <c:v>122</c:v>
                </c:pt>
                <c:pt idx="287">
                  <c:v>121</c:v>
                </c:pt>
                <c:pt idx="288">
                  <c:v>120</c:v>
                </c:pt>
                <c:pt idx="289">
                  <c:v>118</c:v>
                </c:pt>
                <c:pt idx="290">
                  <c:v>117</c:v>
                </c:pt>
                <c:pt idx="291">
                  <c:v>116</c:v>
                </c:pt>
                <c:pt idx="292">
                  <c:v>115</c:v>
                </c:pt>
                <c:pt idx="293">
                  <c:v>115</c:v>
                </c:pt>
                <c:pt idx="294">
                  <c:v>115</c:v>
                </c:pt>
                <c:pt idx="295">
                  <c:v>115</c:v>
                </c:pt>
                <c:pt idx="296">
                  <c:v>115</c:v>
                </c:pt>
                <c:pt idx="297">
                  <c:v>114</c:v>
                </c:pt>
                <c:pt idx="298">
                  <c:v>113</c:v>
                </c:pt>
                <c:pt idx="299">
                  <c:v>113</c:v>
                </c:pt>
                <c:pt idx="300">
                  <c:v>112</c:v>
                </c:pt>
                <c:pt idx="301">
                  <c:v>112</c:v>
                </c:pt>
                <c:pt idx="302">
                  <c:v>112</c:v>
                </c:pt>
                <c:pt idx="303">
                  <c:v>111</c:v>
                </c:pt>
                <c:pt idx="304">
                  <c:v>111</c:v>
                </c:pt>
                <c:pt idx="305">
                  <c:v>111</c:v>
                </c:pt>
                <c:pt idx="306">
                  <c:v>111</c:v>
                </c:pt>
                <c:pt idx="307">
                  <c:v>110</c:v>
                </c:pt>
                <c:pt idx="308">
                  <c:v>109</c:v>
                </c:pt>
                <c:pt idx="309">
                  <c:v>109</c:v>
                </c:pt>
                <c:pt idx="310">
                  <c:v>109</c:v>
                </c:pt>
                <c:pt idx="311">
                  <c:v>109</c:v>
                </c:pt>
                <c:pt idx="312">
                  <c:v>108</c:v>
                </c:pt>
                <c:pt idx="313">
                  <c:v>107</c:v>
                </c:pt>
                <c:pt idx="314">
                  <c:v>107</c:v>
                </c:pt>
                <c:pt idx="315">
                  <c:v>106</c:v>
                </c:pt>
                <c:pt idx="316">
                  <c:v>105</c:v>
                </c:pt>
                <c:pt idx="317">
                  <c:v>105</c:v>
                </c:pt>
                <c:pt idx="318">
                  <c:v>103</c:v>
                </c:pt>
                <c:pt idx="319">
                  <c:v>103</c:v>
                </c:pt>
                <c:pt idx="320">
                  <c:v>103</c:v>
                </c:pt>
                <c:pt idx="321">
                  <c:v>103</c:v>
                </c:pt>
                <c:pt idx="322">
                  <c:v>102</c:v>
                </c:pt>
                <c:pt idx="323">
                  <c:v>101</c:v>
                </c:pt>
                <c:pt idx="324">
                  <c:v>100</c:v>
                </c:pt>
                <c:pt idx="325">
                  <c:v>100</c:v>
                </c:pt>
                <c:pt idx="326">
                  <c:v>99</c:v>
                </c:pt>
                <c:pt idx="327">
                  <c:v>99</c:v>
                </c:pt>
                <c:pt idx="328">
                  <c:v>99</c:v>
                </c:pt>
                <c:pt idx="329">
                  <c:v>98</c:v>
                </c:pt>
                <c:pt idx="330">
                  <c:v>97</c:v>
                </c:pt>
                <c:pt idx="331">
                  <c:v>92</c:v>
                </c:pt>
                <c:pt idx="332">
                  <c:v>92</c:v>
                </c:pt>
                <c:pt idx="333">
                  <c:v>91</c:v>
                </c:pt>
                <c:pt idx="334">
                  <c:v>89</c:v>
                </c:pt>
                <c:pt idx="335">
                  <c:v>89</c:v>
                </c:pt>
                <c:pt idx="336">
                  <c:v>88</c:v>
                </c:pt>
                <c:pt idx="337">
                  <c:v>88</c:v>
                </c:pt>
                <c:pt idx="338">
                  <c:v>87</c:v>
                </c:pt>
                <c:pt idx="339">
                  <c:v>87</c:v>
                </c:pt>
                <c:pt idx="340">
                  <c:v>87</c:v>
                </c:pt>
                <c:pt idx="341">
                  <c:v>85</c:v>
                </c:pt>
                <c:pt idx="342">
                  <c:v>85</c:v>
                </c:pt>
                <c:pt idx="343">
                  <c:v>84</c:v>
                </c:pt>
                <c:pt idx="344">
                  <c:v>84</c:v>
                </c:pt>
                <c:pt idx="345">
                  <c:v>84</c:v>
                </c:pt>
                <c:pt idx="346">
                  <c:v>83</c:v>
                </c:pt>
                <c:pt idx="347">
                  <c:v>82</c:v>
                </c:pt>
                <c:pt idx="348">
                  <c:v>80</c:v>
                </c:pt>
                <c:pt idx="349">
                  <c:v>79</c:v>
                </c:pt>
                <c:pt idx="350">
                  <c:v>79</c:v>
                </c:pt>
                <c:pt idx="351">
                  <c:v>77</c:v>
                </c:pt>
                <c:pt idx="352">
                  <c:v>77</c:v>
                </c:pt>
                <c:pt idx="353">
                  <c:v>77</c:v>
                </c:pt>
                <c:pt idx="354">
                  <c:v>76</c:v>
                </c:pt>
                <c:pt idx="355">
                  <c:v>76</c:v>
                </c:pt>
                <c:pt idx="356">
                  <c:v>75</c:v>
                </c:pt>
                <c:pt idx="357">
                  <c:v>75</c:v>
                </c:pt>
                <c:pt idx="358">
                  <c:v>74</c:v>
                </c:pt>
                <c:pt idx="359">
                  <c:v>74</c:v>
                </c:pt>
                <c:pt idx="360">
                  <c:v>70</c:v>
                </c:pt>
                <c:pt idx="361">
                  <c:v>69</c:v>
                </c:pt>
                <c:pt idx="362">
                  <c:v>69</c:v>
                </c:pt>
                <c:pt idx="363">
                  <c:v>69</c:v>
                </c:pt>
                <c:pt idx="364">
                  <c:v>69</c:v>
                </c:pt>
                <c:pt idx="365">
                  <c:v>68</c:v>
                </c:pt>
                <c:pt idx="366">
                  <c:v>68</c:v>
                </c:pt>
                <c:pt idx="367">
                  <c:v>67</c:v>
                </c:pt>
                <c:pt idx="368">
                  <c:v>65</c:v>
                </c:pt>
                <c:pt idx="369">
                  <c:v>64</c:v>
                </c:pt>
                <c:pt idx="370">
                  <c:v>62</c:v>
                </c:pt>
                <c:pt idx="371">
                  <c:v>60</c:v>
                </c:pt>
                <c:pt idx="372">
                  <c:v>59</c:v>
                </c:pt>
                <c:pt idx="373">
                  <c:v>56</c:v>
                </c:pt>
                <c:pt idx="374">
                  <c:v>56</c:v>
                </c:pt>
                <c:pt idx="375">
                  <c:v>56</c:v>
                </c:pt>
                <c:pt idx="376">
                  <c:v>55</c:v>
                </c:pt>
                <c:pt idx="377">
                  <c:v>55</c:v>
                </c:pt>
                <c:pt idx="378">
                  <c:v>55</c:v>
                </c:pt>
                <c:pt idx="379">
                  <c:v>53</c:v>
                </c:pt>
                <c:pt idx="380">
                  <c:v>47</c:v>
                </c:pt>
                <c:pt idx="381">
                  <c:v>47</c:v>
                </c:pt>
                <c:pt idx="382">
                  <c:v>45</c:v>
                </c:pt>
                <c:pt idx="383">
                  <c:v>43</c:v>
                </c:pt>
                <c:pt idx="384">
                  <c:v>43</c:v>
                </c:pt>
                <c:pt idx="385">
                  <c:v>43</c:v>
                </c:pt>
                <c:pt idx="386">
                  <c:v>41</c:v>
                </c:pt>
                <c:pt idx="387">
                  <c:v>40</c:v>
                </c:pt>
                <c:pt idx="388">
                  <c:v>37</c:v>
                </c:pt>
                <c:pt idx="389">
                  <c:v>37</c:v>
                </c:pt>
                <c:pt idx="390">
                  <c:v>37</c:v>
                </c:pt>
                <c:pt idx="391">
                  <c:v>33</c:v>
                </c:pt>
                <c:pt idx="392">
                  <c:v>33</c:v>
                </c:pt>
                <c:pt idx="393">
                  <c:v>29</c:v>
                </c:pt>
                <c:pt idx="394">
                  <c:v>29</c:v>
                </c:pt>
                <c:pt idx="395">
                  <c:v>28</c:v>
                </c:pt>
                <c:pt idx="396">
                  <c:v>27</c:v>
                </c:pt>
                <c:pt idx="397">
                  <c:v>25</c:v>
                </c:pt>
                <c:pt idx="398">
                  <c:v>24</c:v>
                </c:pt>
                <c:pt idx="399">
                  <c:v>23</c:v>
                </c:pt>
                <c:pt idx="400">
                  <c:v>20</c:v>
                </c:pt>
                <c:pt idx="401">
                  <c:v>19</c:v>
                </c:pt>
                <c:pt idx="402">
                  <c:v>3</c:v>
                </c:pt>
                <c:pt idx="403">
                  <c:v>2</c:v>
                </c:pt>
              </c:numCache>
            </c:numRef>
          </c:xVal>
          <c:yVal>
            <c:numRef>
              <c:f>Sheet1!$B$2:$B$405</c:f>
              <c:numCache>
                <c:formatCode>General</c:formatCode>
                <c:ptCount val="404"/>
                <c:pt idx="0">
                  <c:v>604</c:v>
                </c:pt>
                <c:pt idx="1">
                  <c:v>462</c:v>
                </c:pt>
                <c:pt idx="2">
                  <c:v>676</c:v>
                </c:pt>
                <c:pt idx="3">
                  <c:v>380</c:v>
                </c:pt>
                <c:pt idx="4">
                  <c:v>489</c:v>
                </c:pt>
                <c:pt idx="5">
                  <c:v>539</c:v>
                </c:pt>
                <c:pt idx="6">
                  <c:v>458</c:v>
                </c:pt>
                <c:pt idx="7">
                  <c:v>511</c:v>
                </c:pt>
                <c:pt idx="8">
                  <c:v>541</c:v>
                </c:pt>
                <c:pt idx="9">
                  <c:v>382</c:v>
                </c:pt>
                <c:pt idx="10">
                  <c:v>338</c:v>
                </c:pt>
                <c:pt idx="11">
                  <c:v>434</c:v>
                </c:pt>
                <c:pt idx="12">
                  <c:v>210</c:v>
                </c:pt>
                <c:pt idx="13">
                  <c:v>242</c:v>
                </c:pt>
                <c:pt idx="14">
                  <c:v>365</c:v>
                </c:pt>
                <c:pt idx="15">
                  <c:v>454</c:v>
                </c:pt>
                <c:pt idx="16">
                  <c:v>284</c:v>
                </c:pt>
                <c:pt idx="17">
                  <c:v>281</c:v>
                </c:pt>
                <c:pt idx="18">
                  <c:v>349</c:v>
                </c:pt>
                <c:pt idx="19">
                  <c:v>321</c:v>
                </c:pt>
                <c:pt idx="20">
                  <c:v>276</c:v>
                </c:pt>
                <c:pt idx="21">
                  <c:v>235</c:v>
                </c:pt>
                <c:pt idx="22">
                  <c:v>310</c:v>
                </c:pt>
                <c:pt idx="23">
                  <c:v>106</c:v>
                </c:pt>
                <c:pt idx="24">
                  <c:v>389</c:v>
                </c:pt>
                <c:pt idx="25">
                  <c:v>345</c:v>
                </c:pt>
                <c:pt idx="26">
                  <c:v>377</c:v>
                </c:pt>
                <c:pt idx="27">
                  <c:v>326</c:v>
                </c:pt>
                <c:pt idx="28">
                  <c:v>126</c:v>
                </c:pt>
                <c:pt idx="29">
                  <c:v>301</c:v>
                </c:pt>
                <c:pt idx="30">
                  <c:v>245</c:v>
                </c:pt>
                <c:pt idx="31">
                  <c:v>318</c:v>
                </c:pt>
                <c:pt idx="32">
                  <c:v>321</c:v>
                </c:pt>
                <c:pt idx="33">
                  <c:v>162</c:v>
                </c:pt>
                <c:pt idx="34">
                  <c:v>252</c:v>
                </c:pt>
                <c:pt idx="35">
                  <c:v>202</c:v>
                </c:pt>
                <c:pt idx="36">
                  <c:v>317</c:v>
                </c:pt>
                <c:pt idx="37">
                  <c:v>314</c:v>
                </c:pt>
                <c:pt idx="38">
                  <c:v>216</c:v>
                </c:pt>
                <c:pt idx="39">
                  <c:v>143</c:v>
                </c:pt>
                <c:pt idx="40">
                  <c:v>289</c:v>
                </c:pt>
                <c:pt idx="41">
                  <c:v>207</c:v>
                </c:pt>
                <c:pt idx="42">
                  <c:v>262</c:v>
                </c:pt>
                <c:pt idx="43">
                  <c:v>264</c:v>
                </c:pt>
                <c:pt idx="44">
                  <c:v>249</c:v>
                </c:pt>
                <c:pt idx="45">
                  <c:v>256</c:v>
                </c:pt>
                <c:pt idx="46">
                  <c:v>268</c:v>
                </c:pt>
                <c:pt idx="47">
                  <c:v>258</c:v>
                </c:pt>
                <c:pt idx="48">
                  <c:v>306</c:v>
                </c:pt>
                <c:pt idx="49">
                  <c:v>225</c:v>
                </c:pt>
                <c:pt idx="50">
                  <c:v>223</c:v>
                </c:pt>
                <c:pt idx="51">
                  <c:v>275</c:v>
                </c:pt>
                <c:pt idx="52">
                  <c:v>209</c:v>
                </c:pt>
                <c:pt idx="53">
                  <c:v>167</c:v>
                </c:pt>
                <c:pt idx="54">
                  <c:v>171</c:v>
                </c:pt>
                <c:pt idx="55">
                  <c:v>291</c:v>
                </c:pt>
                <c:pt idx="56">
                  <c:v>273</c:v>
                </c:pt>
                <c:pt idx="57">
                  <c:v>212</c:v>
                </c:pt>
                <c:pt idx="58">
                  <c:v>172</c:v>
                </c:pt>
                <c:pt idx="59">
                  <c:v>210</c:v>
                </c:pt>
                <c:pt idx="60">
                  <c:v>202</c:v>
                </c:pt>
                <c:pt idx="61">
                  <c:v>273</c:v>
                </c:pt>
                <c:pt idx="62">
                  <c:v>218</c:v>
                </c:pt>
                <c:pt idx="63">
                  <c:v>187</c:v>
                </c:pt>
                <c:pt idx="64">
                  <c:v>193</c:v>
                </c:pt>
                <c:pt idx="65">
                  <c:v>243</c:v>
                </c:pt>
                <c:pt idx="66">
                  <c:v>261</c:v>
                </c:pt>
                <c:pt idx="67">
                  <c:v>175</c:v>
                </c:pt>
                <c:pt idx="68">
                  <c:v>120</c:v>
                </c:pt>
                <c:pt idx="69">
                  <c:v>131</c:v>
                </c:pt>
                <c:pt idx="70">
                  <c:v>153</c:v>
                </c:pt>
                <c:pt idx="71">
                  <c:v>190</c:v>
                </c:pt>
                <c:pt idx="72">
                  <c:v>177</c:v>
                </c:pt>
                <c:pt idx="73">
                  <c:v>166</c:v>
                </c:pt>
                <c:pt idx="74">
                  <c:v>187</c:v>
                </c:pt>
                <c:pt idx="75">
                  <c:v>173</c:v>
                </c:pt>
                <c:pt idx="76">
                  <c:v>185</c:v>
                </c:pt>
                <c:pt idx="77">
                  <c:v>166</c:v>
                </c:pt>
                <c:pt idx="78">
                  <c:v>185</c:v>
                </c:pt>
                <c:pt idx="79">
                  <c:v>123</c:v>
                </c:pt>
                <c:pt idx="80">
                  <c:v>220</c:v>
                </c:pt>
                <c:pt idx="81">
                  <c:v>218</c:v>
                </c:pt>
                <c:pt idx="82">
                  <c:v>209</c:v>
                </c:pt>
                <c:pt idx="83">
                  <c:v>153</c:v>
                </c:pt>
                <c:pt idx="84">
                  <c:v>132</c:v>
                </c:pt>
                <c:pt idx="85">
                  <c:v>235</c:v>
                </c:pt>
                <c:pt idx="86">
                  <c:v>197</c:v>
                </c:pt>
                <c:pt idx="87">
                  <c:v>112</c:v>
                </c:pt>
                <c:pt idx="88">
                  <c:v>169</c:v>
                </c:pt>
                <c:pt idx="89">
                  <c:v>329</c:v>
                </c:pt>
                <c:pt idx="90">
                  <c:v>177</c:v>
                </c:pt>
                <c:pt idx="91">
                  <c:v>100</c:v>
                </c:pt>
                <c:pt idx="92">
                  <c:v>191</c:v>
                </c:pt>
                <c:pt idx="93">
                  <c:v>132</c:v>
                </c:pt>
                <c:pt idx="94">
                  <c:v>140</c:v>
                </c:pt>
                <c:pt idx="95">
                  <c:v>214</c:v>
                </c:pt>
                <c:pt idx="96">
                  <c:v>136</c:v>
                </c:pt>
                <c:pt idx="97">
                  <c:v>77</c:v>
                </c:pt>
                <c:pt idx="98">
                  <c:v>148</c:v>
                </c:pt>
                <c:pt idx="99">
                  <c:v>123</c:v>
                </c:pt>
                <c:pt idx="100">
                  <c:v>160</c:v>
                </c:pt>
                <c:pt idx="101">
                  <c:v>137</c:v>
                </c:pt>
                <c:pt idx="102">
                  <c:v>132</c:v>
                </c:pt>
                <c:pt idx="103">
                  <c:v>174</c:v>
                </c:pt>
                <c:pt idx="104">
                  <c:v>162</c:v>
                </c:pt>
                <c:pt idx="105">
                  <c:v>160</c:v>
                </c:pt>
                <c:pt idx="106">
                  <c:v>176</c:v>
                </c:pt>
                <c:pt idx="107">
                  <c:v>123</c:v>
                </c:pt>
                <c:pt idx="108">
                  <c:v>47</c:v>
                </c:pt>
                <c:pt idx="109">
                  <c:v>153</c:v>
                </c:pt>
                <c:pt idx="110">
                  <c:v>136</c:v>
                </c:pt>
                <c:pt idx="111">
                  <c:v>97</c:v>
                </c:pt>
                <c:pt idx="112">
                  <c:v>169</c:v>
                </c:pt>
                <c:pt idx="113">
                  <c:v>110</c:v>
                </c:pt>
                <c:pt idx="114">
                  <c:v>133</c:v>
                </c:pt>
                <c:pt idx="115">
                  <c:v>121</c:v>
                </c:pt>
                <c:pt idx="116">
                  <c:v>89</c:v>
                </c:pt>
                <c:pt idx="117">
                  <c:v>31</c:v>
                </c:pt>
                <c:pt idx="118">
                  <c:v>162</c:v>
                </c:pt>
                <c:pt idx="119">
                  <c:v>116</c:v>
                </c:pt>
                <c:pt idx="120">
                  <c:v>136</c:v>
                </c:pt>
                <c:pt idx="121">
                  <c:v>112</c:v>
                </c:pt>
                <c:pt idx="122">
                  <c:v>112</c:v>
                </c:pt>
                <c:pt idx="123">
                  <c:v>142</c:v>
                </c:pt>
                <c:pt idx="124">
                  <c:v>92</c:v>
                </c:pt>
                <c:pt idx="125">
                  <c:v>146</c:v>
                </c:pt>
                <c:pt idx="126">
                  <c:v>117</c:v>
                </c:pt>
                <c:pt idx="127">
                  <c:v>90</c:v>
                </c:pt>
                <c:pt idx="128">
                  <c:v>133</c:v>
                </c:pt>
                <c:pt idx="129">
                  <c:v>132</c:v>
                </c:pt>
                <c:pt idx="130">
                  <c:v>116</c:v>
                </c:pt>
                <c:pt idx="131">
                  <c:v>164</c:v>
                </c:pt>
                <c:pt idx="132">
                  <c:v>107</c:v>
                </c:pt>
                <c:pt idx="133">
                  <c:v>166</c:v>
                </c:pt>
                <c:pt idx="134">
                  <c:v>52</c:v>
                </c:pt>
                <c:pt idx="135">
                  <c:v>121</c:v>
                </c:pt>
                <c:pt idx="136">
                  <c:v>101</c:v>
                </c:pt>
                <c:pt idx="137">
                  <c:v>94</c:v>
                </c:pt>
                <c:pt idx="138">
                  <c:v>114</c:v>
                </c:pt>
                <c:pt idx="139">
                  <c:v>147</c:v>
                </c:pt>
                <c:pt idx="140">
                  <c:v>133</c:v>
                </c:pt>
                <c:pt idx="141">
                  <c:v>116</c:v>
                </c:pt>
                <c:pt idx="142">
                  <c:v>174</c:v>
                </c:pt>
                <c:pt idx="143">
                  <c:v>149</c:v>
                </c:pt>
                <c:pt idx="144">
                  <c:v>116</c:v>
                </c:pt>
                <c:pt idx="145">
                  <c:v>115</c:v>
                </c:pt>
                <c:pt idx="146">
                  <c:v>142</c:v>
                </c:pt>
                <c:pt idx="147">
                  <c:v>108</c:v>
                </c:pt>
                <c:pt idx="148">
                  <c:v>137</c:v>
                </c:pt>
                <c:pt idx="149">
                  <c:v>112</c:v>
                </c:pt>
                <c:pt idx="150">
                  <c:v>88</c:v>
                </c:pt>
                <c:pt idx="151">
                  <c:v>150</c:v>
                </c:pt>
                <c:pt idx="152">
                  <c:v>132</c:v>
                </c:pt>
                <c:pt idx="153">
                  <c:v>113</c:v>
                </c:pt>
                <c:pt idx="154">
                  <c:v>39</c:v>
                </c:pt>
                <c:pt idx="155">
                  <c:v>153</c:v>
                </c:pt>
                <c:pt idx="156">
                  <c:v>111</c:v>
                </c:pt>
                <c:pt idx="157">
                  <c:v>73</c:v>
                </c:pt>
                <c:pt idx="158">
                  <c:v>122</c:v>
                </c:pt>
                <c:pt idx="159">
                  <c:v>116</c:v>
                </c:pt>
                <c:pt idx="160">
                  <c:v>93</c:v>
                </c:pt>
                <c:pt idx="161">
                  <c:v>95</c:v>
                </c:pt>
                <c:pt idx="162">
                  <c:v>146</c:v>
                </c:pt>
                <c:pt idx="163">
                  <c:v>105</c:v>
                </c:pt>
                <c:pt idx="164">
                  <c:v>67</c:v>
                </c:pt>
                <c:pt idx="165">
                  <c:v>109</c:v>
                </c:pt>
                <c:pt idx="166">
                  <c:v>127</c:v>
                </c:pt>
                <c:pt idx="167">
                  <c:v>112</c:v>
                </c:pt>
                <c:pt idx="168">
                  <c:v>107</c:v>
                </c:pt>
                <c:pt idx="169">
                  <c:v>82</c:v>
                </c:pt>
                <c:pt idx="170">
                  <c:v>58</c:v>
                </c:pt>
                <c:pt idx="171">
                  <c:v>94</c:v>
                </c:pt>
                <c:pt idx="172">
                  <c:v>68</c:v>
                </c:pt>
                <c:pt idx="173">
                  <c:v>103</c:v>
                </c:pt>
                <c:pt idx="174">
                  <c:v>143</c:v>
                </c:pt>
                <c:pt idx="175">
                  <c:v>114</c:v>
                </c:pt>
                <c:pt idx="176">
                  <c:v>110</c:v>
                </c:pt>
                <c:pt idx="177">
                  <c:v>99</c:v>
                </c:pt>
                <c:pt idx="178">
                  <c:v>106</c:v>
                </c:pt>
                <c:pt idx="179">
                  <c:v>83</c:v>
                </c:pt>
                <c:pt idx="180">
                  <c:v>75</c:v>
                </c:pt>
                <c:pt idx="181">
                  <c:v>69</c:v>
                </c:pt>
                <c:pt idx="182">
                  <c:v>121</c:v>
                </c:pt>
                <c:pt idx="183">
                  <c:v>134</c:v>
                </c:pt>
                <c:pt idx="184">
                  <c:v>51</c:v>
                </c:pt>
                <c:pt idx="185">
                  <c:v>71</c:v>
                </c:pt>
                <c:pt idx="186">
                  <c:v>114</c:v>
                </c:pt>
                <c:pt idx="187">
                  <c:v>85</c:v>
                </c:pt>
                <c:pt idx="188">
                  <c:v>66</c:v>
                </c:pt>
                <c:pt idx="189">
                  <c:v>154</c:v>
                </c:pt>
                <c:pt idx="190">
                  <c:v>102</c:v>
                </c:pt>
                <c:pt idx="191">
                  <c:v>86</c:v>
                </c:pt>
                <c:pt idx="192">
                  <c:v>70</c:v>
                </c:pt>
                <c:pt idx="193">
                  <c:v>96</c:v>
                </c:pt>
                <c:pt idx="194">
                  <c:v>47</c:v>
                </c:pt>
                <c:pt idx="195">
                  <c:v>137</c:v>
                </c:pt>
                <c:pt idx="196">
                  <c:v>56</c:v>
                </c:pt>
                <c:pt idx="197">
                  <c:v>120</c:v>
                </c:pt>
                <c:pt idx="198">
                  <c:v>67</c:v>
                </c:pt>
                <c:pt idx="199">
                  <c:v>65</c:v>
                </c:pt>
                <c:pt idx="200">
                  <c:v>108</c:v>
                </c:pt>
                <c:pt idx="201">
                  <c:v>83</c:v>
                </c:pt>
                <c:pt idx="202">
                  <c:v>64</c:v>
                </c:pt>
                <c:pt idx="203">
                  <c:v>107</c:v>
                </c:pt>
                <c:pt idx="204">
                  <c:v>81</c:v>
                </c:pt>
                <c:pt idx="205">
                  <c:v>103</c:v>
                </c:pt>
                <c:pt idx="206">
                  <c:v>77</c:v>
                </c:pt>
                <c:pt idx="207">
                  <c:v>95</c:v>
                </c:pt>
                <c:pt idx="208">
                  <c:v>98</c:v>
                </c:pt>
                <c:pt idx="209">
                  <c:v>142</c:v>
                </c:pt>
                <c:pt idx="210">
                  <c:v>71</c:v>
                </c:pt>
                <c:pt idx="211">
                  <c:v>101</c:v>
                </c:pt>
                <c:pt idx="212">
                  <c:v>80</c:v>
                </c:pt>
                <c:pt idx="213">
                  <c:v>107</c:v>
                </c:pt>
                <c:pt idx="214">
                  <c:v>88</c:v>
                </c:pt>
                <c:pt idx="215">
                  <c:v>74</c:v>
                </c:pt>
                <c:pt idx="216">
                  <c:v>47</c:v>
                </c:pt>
                <c:pt idx="217">
                  <c:v>118</c:v>
                </c:pt>
                <c:pt idx="218">
                  <c:v>74</c:v>
                </c:pt>
                <c:pt idx="219">
                  <c:v>95</c:v>
                </c:pt>
                <c:pt idx="220">
                  <c:v>77</c:v>
                </c:pt>
                <c:pt idx="221">
                  <c:v>68</c:v>
                </c:pt>
                <c:pt idx="222">
                  <c:v>67</c:v>
                </c:pt>
                <c:pt idx="223">
                  <c:v>53</c:v>
                </c:pt>
                <c:pt idx="224">
                  <c:v>82</c:v>
                </c:pt>
                <c:pt idx="225">
                  <c:v>33</c:v>
                </c:pt>
                <c:pt idx="226">
                  <c:v>40</c:v>
                </c:pt>
                <c:pt idx="227">
                  <c:v>113</c:v>
                </c:pt>
                <c:pt idx="228">
                  <c:v>75</c:v>
                </c:pt>
                <c:pt idx="229">
                  <c:v>62</c:v>
                </c:pt>
                <c:pt idx="230">
                  <c:v>84</c:v>
                </c:pt>
                <c:pt idx="231">
                  <c:v>84</c:v>
                </c:pt>
                <c:pt idx="232">
                  <c:v>47</c:v>
                </c:pt>
                <c:pt idx="233">
                  <c:v>84</c:v>
                </c:pt>
                <c:pt idx="234">
                  <c:v>65</c:v>
                </c:pt>
                <c:pt idx="235">
                  <c:v>84</c:v>
                </c:pt>
                <c:pt idx="236">
                  <c:v>65</c:v>
                </c:pt>
                <c:pt idx="237">
                  <c:v>64</c:v>
                </c:pt>
                <c:pt idx="238">
                  <c:v>92</c:v>
                </c:pt>
                <c:pt idx="239">
                  <c:v>64</c:v>
                </c:pt>
                <c:pt idx="240">
                  <c:v>74</c:v>
                </c:pt>
                <c:pt idx="241">
                  <c:v>62</c:v>
                </c:pt>
                <c:pt idx="242">
                  <c:v>73</c:v>
                </c:pt>
                <c:pt idx="243">
                  <c:v>64</c:v>
                </c:pt>
                <c:pt idx="244">
                  <c:v>32</c:v>
                </c:pt>
                <c:pt idx="245">
                  <c:v>56</c:v>
                </c:pt>
                <c:pt idx="246">
                  <c:v>59</c:v>
                </c:pt>
                <c:pt idx="247">
                  <c:v>52</c:v>
                </c:pt>
                <c:pt idx="248">
                  <c:v>50</c:v>
                </c:pt>
                <c:pt idx="249">
                  <c:v>60</c:v>
                </c:pt>
                <c:pt idx="250">
                  <c:v>57</c:v>
                </c:pt>
                <c:pt idx="251">
                  <c:v>54</c:v>
                </c:pt>
                <c:pt idx="252">
                  <c:v>82</c:v>
                </c:pt>
                <c:pt idx="253">
                  <c:v>55</c:v>
                </c:pt>
                <c:pt idx="254">
                  <c:v>67</c:v>
                </c:pt>
                <c:pt idx="255">
                  <c:v>91</c:v>
                </c:pt>
                <c:pt idx="256">
                  <c:v>83</c:v>
                </c:pt>
                <c:pt idx="257">
                  <c:v>73</c:v>
                </c:pt>
                <c:pt idx="258">
                  <c:v>70</c:v>
                </c:pt>
                <c:pt idx="259">
                  <c:v>58</c:v>
                </c:pt>
                <c:pt idx="260">
                  <c:v>58</c:v>
                </c:pt>
                <c:pt idx="261">
                  <c:v>73</c:v>
                </c:pt>
                <c:pt idx="262">
                  <c:v>57</c:v>
                </c:pt>
                <c:pt idx="263">
                  <c:v>76</c:v>
                </c:pt>
                <c:pt idx="264">
                  <c:v>63</c:v>
                </c:pt>
                <c:pt idx="265">
                  <c:v>60</c:v>
                </c:pt>
                <c:pt idx="266">
                  <c:v>63</c:v>
                </c:pt>
                <c:pt idx="267">
                  <c:v>62</c:v>
                </c:pt>
                <c:pt idx="268">
                  <c:v>54</c:v>
                </c:pt>
                <c:pt idx="269">
                  <c:v>58</c:v>
                </c:pt>
                <c:pt idx="270">
                  <c:v>45</c:v>
                </c:pt>
                <c:pt idx="271">
                  <c:v>63</c:v>
                </c:pt>
                <c:pt idx="272">
                  <c:v>32</c:v>
                </c:pt>
                <c:pt idx="273">
                  <c:v>51</c:v>
                </c:pt>
                <c:pt idx="274">
                  <c:v>29</c:v>
                </c:pt>
                <c:pt idx="275">
                  <c:v>26</c:v>
                </c:pt>
                <c:pt idx="276">
                  <c:v>76</c:v>
                </c:pt>
                <c:pt idx="277">
                  <c:v>73</c:v>
                </c:pt>
                <c:pt idx="278">
                  <c:v>62</c:v>
                </c:pt>
                <c:pt idx="279">
                  <c:v>62</c:v>
                </c:pt>
                <c:pt idx="280">
                  <c:v>58</c:v>
                </c:pt>
                <c:pt idx="281">
                  <c:v>54</c:v>
                </c:pt>
                <c:pt idx="282">
                  <c:v>85</c:v>
                </c:pt>
                <c:pt idx="283">
                  <c:v>63</c:v>
                </c:pt>
                <c:pt idx="284">
                  <c:v>71</c:v>
                </c:pt>
                <c:pt idx="285">
                  <c:v>50</c:v>
                </c:pt>
                <c:pt idx="286">
                  <c:v>41</c:v>
                </c:pt>
                <c:pt idx="287">
                  <c:v>71</c:v>
                </c:pt>
                <c:pt idx="288">
                  <c:v>20</c:v>
                </c:pt>
                <c:pt idx="289">
                  <c:v>41</c:v>
                </c:pt>
                <c:pt idx="290">
                  <c:v>55</c:v>
                </c:pt>
                <c:pt idx="291">
                  <c:v>38</c:v>
                </c:pt>
                <c:pt idx="292">
                  <c:v>47</c:v>
                </c:pt>
                <c:pt idx="293">
                  <c:v>45</c:v>
                </c:pt>
                <c:pt idx="294">
                  <c:v>43</c:v>
                </c:pt>
                <c:pt idx="295">
                  <c:v>41</c:v>
                </c:pt>
                <c:pt idx="296">
                  <c:v>30</c:v>
                </c:pt>
                <c:pt idx="297">
                  <c:v>34</c:v>
                </c:pt>
                <c:pt idx="298">
                  <c:v>61</c:v>
                </c:pt>
                <c:pt idx="299">
                  <c:v>44</c:v>
                </c:pt>
                <c:pt idx="300">
                  <c:v>61</c:v>
                </c:pt>
                <c:pt idx="301">
                  <c:v>59</c:v>
                </c:pt>
                <c:pt idx="302">
                  <c:v>43</c:v>
                </c:pt>
                <c:pt idx="303">
                  <c:v>58</c:v>
                </c:pt>
                <c:pt idx="304">
                  <c:v>46</c:v>
                </c:pt>
                <c:pt idx="305">
                  <c:v>39</c:v>
                </c:pt>
                <c:pt idx="306">
                  <c:v>33</c:v>
                </c:pt>
                <c:pt idx="307">
                  <c:v>58</c:v>
                </c:pt>
                <c:pt idx="308">
                  <c:v>61</c:v>
                </c:pt>
                <c:pt idx="309">
                  <c:v>37</c:v>
                </c:pt>
                <c:pt idx="310">
                  <c:v>36</c:v>
                </c:pt>
                <c:pt idx="311">
                  <c:v>30</c:v>
                </c:pt>
                <c:pt idx="312">
                  <c:v>68</c:v>
                </c:pt>
                <c:pt idx="313">
                  <c:v>41</c:v>
                </c:pt>
                <c:pt idx="314">
                  <c:v>39</c:v>
                </c:pt>
                <c:pt idx="315">
                  <c:v>28</c:v>
                </c:pt>
                <c:pt idx="316">
                  <c:v>31</c:v>
                </c:pt>
                <c:pt idx="317">
                  <c:v>20</c:v>
                </c:pt>
                <c:pt idx="318">
                  <c:v>61</c:v>
                </c:pt>
                <c:pt idx="319">
                  <c:v>40</c:v>
                </c:pt>
                <c:pt idx="320">
                  <c:v>31</c:v>
                </c:pt>
                <c:pt idx="321">
                  <c:v>30</c:v>
                </c:pt>
                <c:pt idx="322">
                  <c:v>59</c:v>
                </c:pt>
                <c:pt idx="323">
                  <c:v>34</c:v>
                </c:pt>
                <c:pt idx="324">
                  <c:v>44</c:v>
                </c:pt>
                <c:pt idx="325">
                  <c:v>43</c:v>
                </c:pt>
                <c:pt idx="326">
                  <c:v>40</c:v>
                </c:pt>
                <c:pt idx="327">
                  <c:v>31</c:v>
                </c:pt>
                <c:pt idx="328">
                  <c:v>28</c:v>
                </c:pt>
                <c:pt idx="329">
                  <c:v>29</c:v>
                </c:pt>
                <c:pt idx="330">
                  <c:v>38</c:v>
                </c:pt>
                <c:pt idx="331">
                  <c:v>33</c:v>
                </c:pt>
                <c:pt idx="332">
                  <c:v>21</c:v>
                </c:pt>
                <c:pt idx="333">
                  <c:v>19</c:v>
                </c:pt>
                <c:pt idx="334">
                  <c:v>39</c:v>
                </c:pt>
                <c:pt idx="335">
                  <c:v>35</c:v>
                </c:pt>
                <c:pt idx="336">
                  <c:v>40</c:v>
                </c:pt>
                <c:pt idx="337">
                  <c:v>28</c:v>
                </c:pt>
                <c:pt idx="338">
                  <c:v>52</c:v>
                </c:pt>
                <c:pt idx="339">
                  <c:v>41</c:v>
                </c:pt>
                <c:pt idx="340">
                  <c:v>14</c:v>
                </c:pt>
                <c:pt idx="341">
                  <c:v>43</c:v>
                </c:pt>
                <c:pt idx="342">
                  <c:v>31</c:v>
                </c:pt>
                <c:pt idx="343">
                  <c:v>44</c:v>
                </c:pt>
                <c:pt idx="344">
                  <c:v>32</c:v>
                </c:pt>
                <c:pt idx="345">
                  <c:v>24</c:v>
                </c:pt>
                <c:pt idx="346">
                  <c:v>37</c:v>
                </c:pt>
                <c:pt idx="347">
                  <c:v>77</c:v>
                </c:pt>
                <c:pt idx="348">
                  <c:v>28</c:v>
                </c:pt>
                <c:pt idx="349">
                  <c:v>35</c:v>
                </c:pt>
                <c:pt idx="350">
                  <c:v>8</c:v>
                </c:pt>
                <c:pt idx="351">
                  <c:v>39</c:v>
                </c:pt>
                <c:pt idx="352">
                  <c:v>35</c:v>
                </c:pt>
                <c:pt idx="353">
                  <c:v>27</c:v>
                </c:pt>
                <c:pt idx="354">
                  <c:v>46</c:v>
                </c:pt>
                <c:pt idx="355">
                  <c:v>21</c:v>
                </c:pt>
                <c:pt idx="356">
                  <c:v>41</c:v>
                </c:pt>
                <c:pt idx="357">
                  <c:v>34</c:v>
                </c:pt>
                <c:pt idx="358">
                  <c:v>43</c:v>
                </c:pt>
                <c:pt idx="359">
                  <c:v>28</c:v>
                </c:pt>
                <c:pt idx="360">
                  <c:v>39</c:v>
                </c:pt>
                <c:pt idx="361">
                  <c:v>24</c:v>
                </c:pt>
                <c:pt idx="362">
                  <c:v>23</c:v>
                </c:pt>
                <c:pt idx="363">
                  <c:v>20</c:v>
                </c:pt>
                <c:pt idx="364">
                  <c:v>10</c:v>
                </c:pt>
                <c:pt idx="365">
                  <c:v>30</c:v>
                </c:pt>
                <c:pt idx="366">
                  <c:v>28</c:v>
                </c:pt>
                <c:pt idx="367">
                  <c:v>22</c:v>
                </c:pt>
                <c:pt idx="368">
                  <c:v>30</c:v>
                </c:pt>
                <c:pt idx="369">
                  <c:v>27</c:v>
                </c:pt>
                <c:pt idx="370">
                  <c:v>29</c:v>
                </c:pt>
                <c:pt idx="371">
                  <c:v>20</c:v>
                </c:pt>
                <c:pt idx="372">
                  <c:v>23</c:v>
                </c:pt>
                <c:pt idx="373">
                  <c:v>25</c:v>
                </c:pt>
                <c:pt idx="374">
                  <c:v>23</c:v>
                </c:pt>
                <c:pt idx="375">
                  <c:v>21</c:v>
                </c:pt>
                <c:pt idx="376">
                  <c:v>24</c:v>
                </c:pt>
                <c:pt idx="377">
                  <c:v>23</c:v>
                </c:pt>
                <c:pt idx="378">
                  <c:v>19</c:v>
                </c:pt>
                <c:pt idx="379">
                  <c:v>37</c:v>
                </c:pt>
                <c:pt idx="380">
                  <c:v>35</c:v>
                </c:pt>
                <c:pt idx="381">
                  <c:v>13</c:v>
                </c:pt>
                <c:pt idx="382">
                  <c:v>31</c:v>
                </c:pt>
                <c:pt idx="383">
                  <c:v>17</c:v>
                </c:pt>
                <c:pt idx="384">
                  <c:v>14</c:v>
                </c:pt>
                <c:pt idx="385">
                  <c:v>12</c:v>
                </c:pt>
                <c:pt idx="386">
                  <c:v>22</c:v>
                </c:pt>
                <c:pt idx="387">
                  <c:v>23</c:v>
                </c:pt>
                <c:pt idx="388">
                  <c:v>24</c:v>
                </c:pt>
                <c:pt idx="389">
                  <c:v>24</c:v>
                </c:pt>
                <c:pt idx="390">
                  <c:v>23</c:v>
                </c:pt>
                <c:pt idx="391">
                  <c:v>92</c:v>
                </c:pt>
                <c:pt idx="392">
                  <c:v>36</c:v>
                </c:pt>
                <c:pt idx="393">
                  <c:v>20</c:v>
                </c:pt>
                <c:pt idx="394">
                  <c:v>18</c:v>
                </c:pt>
                <c:pt idx="395">
                  <c:v>8</c:v>
                </c:pt>
                <c:pt idx="396">
                  <c:v>12</c:v>
                </c:pt>
                <c:pt idx="397">
                  <c:v>22</c:v>
                </c:pt>
                <c:pt idx="398">
                  <c:v>15</c:v>
                </c:pt>
                <c:pt idx="399">
                  <c:v>44</c:v>
                </c:pt>
                <c:pt idx="400">
                  <c:v>60</c:v>
                </c:pt>
                <c:pt idx="401">
                  <c:v>12</c:v>
                </c:pt>
                <c:pt idx="402">
                  <c:v>8</c:v>
                </c:pt>
                <c:pt idx="403">
                  <c:v>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D9D-4246-BDE8-8CDD68C79A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4195888"/>
        <c:axId val="10146496"/>
      </c:scatterChart>
      <c:valAx>
        <c:axId val="2114195888"/>
        <c:scaling>
          <c:orientation val="minMax"/>
          <c:max val="15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0146496"/>
        <c:crosses val="autoZero"/>
        <c:crossBetween val="midCat"/>
      </c:valAx>
      <c:valAx>
        <c:axId val="10146496"/>
        <c:scaling>
          <c:orientation val="minMax"/>
          <c:max val="7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114195888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Y 值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-0.4308864467026004"/>
                  <c:y val="-3.7643560958382866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altLang="zh-CN" sz="800" b="0" i="0" u="none" strike="noStrike" kern="1200" baseline="0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A$2:$A$146</c:f>
              <c:numCache>
                <c:formatCode>General</c:formatCode>
                <c:ptCount val="145"/>
                <c:pt idx="0">
                  <c:v>104</c:v>
                </c:pt>
                <c:pt idx="1">
                  <c:v>109</c:v>
                </c:pt>
                <c:pt idx="2">
                  <c:v>108</c:v>
                </c:pt>
                <c:pt idx="3">
                  <c:v>105</c:v>
                </c:pt>
                <c:pt idx="4">
                  <c:v>97</c:v>
                </c:pt>
                <c:pt idx="5">
                  <c:v>84</c:v>
                </c:pt>
                <c:pt idx="6">
                  <c:v>90</c:v>
                </c:pt>
                <c:pt idx="7">
                  <c:v>92</c:v>
                </c:pt>
                <c:pt idx="8">
                  <c:v>88</c:v>
                </c:pt>
                <c:pt idx="9">
                  <c:v>86</c:v>
                </c:pt>
                <c:pt idx="10">
                  <c:v>85</c:v>
                </c:pt>
                <c:pt idx="11">
                  <c:v>82</c:v>
                </c:pt>
                <c:pt idx="12">
                  <c:v>86</c:v>
                </c:pt>
                <c:pt idx="13">
                  <c:v>91</c:v>
                </c:pt>
                <c:pt idx="14">
                  <c:v>84</c:v>
                </c:pt>
                <c:pt idx="15">
                  <c:v>73</c:v>
                </c:pt>
                <c:pt idx="16">
                  <c:v>80</c:v>
                </c:pt>
                <c:pt idx="17">
                  <c:v>81</c:v>
                </c:pt>
                <c:pt idx="18">
                  <c:v>82</c:v>
                </c:pt>
                <c:pt idx="19">
                  <c:v>79</c:v>
                </c:pt>
                <c:pt idx="20">
                  <c:v>70</c:v>
                </c:pt>
                <c:pt idx="21">
                  <c:v>80</c:v>
                </c:pt>
                <c:pt idx="22">
                  <c:v>75</c:v>
                </c:pt>
                <c:pt idx="23">
                  <c:v>72</c:v>
                </c:pt>
                <c:pt idx="24">
                  <c:v>75</c:v>
                </c:pt>
                <c:pt idx="25">
                  <c:v>80</c:v>
                </c:pt>
                <c:pt idx="26">
                  <c:v>68</c:v>
                </c:pt>
                <c:pt idx="27">
                  <c:v>71</c:v>
                </c:pt>
                <c:pt idx="28">
                  <c:v>70</c:v>
                </c:pt>
                <c:pt idx="29">
                  <c:v>69</c:v>
                </c:pt>
                <c:pt idx="30">
                  <c:v>75</c:v>
                </c:pt>
                <c:pt idx="31">
                  <c:v>71</c:v>
                </c:pt>
                <c:pt idx="32">
                  <c:v>69</c:v>
                </c:pt>
                <c:pt idx="33">
                  <c:v>74</c:v>
                </c:pt>
                <c:pt idx="34">
                  <c:v>72</c:v>
                </c:pt>
                <c:pt idx="35">
                  <c:v>63</c:v>
                </c:pt>
                <c:pt idx="36">
                  <c:v>67</c:v>
                </c:pt>
                <c:pt idx="37">
                  <c:v>68</c:v>
                </c:pt>
                <c:pt idx="38">
                  <c:v>77</c:v>
                </c:pt>
                <c:pt idx="39">
                  <c:v>67</c:v>
                </c:pt>
                <c:pt idx="40">
                  <c:v>73</c:v>
                </c:pt>
                <c:pt idx="41">
                  <c:v>69</c:v>
                </c:pt>
                <c:pt idx="42">
                  <c:v>68</c:v>
                </c:pt>
                <c:pt idx="43">
                  <c:v>71</c:v>
                </c:pt>
                <c:pt idx="44">
                  <c:v>66</c:v>
                </c:pt>
                <c:pt idx="45">
                  <c:v>61</c:v>
                </c:pt>
                <c:pt idx="46">
                  <c:v>61</c:v>
                </c:pt>
                <c:pt idx="47">
                  <c:v>65</c:v>
                </c:pt>
                <c:pt idx="48">
                  <c:v>68</c:v>
                </c:pt>
                <c:pt idx="49">
                  <c:v>64</c:v>
                </c:pt>
                <c:pt idx="50">
                  <c:v>57</c:v>
                </c:pt>
                <c:pt idx="51">
                  <c:v>64</c:v>
                </c:pt>
                <c:pt idx="52">
                  <c:v>56</c:v>
                </c:pt>
                <c:pt idx="53">
                  <c:v>58</c:v>
                </c:pt>
                <c:pt idx="54">
                  <c:v>65</c:v>
                </c:pt>
                <c:pt idx="55">
                  <c:v>61</c:v>
                </c:pt>
                <c:pt idx="56">
                  <c:v>56</c:v>
                </c:pt>
                <c:pt idx="57">
                  <c:v>58</c:v>
                </c:pt>
                <c:pt idx="58">
                  <c:v>62</c:v>
                </c:pt>
                <c:pt idx="59">
                  <c:v>63</c:v>
                </c:pt>
                <c:pt idx="60">
                  <c:v>67</c:v>
                </c:pt>
                <c:pt idx="61">
                  <c:v>67</c:v>
                </c:pt>
                <c:pt idx="62">
                  <c:v>70</c:v>
                </c:pt>
                <c:pt idx="63">
                  <c:v>68</c:v>
                </c:pt>
                <c:pt idx="64">
                  <c:v>63</c:v>
                </c:pt>
                <c:pt idx="65">
                  <c:v>63</c:v>
                </c:pt>
                <c:pt idx="66">
                  <c:v>57</c:v>
                </c:pt>
                <c:pt idx="67">
                  <c:v>64</c:v>
                </c:pt>
                <c:pt idx="68">
                  <c:v>58</c:v>
                </c:pt>
                <c:pt idx="69">
                  <c:v>56</c:v>
                </c:pt>
                <c:pt idx="70">
                  <c:v>61</c:v>
                </c:pt>
                <c:pt idx="71">
                  <c:v>56</c:v>
                </c:pt>
                <c:pt idx="72">
                  <c:v>56</c:v>
                </c:pt>
                <c:pt idx="73">
                  <c:v>57</c:v>
                </c:pt>
                <c:pt idx="74">
                  <c:v>53</c:v>
                </c:pt>
                <c:pt idx="75">
                  <c:v>53</c:v>
                </c:pt>
                <c:pt idx="76">
                  <c:v>61</c:v>
                </c:pt>
                <c:pt idx="77">
                  <c:v>58</c:v>
                </c:pt>
                <c:pt idx="78">
                  <c:v>53</c:v>
                </c:pt>
                <c:pt idx="79">
                  <c:v>56</c:v>
                </c:pt>
                <c:pt idx="80">
                  <c:v>58</c:v>
                </c:pt>
                <c:pt idx="81">
                  <c:v>57</c:v>
                </c:pt>
                <c:pt idx="82">
                  <c:v>53</c:v>
                </c:pt>
                <c:pt idx="83">
                  <c:v>51</c:v>
                </c:pt>
                <c:pt idx="84">
                  <c:v>57</c:v>
                </c:pt>
                <c:pt idx="85">
                  <c:v>53</c:v>
                </c:pt>
                <c:pt idx="86">
                  <c:v>49</c:v>
                </c:pt>
                <c:pt idx="87">
                  <c:v>55</c:v>
                </c:pt>
                <c:pt idx="88">
                  <c:v>56</c:v>
                </c:pt>
                <c:pt idx="89">
                  <c:v>49</c:v>
                </c:pt>
                <c:pt idx="90">
                  <c:v>57</c:v>
                </c:pt>
                <c:pt idx="91">
                  <c:v>45</c:v>
                </c:pt>
                <c:pt idx="92">
                  <c:v>49</c:v>
                </c:pt>
                <c:pt idx="93">
                  <c:v>64</c:v>
                </c:pt>
                <c:pt idx="94">
                  <c:v>50</c:v>
                </c:pt>
                <c:pt idx="95">
                  <c:v>45</c:v>
                </c:pt>
                <c:pt idx="96">
                  <c:v>48</c:v>
                </c:pt>
                <c:pt idx="97">
                  <c:v>43</c:v>
                </c:pt>
                <c:pt idx="98">
                  <c:v>50</c:v>
                </c:pt>
                <c:pt idx="99">
                  <c:v>44</c:v>
                </c:pt>
                <c:pt idx="100">
                  <c:v>54</c:v>
                </c:pt>
                <c:pt idx="101">
                  <c:v>51</c:v>
                </c:pt>
                <c:pt idx="102">
                  <c:v>42</c:v>
                </c:pt>
                <c:pt idx="103">
                  <c:v>54</c:v>
                </c:pt>
                <c:pt idx="104">
                  <c:v>42</c:v>
                </c:pt>
                <c:pt idx="105">
                  <c:v>52</c:v>
                </c:pt>
                <c:pt idx="106">
                  <c:v>49</c:v>
                </c:pt>
                <c:pt idx="107">
                  <c:v>52</c:v>
                </c:pt>
                <c:pt idx="108">
                  <c:v>42</c:v>
                </c:pt>
                <c:pt idx="109">
                  <c:v>43</c:v>
                </c:pt>
                <c:pt idx="110">
                  <c:v>44</c:v>
                </c:pt>
                <c:pt idx="111">
                  <c:v>39</c:v>
                </c:pt>
                <c:pt idx="112">
                  <c:v>45</c:v>
                </c:pt>
                <c:pt idx="113">
                  <c:v>45</c:v>
                </c:pt>
                <c:pt idx="114">
                  <c:v>47</c:v>
                </c:pt>
                <c:pt idx="115">
                  <c:v>39</c:v>
                </c:pt>
                <c:pt idx="116">
                  <c:v>43</c:v>
                </c:pt>
                <c:pt idx="117">
                  <c:v>44</c:v>
                </c:pt>
                <c:pt idx="118">
                  <c:v>40</c:v>
                </c:pt>
                <c:pt idx="119">
                  <c:v>38</c:v>
                </c:pt>
                <c:pt idx="120">
                  <c:v>42</c:v>
                </c:pt>
                <c:pt idx="121">
                  <c:v>38</c:v>
                </c:pt>
                <c:pt idx="122">
                  <c:v>37</c:v>
                </c:pt>
                <c:pt idx="123">
                  <c:v>43</c:v>
                </c:pt>
                <c:pt idx="124">
                  <c:v>39</c:v>
                </c:pt>
                <c:pt idx="125">
                  <c:v>38</c:v>
                </c:pt>
                <c:pt idx="126">
                  <c:v>40</c:v>
                </c:pt>
                <c:pt idx="127">
                  <c:v>36</c:v>
                </c:pt>
                <c:pt idx="128">
                  <c:v>36</c:v>
                </c:pt>
                <c:pt idx="129">
                  <c:v>34</c:v>
                </c:pt>
                <c:pt idx="130">
                  <c:v>36</c:v>
                </c:pt>
                <c:pt idx="131">
                  <c:v>30</c:v>
                </c:pt>
                <c:pt idx="132">
                  <c:v>32</c:v>
                </c:pt>
                <c:pt idx="133">
                  <c:v>38</c:v>
                </c:pt>
                <c:pt idx="134">
                  <c:v>38</c:v>
                </c:pt>
                <c:pt idx="135">
                  <c:v>29</c:v>
                </c:pt>
                <c:pt idx="136">
                  <c:v>28</c:v>
                </c:pt>
                <c:pt idx="137">
                  <c:v>32</c:v>
                </c:pt>
                <c:pt idx="138">
                  <c:v>26</c:v>
                </c:pt>
                <c:pt idx="139">
                  <c:v>19</c:v>
                </c:pt>
                <c:pt idx="140">
                  <c:v>27</c:v>
                </c:pt>
                <c:pt idx="141">
                  <c:v>17</c:v>
                </c:pt>
                <c:pt idx="142">
                  <c:v>18</c:v>
                </c:pt>
                <c:pt idx="143">
                  <c:v>12</c:v>
                </c:pt>
                <c:pt idx="144">
                  <c:v>5</c:v>
                </c:pt>
              </c:numCache>
            </c:numRef>
          </c:xVal>
          <c:yVal>
            <c:numRef>
              <c:f>Sheet1!$B$2:$B$146</c:f>
              <c:numCache>
                <c:formatCode>General</c:formatCode>
                <c:ptCount val="145"/>
                <c:pt idx="0">
                  <c:v>30</c:v>
                </c:pt>
                <c:pt idx="1">
                  <c:v>33</c:v>
                </c:pt>
                <c:pt idx="2">
                  <c:v>35</c:v>
                </c:pt>
                <c:pt idx="3">
                  <c:v>23</c:v>
                </c:pt>
                <c:pt idx="4">
                  <c:v>25</c:v>
                </c:pt>
                <c:pt idx="5">
                  <c:v>26</c:v>
                </c:pt>
                <c:pt idx="6">
                  <c:v>21</c:v>
                </c:pt>
                <c:pt idx="7">
                  <c:v>22</c:v>
                </c:pt>
                <c:pt idx="8">
                  <c:v>37</c:v>
                </c:pt>
                <c:pt idx="9">
                  <c:v>24</c:v>
                </c:pt>
                <c:pt idx="10">
                  <c:v>23</c:v>
                </c:pt>
                <c:pt idx="11">
                  <c:v>22</c:v>
                </c:pt>
                <c:pt idx="12">
                  <c:v>21</c:v>
                </c:pt>
                <c:pt idx="13">
                  <c:v>31</c:v>
                </c:pt>
                <c:pt idx="14">
                  <c:v>32</c:v>
                </c:pt>
                <c:pt idx="15">
                  <c:v>18</c:v>
                </c:pt>
                <c:pt idx="16">
                  <c:v>28</c:v>
                </c:pt>
                <c:pt idx="17">
                  <c:v>33</c:v>
                </c:pt>
                <c:pt idx="18">
                  <c:v>27</c:v>
                </c:pt>
                <c:pt idx="19">
                  <c:v>18</c:v>
                </c:pt>
                <c:pt idx="20">
                  <c:v>32</c:v>
                </c:pt>
                <c:pt idx="21">
                  <c:v>27</c:v>
                </c:pt>
                <c:pt idx="22">
                  <c:v>12</c:v>
                </c:pt>
                <c:pt idx="23">
                  <c:v>19</c:v>
                </c:pt>
                <c:pt idx="24">
                  <c:v>20</c:v>
                </c:pt>
                <c:pt idx="25">
                  <c:v>21</c:v>
                </c:pt>
                <c:pt idx="26">
                  <c:v>27</c:v>
                </c:pt>
                <c:pt idx="27">
                  <c:v>27</c:v>
                </c:pt>
                <c:pt idx="28">
                  <c:v>21</c:v>
                </c:pt>
                <c:pt idx="29">
                  <c:v>13</c:v>
                </c:pt>
                <c:pt idx="30">
                  <c:v>18</c:v>
                </c:pt>
                <c:pt idx="31">
                  <c:v>26</c:v>
                </c:pt>
                <c:pt idx="32">
                  <c:v>23</c:v>
                </c:pt>
                <c:pt idx="33">
                  <c:v>25</c:v>
                </c:pt>
                <c:pt idx="34">
                  <c:v>15</c:v>
                </c:pt>
                <c:pt idx="35">
                  <c:v>11</c:v>
                </c:pt>
                <c:pt idx="36">
                  <c:v>12</c:v>
                </c:pt>
                <c:pt idx="37">
                  <c:v>28</c:v>
                </c:pt>
                <c:pt idx="38">
                  <c:v>24</c:v>
                </c:pt>
                <c:pt idx="39">
                  <c:v>25</c:v>
                </c:pt>
                <c:pt idx="40">
                  <c:v>27</c:v>
                </c:pt>
                <c:pt idx="41">
                  <c:v>22</c:v>
                </c:pt>
                <c:pt idx="42">
                  <c:v>25</c:v>
                </c:pt>
                <c:pt idx="43">
                  <c:v>20</c:v>
                </c:pt>
                <c:pt idx="44">
                  <c:v>25</c:v>
                </c:pt>
                <c:pt idx="45">
                  <c:v>23</c:v>
                </c:pt>
                <c:pt idx="46">
                  <c:v>16</c:v>
                </c:pt>
                <c:pt idx="47">
                  <c:v>28</c:v>
                </c:pt>
                <c:pt idx="48">
                  <c:v>28</c:v>
                </c:pt>
                <c:pt idx="49">
                  <c:v>29</c:v>
                </c:pt>
                <c:pt idx="50">
                  <c:v>5</c:v>
                </c:pt>
                <c:pt idx="51">
                  <c:v>26</c:v>
                </c:pt>
                <c:pt idx="52">
                  <c:v>10</c:v>
                </c:pt>
                <c:pt idx="53">
                  <c:v>30</c:v>
                </c:pt>
                <c:pt idx="54">
                  <c:v>17</c:v>
                </c:pt>
                <c:pt idx="55">
                  <c:v>21</c:v>
                </c:pt>
                <c:pt idx="56">
                  <c:v>27</c:v>
                </c:pt>
                <c:pt idx="57">
                  <c:v>22</c:v>
                </c:pt>
                <c:pt idx="58">
                  <c:v>30</c:v>
                </c:pt>
                <c:pt idx="59">
                  <c:v>19</c:v>
                </c:pt>
                <c:pt idx="60">
                  <c:v>23</c:v>
                </c:pt>
                <c:pt idx="61">
                  <c:v>25</c:v>
                </c:pt>
                <c:pt idx="62">
                  <c:v>30</c:v>
                </c:pt>
                <c:pt idx="63">
                  <c:v>33</c:v>
                </c:pt>
                <c:pt idx="64">
                  <c:v>28</c:v>
                </c:pt>
                <c:pt idx="65">
                  <c:v>16</c:v>
                </c:pt>
                <c:pt idx="66">
                  <c:v>16</c:v>
                </c:pt>
                <c:pt idx="67">
                  <c:v>27</c:v>
                </c:pt>
                <c:pt idx="68">
                  <c:v>23</c:v>
                </c:pt>
                <c:pt idx="69">
                  <c:v>24</c:v>
                </c:pt>
                <c:pt idx="70">
                  <c:v>26</c:v>
                </c:pt>
                <c:pt idx="71">
                  <c:v>26</c:v>
                </c:pt>
                <c:pt idx="72">
                  <c:v>21</c:v>
                </c:pt>
                <c:pt idx="73">
                  <c:v>26</c:v>
                </c:pt>
                <c:pt idx="74">
                  <c:v>12</c:v>
                </c:pt>
                <c:pt idx="75">
                  <c:v>19</c:v>
                </c:pt>
                <c:pt idx="76">
                  <c:v>23</c:v>
                </c:pt>
                <c:pt idx="77">
                  <c:v>11</c:v>
                </c:pt>
                <c:pt idx="78">
                  <c:v>19</c:v>
                </c:pt>
                <c:pt idx="79">
                  <c:v>23</c:v>
                </c:pt>
                <c:pt idx="80">
                  <c:v>11</c:v>
                </c:pt>
                <c:pt idx="81">
                  <c:v>25</c:v>
                </c:pt>
                <c:pt idx="82">
                  <c:v>15</c:v>
                </c:pt>
                <c:pt idx="83">
                  <c:v>31</c:v>
                </c:pt>
                <c:pt idx="84">
                  <c:v>20</c:v>
                </c:pt>
                <c:pt idx="85">
                  <c:v>14</c:v>
                </c:pt>
                <c:pt idx="86">
                  <c:v>22</c:v>
                </c:pt>
                <c:pt idx="87">
                  <c:v>17</c:v>
                </c:pt>
                <c:pt idx="88">
                  <c:v>28</c:v>
                </c:pt>
                <c:pt idx="89">
                  <c:v>12</c:v>
                </c:pt>
                <c:pt idx="90">
                  <c:v>14</c:v>
                </c:pt>
                <c:pt idx="91">
                  <c:v>16</c:v>
                </c:pt>
                <c:pt idx="92">
                  <c:v>20</c:v>
                </c:pt>
                <c:pt idx="93">
                  <c:v>29</c:v>
                </c:pt>
                <c:pt idx="94">
                  <c:v>22</c:v>
                </c:pt>
                <c:pt idx="95">
                  <c:v>18</c:v>
                </c:pt>
                <c:pt idx="96">
                  <c:v>14</c:v>
                </c:pt>
                <c:pt idx="97">
                  <c:v>20</c:v>
                </c:pt>
                <c:pt idx="98">
                  <c:v>29</c:v>
                </c:pt>
                <c:pt idx="99">
                  <c:v>17</c:v>
                </c:pt>
                <c:pt idx="100">
                  <c:v>15</c:v>
                </c:pt>
                <c:pt idx="101">
                  <c:v>23</c:v>
                </c:pt>
                <c:pt idx="102">
                  <c:v>24</c:v>
                </c:pt>
                <c:pt idx="103">
                  <c:v>25</c:v>
                </c:pt>
                <c:pt idx="104">
                  <c:v>30</c:v>
                </c:pt>
                <c:pt idx="105">
                  <c:v>26</c:v>
                </c:pt>
                <c:pt idx="106">
                  <c:v>12</c:v>
                </c:pt>
                <c:pt idx="107">
                  <c:v>13</c:v>
                </c:pt>
                <c:pt idx="108">
                  <c:v>14</c:v>
                </c:pt>
                <c:pt idx="109">
                  <c:v>16</c:v>
                </c:pt>
                <c:pt idx="110">
                  <c:v>13</c:v>
                </c:pt>
                <c:pt idx="111">
                  <c:v>14</c:v>
                </c:pt>
                <c:pt idx="112">
                  <c:v>7</c:v>
                </c:pt>
                <c:pt idx="113">
                  <c:v>19</c:v>
                </c:pt>
                <c:pt idx="114">
                  <c:v>14</c:v>
                </c:pt>
                <c:pt idx="115">
                  <c:v>24</c:v>
                </c:pt>
                <c:pt idx="116">
                  <c:v>14</c:v>
                </c:pt>
                <c:pt idx="117">
                  <c:v>12</c:v>
                </c:pt>
                <c:pt idx="118">
                  <c:v>22</c:v>
                </c:pt>
                <c:pt idx="119">
                  <c:v>15</c:v>
                </c:pt>
                <c:pt idx="120">
                  <c:v>12</c:v>
                </c:pt>
                <c:pt idx="121">
                  <c:v>17</c:v>
                </c:pt>
                <c:pt idx="122">
                  <c:v>11</c:v>
                </c:pt>
                <c:pt idx="123">
                  <c:v>24</c:v>
                </c:pt>
                <c:pt idx="124">
                  <c:v>23</c:v>
                </c:pt>
                <c:pt idx="125">
                  <c:v>16</c:v>
                </c:pt>
                <c:pt idx="126">
                  <c:v>21</c:v>
                </c:pt>
                <c:pt idx="127">
                  <c:v>17</c:v>
                </c:pt>
                <c:pt idx="128">
                  <c:v>17</c:v>
                </c:pt>
                <c:pt idx="129">
                  <c:v>23</c:v>
                </c:pt>
                <c:pt idx="130">
                  <c:v>24</c:v>
                </c:pt>
                <c:pt idx="131">
                  <c:v>15</c:v>
                </c:pt>
                <c:pt idx="132">
                  <c:v>15</c:v>
                </c:pt>
                <c:pt idx="133">
                  <c:v>9</c:v>
                </c:pt>
                <c:pt idx="134">
                  <c:v>12</c:v>
                </c:pt>
                <c:pt idx="135">
                  <c:v>14</c:v>
                </c:pt>
                <c:pt idx="136">
                  <c:v>7</c:v>
                </c:pt>
                <c:pt idx="137">
                  <c:v>13</c:v>
                </c:pt>
                <c:pt idx="138">
                  <c:v>12</c:v>
                </c:pt>
                <c:pt idx="139">
                  <c:v>21</c:v>
                </c:pt>
                <c:pt idx="140">
                  <c:v>12</c:v>
                </c:pt>
                <c:pt idx="141">
                  <c:v>15</c:v>
                </c:pt>
                <c:pt idx="142">
                  <c:v>6</c:v>
                </c:pt>
                <c:pt idx="143">
                  <c:v>9</c:v>
                </c:pt>
                <c:pt idx="144">
                  <c:v>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7C9-4B8C-997E-2F74239729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5884272"/>
        <c:axId val="1686546640"/>
      </c:scatterChart>
      <c:valAx>
        <c:axId val="1825884272"/>
        <c:scaling>
          <c:orientation val="minMax"/>
          <c:max val="12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686546640"/>
        <c:crosses val="autoZero"/>
        <c:crossBetween val="midCat"/>
        <c:majorUnit val="30"/>
      </c:valAx>
      <c:valAx>
        <c:axId val="16865466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825884272"/>
        <c:crosses val="autoZero"/>
        <c:crossBetween val="midCat"/>
        <c:majorUnit val="1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Y 值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25400" cap="rnd">
                <a:solidFill>
                  <a:srgbClr val="FF0000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-0.23252081391419022"/>
                  <c:y val="-2.0793645267027112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rgbClr val="FF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A$2:$A$486</c:f>
              <c:numCache>
                <c:formatCode>General</c:formatCode>
                <c:ptCount val="485"/>
                <c:pt idx="0">
                  <c:v>1483</c:v>
                </c:pt>
                <c:pt idx="1">
                  <c:v>1232</c:v>
                </c:pt>
                <c:pt idx="2">
                  <c:v>1232</c:v>
                </c:pt>
                <c:pt idx="3">
                  <c:v>1192</c:v>
                </c:pt>
                <c:pt idx="4">
                  <c:v>1145</c:v>
                </c:pt>
                <c:pt idx="5">
                  <c:v>1131</c:v>
                </c:pt>
                <c:pt idx="6">
                  <c:v>1080</c:v>
                </c:pt>
                <c:pt idx="7">
                  <c:v>1073</c:v>
                </c:pt>
                <c:pt idx="8">
                  <c:v>1051</c:v>
                </c:pt>
                <c:pt idx="9">
                  <c:v>1042</c:v>
                </c:pt>
                <c:pt idx="10">
                  <c:v>1027</c:v>
                </c:pt>
                <c:pt idx="11">
                  <c:v>1017</c:v>
                </c:pt>
                <c:pt idx="12">
                  <c:v>960</c:v>
                </c:pt>
                <c:pt idx="13">
                  <c:v>907</c:v>
                </c:pt>
                <c:pt idx="14">
                  <c:v>885</c:v>
                </c:pt>
                <c:pt idx="15">
                  <c:v>826</c:v>
                </c:pt>
                <c:pt idx="16">
                  <c:v>791</c:v>
                </c:pt>
                <c:pt idx="17">
                  <c:v>759</c:v>
                </c:pt>
                <c:pt idx="18">
                  <c:v>748</c:v>
                </c:pt>
                <c:pt idx="19">
                  <c:v>721</c:v>
                </c:pt>
                <c:pt idx="20">
                  <c:v>711</c:v>
                </c:pt>
                <c:pt idx="21">
                  <c:v>702</c:v>
                </c:pt>
                <c:pt idx="22">
                  <c:v>701</c:v>
                </c:pt>
                <c:pt idx="23">
                  <c:v>700</c:v>
                </c:pt>
                <c:pt idx="24">
                  <c:v>699</c:v>
                </c:pt>
                <c:pt idx="25">
                  <c:v>697</c:v>
                </c:pt>
                <c:pt idx="26">
                  <c:v>680</c:v>
                </c:pt>
                <c:pt idx="27">
                  <c:v>675</c:v>
                </c:pt>
                <c:pt idx="28">
                  <c:v>666</c:v>
                </c:pt>
                <c:pt idx="29">
                  <c:v>662</c:v>
                </c:pt>
                <c:pt idx="30">
                  <c:v>658</c:v>
                </c:pt>
                <c:pt idx="31">
                  <c:v>653</c:v>
                </c:pt>
                <c:pt idx="32">
                  <c:v>630</c:v>
                </c:pt>
                <c:pt idx="33">
                  <c:v>617</c:v>
                </c:pt>
                <c:pt idx="34">
                  <c:v>576</c:v>
                </c:pt>
                <c:pt idx="35">
                  <c:v>576</c:v>
                </c:pt>
                <c:pt idx="36">
                  <c:v>574</c:v>
                </c:pt>
                <c:pt idx="37">
                  <c:v>568</c:v>
                </c:pt>
                <c:pt idx="38">
                  <c:v>561</c:v>
                </c:pt>
                <c:pt idx="39">
                  <c:v>560</c:v>
                </c:pt>
                <c:pt idx="40">
                  <c:v>560</c:v>
                </c:pt>
                <c:pt idx="41">
                  <c:v>549</c:v>
                </c:pt>
                <c:pt idx="42">
                  <c:v>547</c:v>
                </c:pt>
                <c:pt idx="43">
                  <c:v>543</c:v>
                </c:pt>
                <c:pt idx="44">
                  <c:v>540</c:v>
                </c:pt>
                <c:pt idx="45">
                  <c:v>536</c:v>
                </c:pt>
                <c:pt idx="46">
                  <c:v>536</c:v>
                </c:pt>
                <c:pt idx="47">
                  <c:v>530</c:v>
                </c:pt>
                <c:pt idx="48">
                  <c:v>523</c:v>
                </c:pt>
                <c:pt idx="49">
                  <c:v>517</c:v>
                </c:pt>
                <c:pt idx="50">
                  <c:v>507</c:v>
                </c:pt>
                <c:pt idx="51">
                  <c:v>506</c:v>
                </c:pt>
                <c:pt idx="52">
                  <c:v>503</c:v>
                </c:pt>
                <c:pt idx="53">
                  <c:v>492</c:v>
                </c:pt>
                <c:pt idx="54">
                  <c:v>490</c:v>
                </c:pt>
                <c:pt idx="55">
                  <c:v>478</c:v>
                </c:pt>
                <c:pt idx="56">
                  <c:v>477</c:v>
                </c:pt>
                <c:pt idx="57">
                  <c:v>477</c:v>
                </c:pt>
                <c:pt idx="58">
                  <c:v>475</c:v>
                </c:pt>
                <c:pt idx="59">
                  <c:v>473</c:v>
                </c:pt>
                <c:pt idx="60">
                  <c:v>471</c:v>
                </c:pt>
                <c:pt idx="61">
                  <c:v>466</c:v>
                </c:pt>
                <c:pt idx="62">
                  <c:v>464</c:v>
                </c:pt>
                <c:pt idx="63">
                  <c:v>461</c:v>
                </c:pt>
                <c:pt idx="64">
                  <c:v>460</c:v>
                </c:pt>
                <c:pt idx="65">
                  <c:v>460</c:v>
                </c:pt>
                <c:pt idx="66">
                  <c:v>456</c:v>
                </c:pt>
                <c:pt idx="67">
                  <c:v>455</c:v>
                </c:pt>
                <c:pt idx="68">
                  <c:v>449</c:v>
                </c:pt>
                <c:pt idx="69">
                  <c:v>448</c:v>
                </c:pt>
                <c:pt idx="70">
                  <c:v>446</c:v>
                </c:pt>
                <c:pt idx="71">
                  <c:v>445</c:v>
                </c:pt>
                <c:pt idx="72">
                  <c:v>442</c:v>
                </c:pt>
                <c:pt idx="73">
                  <c:v>442</c:v>
                </c:pt>
                <c:pt idx="74">
                  <c:v>441</c:v>
                </c:pt>
                <c:pt idx="75">
                  <c:v>439</c:v>
                </c:pt>
                <c:pt idx="76">
                  <c:v>437</c:v>
                </c:pt>
                <c:pt idx="77">
                  <c:v>435</c:v>
                </c:pt>
                <c:pt idx="78">
                  <c:v>431</c:v>
                </c:pt>
                <c:pt idx="79">
                  <c:v>430</c:v>
                </c:pt>
                <c:pt idx="80">
                  <c:v>430</c:v>
                </c:pt>
                <c:pt idx="81">
                  <c:v>429</c:v>
                </c:pt>
                <c:pt idx="82">
                  <c:v>429</c:v>
                </c:pt>
                <c:pt idx="83">
                  <c:v>429</c:v>
                </c:pt>
                <c:pt idx="84">
                  <c:v>426</c:v>
                </c:pt>
                <c:pt idx="85">
                  <c:v>424</c:v>
                </c:pt>
                <c:pt idx="86">
                  <c:v>423</c:v>
                </c:pt>
                <c:pt idx="87">
                  <c:v>422</c:v>
                </c:pt>
                <c:pt idx="88">
                  <c:v>421</c:v>
                </c:pt>
                <c:pt idx="89">
                  <c:v>421</c:v>
                </c:pt>
                <c:pt idx="90">
                  <c:v>420</c:v>
                </c:pt>
                <c:pt idx="91">
                  <c:v>418</c:v>
                </c:pt>
                <c:pt idx="92">
                  <c:v>417</c:v>
                </c:pt>
                <c:pt idx="93">
                  <c:v>416</c:v>
                </c:pt>
                <c:pt idx="94">
                  <c:v>415</c:v>
                </c:pt>
                <c:pt idx="95">
                  <c:v>414</c:v>
                </c:pt>
                <c:pt idx="96">
                  <c:v>413</c:v>
                </c:pt>
                <c:pt idx="97">
                  <c:v>412</c:v>
                </c:pt>
                <c:pt idx="98">
                  <c:v>411</c:v>
                </c:pt>
                <c:pt idx="99">
                  <c:v>410</c:v>
                </c:pt>
                <c:pt idx="100">
                  <c:v>410</c:v>
                </c:pt>
                <c:pt idx="101">
                  <c:v>408</c:v>
                </c:pt>
                <c:pt idx="102">
                  <c:v>408</c:v>
                </c:pt>
                <c:pt idx="103">
                  <c:v>406</c:v>
                </c:pt>
                <c:pt idx="104">
                  <c:v>399</c:v>
                </c:pt>
                <c:pt idx="105">
                  <c:v>399</c:v>
                </c:pt>
                <c:pt idx="106">
                  <c:v>399</c:v>
                </c:pt>
                <c:pt idx="107">
                  <c:v>398</c:v>
                </c:pt>
                <c:pt idx="108">
                  <c:v>398</c:v>
                </c:pt>
                <c:pt idx="109">
                  <c:v>397</c:v>
                </c:pt>
                <c:pt idx="110">
                  <c:v>395</c:v>
                </c:pt>
                <c:pt idx="111">
                  <c:v>394</c:v>
                </c:pt>
                <c:pt idx="112">
                  <c:v>392</c:v>
                </c:pt>
                <c:pt idx="113">
                  <c:v>391</c:v>
                </c:pt>
                <c:pt idx="114">
                  <c:v>389</c:v>
                </c:pt>
                <c:pt idx="115">
                  <c:v>388</c:v>
                </c:pt>
                <c:pt idx="116">
                  <c:v>381</c:v>
                </c:pt>
                <c:pt idx="117">
                  <c:v>380</c:v>
                </c:pt>
                <c:pt idx="118">
                  <c:v>380</c:v>
                </c:pt>
                <c:pt idx="119">
                  <c:v>379</c:v>
                </c:pt>
                <c:pt idx="120">
                  <c:v>379</c:v>
                </c:pt>
                <c:pt idx="121">
                  <c:v>377</c:v>
                </c:pt>
                <c:pt idx="122">
                  <c:v>375</c:v>
                </c:pt>
                <c:pt idx="123">
                  <c:v>375</c:v>
                </c:pt>
                <c:pt idx="124">
                  <c:v>374</c:v>
                </c:pt>
                <c:pt idx="125">
                  <c:v>373</c:v>
                </c:pt>
                <c:pt idx="126">
                  <c:v>373</c:v>
                </c:pt>
                <c:pt idx="127">
                  <c:v>372</c:v>
                </c:pt>
                <c:pt idx="128">
                  <c:v>372</c:v>
                </c:pt>
                <c:pt idx="129">
                  <c:v>372</c:v>
                </c:pt>
                <c:pt idx="130">
                  <c:v>372</c:v>
                </c:pt>
                <c:pt idx="131">
                  <c:v>372</c:v>
                </c:pt>
                <c:pt idx="132">
                  <c:v>371</c:v>
                </c:pt>
                <c:pt idx="133">
                  <c:v>369</c:v>
                </c:pt>
                <c:pt idx="134">
                  <c:v>368</c:v>
                </c:pt>
                <c:pt idx="135">
                  <c:v>367</c:v>
                </c:pt>
                <c:pt idx="136">
                  <c:v>367</c:v>
                </c:pt>
                <c:pt idx="137">
                  <c:v>366</c:v>
                </c:pt>
                <c:pt idx="138">
                  <c:v>364</c:v>
                </c:pt>
                <c:pt idx="139">
                  <c:v>363</c:v>
                </c:pt>
                <c:pt idx="140">
                  <c:v>363</c:v>
                </c:pt>
                <c:pt idx="141">
                  <c:v>362</c:v>
                </c:pt>
                <c:pt idx="142">
                  <c:v>359</c:v>
                </c:pt>
                <c:pt idx="143">
                  <c:v>358</c:v>
                </c:pt>
                <c:pt idx="144">
                  <c:v>351</c:v>
                </c:pt>
                <c:pt idx="145">
                  <c:v>348</c:v>
                </c:pt>
                <c:pt idx="146">
                  <c:v>348</c:v>
                </c:pt>
                <c:pt idx="147">
                  <c:v>347</c:v>
                </c:pt>
                <c:pt idx="148">
                  <c:v>347</c:v>
                </c:pt>
                <c:pt idx="149">
                  <c:v>345</c:v>
                </c:pt>
                <c:pt idx="150">
                  <c:v>344</c:v>
                </c:pt>
                <c:pt idx="151">
                  <c:v>343</c:v>
                </c:pt>
                <c:pt idx="152">
                  <c:v>341</c:v>
                </c:pt>
                <c:pt idx="153">
                  <c:v>340</c:v>
                </c:pt>
                <c:pt idx="154">
                  <c:v>340</c:v>
                </c:pt>
                <c:pt idx="155">
                  <c:v>339</c:v>
                </c:pt>
                <c:pt idx="156">
                  <c:v>338</c:v>
                </c:pt>
                <c:pt idx="157">
                  <c:v>336</c:v>
                </c:pt>
                <c:pt idx="158">
                  <c:v>335</c:v>
                </c:pt>
                <c:pt idx="159">
                  <c:v>334</c:v>
                </c:pt>
                <c:pt idx="160">
                  <c:v>332</c:v>
                </c:pt>
                <c:pt idx="161">
                  <c:v>331</c:v>
                </c:pt>
                <c:pt idx="162">
                  <c:v>330</c:v>
                </c:pt>
                <c:pt idx="163">
                  <c:v>330</c:v>
                </c:pt>
                <c:pt idx="164">
                  <c:v>330</c:v>
                </c:pt>
                <c:pt idx="165">
                  <c:v>329</c:v>
                </c:pt>
                <c:pt idx="166">
                  <c:v>329</c:v>
                </c:pt>
                <c:pt idx="167">
                  <c:v>328</c:v>
                </c:pt>
                <c:pt idx="168">
                  <c:v>326</c:v>
                </c:pt>
                <c:pt idx="169">
                  <c:v>326</c:v>
                </c:pt>
                <c:pt idx="170">
                  <c:v>324</c:v>
                </c:pt>
                <c:pt idx="171">
                  <c:v>323</c:v>
                </c:pt>
                <c:pt idx="172">
                  <c:v>323</c:v>
                </c:pt>
                <c:pt idx="173">
                  <c:v>323</c:v>
                </c:pt>
                <c:pt idx="174">
                  <c:v>323</c:v>
                </c:pt>
                <c:pt idx="175">
                  <c:v>322</c:v>
                </c:pt>
                <c:pt idx="176">
                  <c:v>322</c:v>
                </c:pt>
                <c:pt idx="177">
                  <c:v>321</c:v>
                </c:pt>
                <c:pt idx="178">
                  <c:v>319</c:v>
                </c:pt>
                <c:pt idx="179">
                  <c:v>319</c:v>
                </c:pt>
                <c:pt idx="180">
                  <c:v>318</c:v>
                </c:pt>
                <c:pt idx="181">
                  <c:v>315</c:v>
                </c:pt>
                <c:pt idx="182">
                  <c:v>314</c:v>
                </c:pt>
                <c:pt idx="183">
                  <c:v>314</c:v>
                </c:pt>
                <c:pt idx="184">
                  <c:v>312</c:v>
                </c:pt>
                <c:pt idx="185">
                  <c:v>311</c:v>
                </c:pt>
                <c:pt idx="186">
                  <c:v>309</c:v>
                </c:pt>
                <c:pt idx="187">
                  <c:v>308</c:v>
                </c:pt>
                <c:pt idx="188">
                  <c:v>308</c:v>
                </c:pt>
                <c:pt idx="189">
                  <c:v>307</c:v>
                </c:pt>
                <c:pt idx="190">
                  <c:v>306</c:v>
                </c:pt>
                <c:pt idx="191">
                  <c:v>306</c:v>
                </c:pt>
                <c:pt idx="192">
                  <c:v>305</c:v>
                </c:pt>
                <c:pt idx="193">
                  <c:v>304</c:v>
                </c:pt>
                <c:pt idx="194">
                  <c:v>304</c:v>
                </c:pt>
                <c:pt idx="195">
                  <c:v>304</c:v>
                </c:pt>
                <c:pt idx="196">
                  <c:v>303</c:v>
                </c:pt>
                <c:pt idx="197">
                  <c:v>303</c:v>
                </c:pt>
                <c:pt idx="198">
                  <c:v>301</c:v>
                </c:pt>
                <c:pt idx="199">
                  <c:v>301</c:v>
                </c:pt>
                <c:pt idx="200">
                  <c:v>298</c:v>
                </c:pt>
                <c:pt idx="201">
                  <c:v>296</c:v>
                </c:pt>
                <c:pt idx="202">
                  <c:v>296</c:v>
                </c:pt>
                <c:pt idx="203">
                  <c:v>295</c:v>
                </c:pt>
                <c:pt idx="204">
                  <c:v>293</c:v>
                </c:pt>
                <c:pt idx="205">
                  <c:v>293</c:v>
                </c:pt>
                <c:pt idx="206">
                  <c:v>293</c:v>
                </c:pt>
                <c:pt idx="207">
                  <c:v>291</c:v>
                </c:pt>
                <c:pt idx="208">
                  <c:v>291</c:v>
                </c:pt>
                <c:pt idx="209">
                  <c:v>291</c:v>
                </c:pt>
                <c:pt idx="210">
                  <c:v>289</c:v>
                </c:pt>
                <c:pt idx="211">
                  <c:v>287</c:v>
                </c:pt>
                <c:pt idx="212">
                  <c:v>287</c:v>
                </c:pt>
                <c:pt idx="213">
                  <c:v>286</c:v>
                </c:pt>
                <c:pt idx="214">
                  <c:v>286</c:v>
                </c:pt>
                <c:pt idx="215">
                  <c:v>282</c:v>
                </c:pt>
                <c:pt idx="216">
                  <c:v>281</c:v>
                </c:pt>
                <c:pt idx="217">
                  <c:v>279</c:v>
                </c:pt>
                <c:pt idx="218">
                  <c:v>279</c:v>
                </c:pt>
                <c:pt idx="219">
                  <c:v>279</c:v>
                </c:pt>
                <c:pt idx="220">
                  <c:v>277</c:v>
                </c:pt>
                <c:pt idx="221">
                  <c:v>276</c:v>
                </c:pt>
                <c:pt idx="222">
                  <c:v>275</c:v>
                </c:pt>
                <c:pt idx="223">
                  <c:v>275</c:v>
                </c:pt>
                <c:pt idx="224">
                  <c:v>275</c:v>
                </c:pt>
                <c:pt idx="225">
                  <c:v>275</c:v>
                </c:pt>
                <c:pt idx="226">
                  <c:v>274</c:v>
                </c:pt>
                <c:pt idx="227">
                  <c:v>274</c:v>
                </c:pt>
                <c:pt idx="228">
                  <c:v>274</c:v>
                </c:pt>
                <c:pt idx="229">
                  <c:v>273</c:v>
                </c:pt>
                <c:pt idx="230">
                  <c:v>272</c:v>
                </c:pt>
                <c:pt idx="231">
                  <c:v>272</c:v>
                </c:pt>
                <c:pt idx="232">
                  <c:v>271</c:v>
                </c:pt>
                <c:pt idx="233">
                  <c:v>270</c:v>
                </c:pt>
                <c:pt idx="234">
                  <c:v>270</c:v>
                </c:pt>
                <c:pt idx="235">
                  <c:v>268</c:v>
                </c:pt>
                <c:pt idx="236">
                  <c:v>267</c:v>
                </c:pt>
                <c:pt idx="237">
                  <c:v>267</c:v>
                </c:pt>
                <c:pt idx="238">
                  <c:v>265</c:v>
                </c:pt>
                <c:pt idx="239">
                  <c:v>265</c:v>
                </c:pt>
                <c:pt idx="240">
                  <c:v>265</c:v>
                </c:pt>
                <c:pt idx="241">
                  <c:v>264</c:v>
                </c:pt>
                <c:pt idx="242">
                  <c:v>264</c:v>
                </c:pt>
                <c:pt idx="243">
                  <c:v>263</c:v>
                </c:pt>
                <c:pt idx="244">
                  <c:v>261</c:v>
                </c:pt>
                <c:pt idx="245">
                  <c:v>259</c:v>
                </c:pt>
                <c:pt idx="246">
                  <c:v>259</c:v>
                </c:pt>
                <c:pt idx="247">
                  <c:v>259</c:v>
                </c:pt>
                <c:pt idx="248">
                  <c:v>258</c:v>
                </c:pt>
                <c:pt idx="249">
                  <c:v>257</c:v>
                </c:pt>
                <c:pt idx="250">
                  <c:v>256</c:v>
                </c:pt>
                <c:pt idx="251">
                  <c:v>256</c:v>
                </c:pt>
                <c:pt idx="252">
                  <c:v>254</c:v>
                </c:pt>
                <c:pt idx="253">
                  <c:v>253</c:v>
                </c:pt>
                <c:pt idx="254">
                  <c:v>253</c:v>
                </c:pt>
                <c:pt idx="255">
                  <c:v>252</c:v>
                </c:pt>
                <c:pt idx="256">
                  <c:v>252</c:v>
                </c:pt>
                <c:pt idx="257">
                  <c:v>250</c:v>
                </c:pt>
                <c:pt idx="258">
                  <c:v>250</c:v>
                </c:pt>
                <c:pt idx="259">
                  <c:v>250</c:v>
                </c:pt>
                <c:pt idx="260">
                  <c:v>249</c:v>
                </c:pt>
                <c:pt idx="261">
                  <c:v>249</c:v>
                </c:pt>
                <c:pt idx="262">
                  <c:v>248</c:v>
                </c:pt>
                <c:pt idx="263">
                  <c:v>248</c:v>
                </c:pt>
                <c:pt idx="264">
                  <c:v>248</c:v>
                </c:pt>
                <c:pt idx="265">
                  <c:v>247</c:v>
                </c:pt>
                <c:pt idx="266">
                  <c:v>247</c:v>
                </c:pt>
                <c:pt idx="267">
                  <c:v>247</c:v>
                </c:pt>
                <c:pt idx="268">
                  <c:v>247</c:v>
                </c:pt>
                <c:pt idx="269">
                  <c:v>246</c:v>
                </c:pt>
                <c:pt idx="270">
                  <c:v>245</c:v>
                </c:pt>
                <c:pt idx="271">
                  <c:v>244</c:v>
                </c:pt>
                <c:pt idx="272">
                  <c:v>243</c:v>
                </c:pt>
                <c:pt idx="273">
                  <c:v>242</c:v>
                </c:pt>
                <c:pt idx="274">
                  <c:v>242</c:v>
                </c:pt>
                <c:pt idx="275">
                  <c:v>240</c:v>
                </c:pt>
                <c:pt idx="276">
                  <c:v>240</c:v>
                </c:pt>
                <c:pt idx="277">
                  <c:v>239</c:v>
                </c:pt>
                <c:pt idx="278">
                  <c:v>239</c:v>
                </c:pt>
                <c:pt idx="279">
                  <c:v>238</c:v>
                </c:pt>
                <c:pt idx="280">
                  <c:v>237</c:v>
                </c:pt>
                <c:pt idx="281">
                  <c:v>237</c:v>
                </c:pt>
                <c:pt idx="282">
                  <c:v>237</c:v>
                </c:pt>
                <c:pt idx="283">
                  <c:v>236</c:v>
                </c:pt>
                <c:pt idx="284">
                  <c:v>236</c:v>
                </c:pt>
                <c:pt idx="285">
                  <c:v>236</c:v>
                </c:pt>
                <c:pt idx="286">
                  <c:v>235</c:v>
                </c:pt>
                <c:pt idx="287">
                  <c:v>234</c:v>
                </c:pt>
                <c:pt idx="288">
                  <c:v>234</c:v>
                </c:pt>
                <c:pt idx="289">
                  <c:v>234</c:v>
                </c:pt>
                <c:pt idx="290">
                  <c:v>234</c:v>
                </c:pt>
                <c:pt idx="291">
                  <c:v>233</c:v>
                </c:pt>
                <c:pt idx="292">
                  <c:v>233</c:v>
                </c:pt>
                <c:pt idx="293">
                  <c:v>233</c:v>
                </c:pt>
                <c:pt idx="294">
                  <c:v>233</c:v>
                </c:pt>
                <c:pt idx="295">
                  <c:v>233</c:v>
                </c:pt>
                <c:pt idx="296">
                  <c:v>232</c:v>
                </c:pt>
                <c:pt idx="297">
                  <c:v>232</c:v>
                </c:pt>
                <c:pt idx="298">
                  <c:v>231</c:v>
                </c:pt>
                <c:pt idx="299">
                  <c:v>231</c:v>
                </c:pt>
                <c:pt idx="300">
                  <c:v>230</c:v>
                </c:pt>
                <c:pt idx="301">
                  <c:v>229</c:v>
                </c:pt>
                <c:pt idx="302">
                  <c:v>229</c:v>
                </c:pt>
                <c:pt idx="303">
                  <c:v>228</c:v>
                </c:pt>
                <c:pt idx="304">
                  <c:v>228</c:v>
                </c:pt>
                <c:pt idx="305">
                  <c:v>228</c:v>
                </c:pt>
                <c:pt idx="306">
                  <c:v>228</c:v>
                </c:pt>
                <c:pt idx="307">
                  <c:v>228</c:v>
                </c:pt>
                <c:pt idx="308">
                  <c:v>227</c:v>
                </c:pt>
                <c:pt idx="309">
                  <c:v>227</c:v>
                </c:pt>
                <c:pt idx="310">
                  <c:v>227</c:v>
                </c:pt>
                <c:pt idx="311">
                  <c:v>226</c:v>
                </c:pt>
                <c:pt idx="312">
                  <c:v>226</c:v>
                </c:pt>
                <c:pt idx="313">
                  <c:v>226</c:v>
                </c:pt>
                <c:pt idx="314">
                  <c:v>225</c:v>
                </c:pt>
                <c:pt idx="315">
                  <c:v>225</c:v>
                </c:pt>
                <c:pt idx="316">
                  <c:v>224</c:v>
                </c:pt>
                <c:pt idx="317">
                  <c:v>223</c:v>
                </c:pt>
                <c:pt idx="318">
                  <c:v>223</c:v>
                </c:pt>
                <c:pt idx="319">
                  <c:v>223</c:v>
                </c:pt>
                <c:pt idx="320">
                  <c:v>222</c:v>
                </c:pt>
                <c:pt idx="321">
                  <c:v>222</c:v>
                </c:pt>
                <c:pt idx="322">
                  <c:v>221</c:v>
                </c:pt>
                <c:pt idx="323">
                  <c:v>220</c:v>
                </c:pt>
                <c:pt idx="324">
                  <c:v>219</c:v>
                </c:pt>
                <c:pt idx="325">
                  <c:v>219</c:v>
                </c:pt>
                <c:pt idx="326">
                  <c:v>219</c:v>
                </c:pt>
                <c:pt idx="327">
                  <c:v>217</c:v>
                </c:pt>
                <c:pt idx="328">
                  <c:v>216</c:v>
                </c:pt>
                <c:pt idx="329">
                  <c:v>215</c:v>
                </c:pt>
                <c:pt idx="330">
                  <c:v>215</c:v>
                </c:pt>
                <c:pt idx="331">
                  <c:v>214</c:v>
                </c:pt>
                <c:pt idx="332">
                  <c:v>213</c:v>
                </c:pt>
                <c:pt idx="333">
                  <c:v>213</c:v>
                </c:pt>
                <c:pt idx="334">
                  <c:v>211</c:v>
                </c:pt>
                <c:pt idx="335">
                  <c:v>211</c:v>
                </c:pt>
                <c:pt idx="336">
                  <c:v>210</c:v>
                </c:pt>
                <c:pt idx="337">
                  <c:v>210</c:v>
                </c:pt>
                <c:pt idx="338">
                  <c:v>210</c:v>
                </c:pt>
                <c:pt idx="339">
                  <c:v>209</c:v>
                </c:pt>
                <c:pt idx="340">
                  <c:v>207</c:v>
                </c:pt>
                <c:pt idx="341">
                  <c:v>207</c:v>
                </c:pt>
                <c:pt idx="342">
                  <c:v>206</c:v>
                </c:pt>
                <c:pt idx="343">
                  <c:v>205</c:v>
                </c:pt>
                <c:pt idx="344">
                  <c:v>204</c:v>
                </c:pt>
                <c:pt idx="345">
                  <c:v>203</c:v>
                </c:pt>
                <c:pt idx="346">
                  <c:v>202</c:v>
                </c:pt>
                <c:pt idx="347">
                  <c:v>202</c:v>
                </c:pt>
                <c:pt idx="348">
                  <c:v>201</c:v>
                </c:pt>
                <c:pt idx="349">
                  <c:v>199</c:v>
                </c:pt>
                <c:pt idx="350">
                  <c:v>198</c:v>
                </c:pt>
                <c:pt idx="351">
                  <c:v>197</c:v>
                </c:pt>
                <c:pt idx="352">
                  <c:v>197</c:v>
                </c:pt>
                <c:pt idx="353">
                  <c:v>197</c:v>
                </c:pt>
                <c:pt idx="354">
                  <c:v>197</c:v>
                </c:pt>
                <c:pt idx="355">
                  <c:v>197</c:v>
                </c:pt>
                <c:pt idx="356">
                  <c:v>196</c:v>
                </c:pt>
                <c:pt idx="357">
                  <c:v>196</c:v>
                </c:pt>
                <c:pt idx="358">
                  <c:v>195</c:v>
                </c:pt>
                <c:pt idx="359">
                  <c:v>195</c:v>
                </c:pt>
                <c:pt idx="360">
                  <c:v>194</c:v>
                </c:pt>
                <c:pt idx="361">
                  <c:v>194</c:v>
                </c:pt>
                <c:pt idx="362">
                  <c:v>193</c:v>
                </c:pt>
                <c:pt idx="363">
                  <c:v>192</c:v>
                </c:pt>
                <c:pt idx="364">
                  <c:v>192</c:v>
                </c:pt>
                <c:pt idx="365">
                  <c:v>191</c:v>
                </c:pt>
                <c:pt idx="366">
                  <c:v>191</c:v>
                </c:pt>
                <c:pt idx="367">
                  <c:v>191</c:v>
                </c:pt>
                <c:pt idx="368">
                  <c:v>190</c:v>
                </c:pt>
                <c:pt idx="369">
                  <c:v>190</c:v>
                </c:pt>
                <c:pt idx="370">
                  <c:v>189</c:v>
                </c:pt>
                <c:pt idx="371">
                  <c:v>188</c:v>
                </c:pt>
                <c:pt idx="372">
                  <c:v>188</c:v>
                </c:pt>
                <c:pt idx="373">
                  <c:v>188</c:v>
                </c:pt>
                <c:pt idx="374">
                  <c:v>186</c:v>
                </c:pt>
                <c:pt idx="375">
                  <c:v>185</c:v>
                </c:pt>
                <c:pt idx="376">
                  <c:v>185</c:v>
                </c:pt>
                <c:pt idx="377">
                  <c:v>185</c:v>
                </c:pt>
                <c:pt idx="378">
                  <c:v>184</c:v>
                </c:pt>
                <c:pt idx="379">
                  <c:v>183</c:v>
                </c:pt>
                <c:pt idx="380">
                  <c:v>183</c:v>
                </c:pt>
                <c:pt idx="381">
                  <c:v>182</c:v>
                </c:pt>
                <c:pt idx="382">
                  <c:v>181</c:v>
                </c:pt>
                <c:pt idx="383">
                  <c:v>179</c:v>
                </c:pt>
                <c:pt idx="384">
                  <c:v>179</c:v>
                </c:pt>
                <c:pt idx="385">
                  <c:v>178</c:v>
                </c:pt>
                <c:pt idx="386">
                  <c:v>178</c:v>
                </c:pt>
                <c:pt idx="387">
                  <c:v>178</c:v>
                </c:pt>
                <c:pt idx="388">
                  <c:v>177</c:v>
                </c:pt>
                <c:pt idx="389">
                  <c:v>176</c:v>
                </c:pt>
                <c:pt idx="390">
                  <c:v>175</c:v>
                </c:pt>
                <c:pt idx="391">
                  <c:v>174</c:v>
                </c:pt>
                <c:pt idx="392">
                  <c:v>172</c:v>
                </c:pt>
                <c:pt idx="393">
                  <c:v>171</c:v>
                </c:pt>
                <c:pt idx="394">
                  <c:v>166</c:v>
                </c:pt>
                <c:pt idx="395">
                  <c:v>166</c:v>
                </c:pt>
                <c:pt idx="396">
                  <c:v>165</c:v>
                </c:pt>
                <c:pt idx="397">
                  <c:v>165</c:v>
                </c:pt>
                <c:pt idx="398">
                  <c:v>164</c:v>
                </c:pt>
                <c:pt idx="399">
                  <c:v>163</c:v>
                </c:pt>
                <c:pt idx="400">
                  <c:v>163</c:v>
                </c:pt>
                <c:pt idx="401">
                  <c:v>163</c:v>
                </c:pt>
                <c:pt idx="402">
                  <c:v>163</c:v>
                </c:pt>
                <c:pt idx="403">
                  <c:v>163</c:v>
                </c:pt>
                <c:pt idx="404">
                  <c:v>161</c:v>
                </c:pt>
                <c:pt idx="405">
                  <c:v>161</c:v>
                </c:pt>
                <c:pt idx="406">
                  <c:v>157</c:v>
                </c:pt>
                <c:pt idx="407">
                  <c:v>156</c:v>
                </c:pt>
                <c:pt idx="408">
                  <c:v>156</c:v>
                </c:pt>
                <c:pt idx="409">
                  <c:v>155</c:v>
                </c:pt>
                <c:pt idx="410">
                  <c:v>154</c:v>
                </c:pt>
                <c:pt idx="411">
                  <c:v>154</c:v>
                </c:pt>
                <c:pt idx="412">
                  <c:v>153</c:v>
                </c:pt>
                <c:pt idx="413">
                  <c:v>152</c:v>
                </c:pt>
                <c:pt idx="414">
                  <c:v>152</c:v>
                </c:pt>
                <c:pt idx="415">
                  <c:v>152</c:v>
                </c:pt>
                <c:pt idx="416">
                  <c:v>150</c:v>
                </c:pt>
                <c:pt idx="417">
                  <c:v>150</c:v>
                </c:pt>
                <c:pt idx="418">
                  <c:v>149</c:v>
                </c:pt>
                <c:pt idx="419">
                  <c:v>147</c:v>
                </c:pt>
                <c:pt idx="420">
                  <c:v>145</c:v>
                </c:pt>
                <c:pt idx="421">
                  <c:v>144</c:v>
                </c:pt>
                <c:pt idx="422">
                  <c:v>144</c:v>
                </c:pt>
                <c:pt idx="423">
                  <c:v>143</c:v>
                </c:pt>
                <c:pt idx="424">
                  <c:v>142</c:v>
                </c:pt>
                <c:pt idx="425">
                  <c:v>139</c:v>
                </c:pt>
                <c:pt idx="426">
                  <c:v>138</c:v>
                </c:pt>
                <c:pt idx="427">
                  <c:v>138</c:v>
                </c:pt>
                <c:pt idx="428">
                  <c:v>137</c:v>
                </c:pt>
                <c:pt idx="429">
                  <c:v>136</c:v>
                </c:pt>
                <c:pt idx="430">
                  <c:v>136</c:v>
                </c:pt>
                <c:pt idx="431">
                  <c:v>136</c:v>
                </c:pt>
                <c:pt idx="432">
                  <c:v>135</c:v>
                </c:pt>
                <c:pt idx="433">
                  <c:v>134</c:v>
                </c:pt>
                <c:pt idx="434">
                  <c:v>133</c:v>
                </c:pt>
                <c:pt idx="435">
                  <c:v>133</c:v>
                </c:pt>
                <c:pt idx="436">
                  <c:v>130</c:v>
                </c:pt>
                <c:pt idx="437">
                  <c:v>130</c:v>
                </c:pt>
                <c:pt idx="438">
                  <c:v>130</c:v>
                </c:pt>
                <c:pt idx="439">
                  <c:v>126</c:v>
                </c:pt>
                <c:pt idx="440">
                  <c:v>125</c:v>
                </c:pt>
                <c:pt idx="441">
                  <c:v>125</c:v>
                </c:pt>
                <c:pt idx="442">
                  <c:v>124</c:v>
                </c:pt>
                <c:pt idx="443">
                  <c:v>120</c:v>
                </c:pt>
                <c:pt idx="444">
                  <c:v>120</c:v>
                </c:pt>
                <c:pt idx="445">
                  <c:v>119</c:v>
                </c:pt>
                <c:pt idx="446">
                  <c:v>116</c:v>
                </c:pt>
                <c:pt idx="447">
                  <c:v>115</c:v>
                </c:pt>
                <c:pt idx="448">
                  <c:v>113</c:v>
                </c:pt>
                <c:pt idx="449">
                  <c:v>112</c:v>
                </c:pt>
                <c:pt idx="450">
                  <c:v>111</c:v>
                </c:pt>
                <c:pt idx="451">
                  <c:v>111</c:v>
                </c:pt>
                <c:pt idx="452">
                  <c:v>110</c:v>
                </c:pt>
                <c:pt idx="453">
                  <c:v>108</c:v>
                </c:pt>
                <c:pt idx="454">
                  <c:v>108</c:v>
                </c:pt>
                <c:pt idx="455">
                  <c:v>107</c:v>
                </c:pt>
                <c:pt idx="456">
                  <c:v>107</c:v>
                </c:pt>
                <c:pt idx="457">
                  <c:v>106</c:v>
                </c:pt>
                <c:pt idx="458">
                  <c:v>105</c:v>
                </c:pt>
                <c:pt idx="459">
                  <c:v>102</c:v>
                </c:pt>
                <c:pt idx="460">
                  <c:v>102</c:v>
                </c:pt>
                <c:pt idx="461">
                  <c:v>98</c:v>
                </c:pt>
                <c:pt idx="462">
                  <c:v>97</c:v>
                </c:pt>
                <c:pt idx="463">
                  <c:v>96</c:v>
                </c:pt>
                <c:pt idx="464">
                  <c:v>89</c:v>
                </c:pt>
                <c:pt idx="465">
                  <c:v>88</c:v>
                </c:pt>
                <c:pt idx="466">
                  <c:v>87</c:v>
                </c:pt>
                <c:pt idx="467">
                  <c:v>86</c:v>
                </c:pt>
                <c:pt idx="468">
                  <c:v>85</c:v>
                </c:pt>
                <c:pt idx="469">
                  <c:v>84</c:v>
                </c:pt>
                <c:pt idx="470">
                  <c:v>73</c:v>
                </c:pt>
                <c:pt idx="471">
                  <c:v>66</c:v>
                </c:pt>
                <c:pt idx="472">
                  <c:v>65</c:v>
                </c:pt>
                <c:pt idx="473">
                  <c:v>61</c:v>
                </c:pt>
                <c:pt idx="474">
                  <c:v>59</c:v>
                </c:pt>
                <c:pt idx="475">
                  <c:v>48</c:v>
                </c:pt>
                <c:pt idx="476">
                  <c:v>42</c:v>
                </c:pt>
                <c:pt idx="477">
                  <c:v>34</c:v>
                </c:pt>
                <c:pt idx="478">
                  <c:v>26</c:v>
                </c:pt>
                <c:pt idx="479">
                  <c:v>26</c:v>
                </c:pt>
                <c:pt idx="480">
                  <c:v>19</c:v>
                </c:pt>
                <c:pt idx="481">
                  <c:v>10</c:v>
                </c:pt>
                <c:pt idx="482">
                  <c:v>7</c:v>
                </c:pt>
                <c:pt idx="483">
                  <c:v>5</c:v>
                </c:pt>
                <c:pt idx="484">
                  <c:v>0</c:v>
                </c:pt>
              </c:numCache>
            </c:numRef>
          </c:xVal>
          <c:yVal>
            <c:numRef>
              <c:f>Sheet1!$B$2:$B$486</c:f>
              <c:numCache>
                <c:formatCode>General</c:formatCode>
                <c:ptCount val="485"/>
                <c:pt idx="0">
                  <c:v>271</c:v>
                </c:pt>
                <c:pt idx="1">
                  <c:v>450</c:v>
                </c:pt>
                <c:pt idx="2">
                  <c:v>185</c:v>
                </c:pt>
                <c:pt idx="3">
                  <c:v>426</c:v>
                </c:pt>
                <c:pt idx="4">
                  <c:v>525</c:v>
                </c:pt>
                <c:pt idx="5">
                  <c:v>443</c:v>
                </c:pt>
                <c:pt idx="6">
                  <c:v>321</c:v>
                </c:pt>
                <c:pt idx="7">
                  <c:v>309</c:v>
                </c:pt>
                <c:pt idx="8">
                  <c:v>492</c:v>
                </c:pt>
                <c:pt idx="9">
                  <c:v>347</c:v>
                </c:pt>
                <c:pt idx="10">
                  <c:v>440</c:v>
                </c:pt>
                <c:pt idx="11">
                  <c:v>334</c:v>
                </c:pt>
                <c:pt idx="12">
                  <c:v>263</c:v>
                </c:pt>
                <c:pt idx="13">
                  <c:v>334</c:v>
                </c:pt>
                <c:pt idx="14">
                  <c:v>296</c:v>
                </c:pt>
                <c:pt idx="15">
                  <c:v>237</c:v>
                </c:pt>
                <c:pt idx="16">
                  <c:v>254</c:v>
                </c:pt>
                <c:pt idx="17">
                  <c:v>348</c:v>
                </c:pt>
                <c:pt idx="18">
                  <c:v>304</c:v>
                </c:pt>
                <c:pt idx="19">
                  <c:v>259</c:v>
                </c:pt>
                <c:pt idx="20">
                  <c:v>242</c:v>
                </c:pt>
                <c:pt idx="21">
                  <c:v>263</c:v>
                </c:pt>
                <c:pt idx="22">
                  <c:v>206</c:v>
                </c:pt>
                <c:pt idx="23">
                  <c:v>244</c:v>
                </c:pt>
                <c:pt idx="24">
                  <c:v>194</c:v>
                </c:pt>
                <c:pt idx="25">
                  <c:v>173</c:v>
                </c:pt>
                <c:pt idx="26">
                  <c:v>154</c:v>
                </c:pt>
                <c:pt idx="27">
                  <c:v>250</c:v>
                </c:pt>
                <c:pt idx="28">
                  <c:v>165</c:v>
                </c:pt>
                <c:pt idx="29">
                  <c:v>212</c:v>
                </c:pt>
                <c:pt idx="30">
                  <c:v>188</c:v>
                </c:pt>
                <c:pt idx="31">
                  <c:v>167</c:v>
                </c:pt>
                <c:pt idx="32">
                  <c:v>219</c:v>
                </c:pt>
                <c:pt idx="33">
                  <c:v>267</c:v>
                </c:pt>
                <c:pt idx="34">
                  <c:v>165</c:v>
                </c:pt>
                <c:pt idx="35">
                  <c:v>190</c:v>
                </c:pt>
                <c:pt idx="36">
                  <c:v>198</c:v>
                </c:pt>
                <c:pt idx="37">
                  <c:v>155</c:v>
                </c:pt>
                <c:pt idx="38">
                  <c:v>184</c:v>
                </c:pt>
                <c:pt idx="39">
                  <c:v>102</c:v>
                </c:pt>
                <c:pt idx="40">
                  <c:v>161</c:v>
                </c:pt>
                <c:pt idx="41">
                  <c:v>230</c:v>
                </c:pt>
                <c:pt idx="42">
                  <c:v>192</c:v>
                </c:pt>
                <c:pt idx="43">
                  <c:v>138</c:v>
                </c:pt>
                <c:pt idx="44">
                  <c:v>208</c:v>
                </c:pt>
                <c:pt idx="45">
                  <c:v>216</c:v>
                </c:pt>
                <c:pt idx="46">
                  <c:v>186</c:v>
                </c:pt>
                <c:pt idx="47">
                  <c:v>205</c:v>
                </c:pt>
                <c:pt idx="48">
                  <c:v>193</c:v>
                </c:pt>
                <c:pt idx="49">
                  <c:v>212</c:v>
                </c:pt>
                <c:pt idx="50">
                  <c:v>187</c:v>
                </c:pt>
                <c:pt idx="51">
                  <c:v>197</c:v>
                </c:pt>
                <c:pt idx="52">
                  <c:v>248</c:v>
                </c:pt>
                <c:pt idx="53">
                  <c:v>170</c:v>
                </c:pt>
                <c:pt idx="54">
                  <c:v>172</c:v>
                </c:pt>
                <c:pt idx="55">
                  <c:v>178</c:v>
                </c:pt>
                <c:pt idx="56">
                  <c:v>131</c:v>
                </c:pt>
                <c:pt idx="57">
                  <c:v>149</c:v>
                </c:pt>
                <c:pt idx="58">
                  <c:v>265</c:v>
                </c:pt>
                <c:pt idx="59">
                  <c:v>178</c:v>
                </c:pt>
                <c:pt idx="60">
                  <c:v>158</c:v>
                </c:pt>
                <c:pt idx="61">
                  <c:v>159</c:v>
                </c:pt>
                <c:pt idx="62">
                  <c:v>92</c:v>
                </c:pt>
                <c:pt idx="63">
                  <c:v>120</c:v>
                </c:pt>
                <c:pt idx="64">
                  <c:v>174</c:v>
                </c:pt>
                <c:pt idx="65">
                  <c:v>210</c:v>
                </c:pt>
                <c:pt idx="66">
                  <c:v>154</c:v>
                </c:pt>
                <c:pt idx="67">
                  <c:v>124</c:v>
                </c:pt>
                <c:pt idx="68">
                  <c:v>164</c:v>
                </c:pt>
                <c:pt idx="69">
                  <c:v>160</c:v>
                </c:pt>
                <c:pt idx="70">
                  <c:v>137</c:v>
                </c:pt>
                <c:pt idx="71">
                  <c:v>110</c:v>
                </c:pt>
                <c:pt idx="72">
                  <c:v>132</c:v>
                </c:pt>
                <c:pt idx="73">
                  <c:v>179</c:v>
                </c:pt>
                <c:pt idx="74">
                  <c:v>131</c:v>
                </c:pt>
                <c:pt idx="75">
                  <c:v>157</c:v>
                </c:pt>
                <c:pt idx="76">
                  <c:v>165</c:v>
                </c:pt>
                <c:pt idx="77">
                  <c:v>108</c:v>
                </c:pt>
                <c:pt idx="78">
                  <c:v>149</c:v>
                </c:pt>
                <c:pt idx="79">
                  <c:v>107</c:v>
                </c:pt>
                <c:pt idx="80">
                  <c:v>166</c:v>
                </c:pt>
                <c:pt idx="81">
                  <c:v>156</c:v>
                </c:pt>
                <c:pt idx="82">
                  <c:v>105</c:v>
                </c:pt>
                <c:pt idx="83">
                  <c:v>125</c:v>
                </c:pt>
                <c:pt idx="84">
                  <c:v>136</c:v>
                </c:pt>
                <c:pt idx="85">
                  <c:v>134</c:v>
                </c:pt>
                <c:pt idx="86">
                  <c:v>136</c:v>
                </c:pt>
                <c:pt idx="87">
                  <c:v>114</c:v>
                </c:pt>
                <c:pt idx="88">
                  <c:v>141</c:v>
                </c:pt>
                <c:pt idx="89">
                  <c:v>164</c:v>
                </c:pt>
                <c:pt idx="90">
                  <c:v>135</c:v>
                </c:pt>
                <c:pt idx="91">
                  <c:v>146</c:v>
                </c:pt>
                <c:pt idx="92">
                  <c:v>135</c:v>
                </c:pt>
                <c:pt idx="93">
                  <c:v>116</c:v>
                </c:pt>
                <c:pt idx="94">
                  <c:v>177</c:v>
                </c:pt>
                <c:pt idx="95">
                  <c:v>149</c:v>
                </c:pt>
                <c:pt idx="96">
                  <c:v>131</c:v>
                </c:pt>
                <c:pt idx="97">
                  <c:v>136</c:v>
                </c:pt>
                <c:pt idx="98">
                  <c:v>120</c:v>
                </c:pt>
                <c:pt idx="99">
                  <c:v>173</c:v>
                </c:pt>
                <c:pt idx="100">
                  <c:v>119</c:v>
                </c:pt>
                <c:pt idx="101">
                  <c:v>179</c:v>
                </c:pt>
                <c:pt idx="102">
                  <c:v>106</c:v>
                </c:pt>
                <c:pt idx="103">
                  <c:v>142</c:v>
                </c:pt>
                <c:pt idx="104">
                  <c:v>149</c:v>
                </c:pt>
                <c:pt idx="105">
                  <c:v>160</c:v>
                </c:pt>
                <c:pt idx="106">
                  <c:v>129</c:v>
                </c:pt>
                <c:pt idx="107">
                  <c:v>134</c:v>
                </c:pt>
                <c:pt idx="108">
                  <c:v>160</c:v>
                </c:pt>
                <c:pt idx="109">
                  <c:v>150</c:v>
                </c:pt>
                <c:pt idx="110">
                  <c:v>76</c:v>
                </c:pt>
                <c:pt idx="111">
                  <c:v>117</c:v>
                </c:pt>
                <c:pt idx="112">
                  <c:v>118</c:v>
                </c:pt>
                <c:pt idx="113">
                  <c:v>154</c:v>
                </c:pt>
                <c:pt idx="114">
                  <c:v>133</c:v>
                </c:pt>
                <c:pt idx="115">
                  <c:v>183</c:v>
                </c:pt>
                <c:pt idx="116">
                  <c:v>62</c:v>
                </c:pt>
                <c:pt idx="117">
                  <c:v>159</c:v>
                </c:pt>
                <c:pt idx="118">
                  <c:v>112</c:v>
                </c:pt>
                <c:pt idx="119">
                  <c:v>149</c:v>
                </c:pt>
                <c:pt idx="120">
                  <c:v>131</c:v>
                </c:pt>
                <c:pt idx="121">
                  <c:v>134</c:v>
                </c:pt>
                <c:pt idx="122">
                  <c:v>137</c:v>
                </c:pt>
                <c:pt idx="123">
                  <c:v>122</c:v>
                </c:pt>
                <c:pt idx="124">
                  <c:v>115</c:v>
                </c:pt>
                <c:pt idx="125">
                  <c:v>127</c:v>
                </c:pt>
                <c:pt idx="126">
                  <c:v>66</c:v>
                </c:pt>
                <c:pt idx="127">
                  <c:v>116</c:v>
                </c:pt>
                <c:pt idx="128">
                  <c:v>136</c:v>
                </c:pt>
                <c:pt idx="129">
                  <c:v>131</c:v>
                </c:pt>
                <c:pt idx="130">
                  <c:v>144</c:v>
                </c:pt>
                <c:pt idx="131">
                  <c:v>114</c:v>
                </c:pt>
                <c:pt idx="132">
                  <c:v>116</c:v>
                </c:pt>
                <c:pt idx="133">
                  <c:v>110</c:v>
                </c:pt>
                <c:pt idx="134">
                  <c:v>122</c:v>
                </c:pt>
                <c:pt idx="135">
                  <c:v>137</c:v>
                </c:pt>
                <c:pt idx="136">
                  <c:v>120</c:v>
                </c:pt>
                <c:pt idx="137">
                  <c:v>103</c:v>
                </c:pt>
                <c:pt idx="138">
                  <c:v>132</c:v>
                </c:pt>
                <c:pt idx="139">
                  <c:v>137</c:v>
                </c:pt>
                <c:pt idx="140">
                  <c:v>133</c:v>
                </c:pt>
                <c:pt idx="141">
                  <c:v>107</c:v>
                </c:pt>
                <c:pt idx="142">
                  <c:v>106</c:v>
                </c:pt>
                <c:pt idx="143">
                  <c:v>117</c:v>
                </c:pt>
                <c:pt idx="144">
                  <c:v>144</c:v>
                </c:pt>
                <c:pt idx="145">
                  <c:v>100</c:v>
                </c:pt>
                <c:pt idx="146">
                  <c:v>134</c:v>
                </c:pt>
                <c:pt idx="147">
                  <c:v>128</c:v>
                </c:pt>
                <c:pt idx="148">
                  <c:v>131</c:v>
                </c:pt>
                <c:pt idx="149">
                  <c:v>138</c:v>
                </c:pt>
                <c:pt idx="150">
                  <c:v>125</c:v>
                </c:pt>
                <c:pt idx="151">
                  <c:v>123</c:v>
                </c:pt>
                <c:pt idx="152">
                  <c:v>145</c:v>
                </c:pt>
                <c:pt idx="153">
                  <c:v>99</c:v>
                </c:pt>
                <c:pt idx="154">
                  <c:v>135</c:v>
                </c:pt>
                <c:pt idx="155">
                  <c:v>114</c:v>
                </c:pt>
                <c:pt idx="156">
                  <c:v>102</c:v>
                </c:pt>
                <c:pt idx="157">
                  <c:v>155</c:v>
                </c:pt>
                <c:pt idx="158">
                  <c:v>166</c:v>
                </c:pt>
                <c:pt idx="159">
                  <c:v>74</c:v>
                </c:pt>
                <c:pt idx="160">
                  <c:v>116</c:v>
                </c:pt>
                <c:pt idx="161">
                  <c:v>106</c:v>
                </c:pt>
                <c:pt idx="162">
                  <c:v>130</c:v>
                </c:pt>
                <c:pt idx="163">
                  <c:v>106</c:v>
                </c:pt>
                <c:pt idx="164">
                  <c:v>93</c:v>
                </c:pt>
                <c:pt idx="165">
                  <c:v>138</c:v>
                </c:pt>
                <c:pt idx="166">
                  <c:v>116</c:v>
                </c:pt>
                <c:pt idx="167">
                  <c:v>115</c:v>
                </c:pt>
                <c:pt idx="168">
                  <c:v>124</c:v>
                </c:pt>
                <c:pt idx="169">
                  <c:v>114</c:v>
                </c:pt>
                <c:pt idx="170">
                  <c:v>98</c:v>
                </c:pt>
                <c:pt idx="171">
                  <c:v>108</c:v>
                </c:pt>
                <c:pt idx="172">
                  <c:v>124</c:v>
                </c:pt>
                <c:pt idx="173">
                  <c:v>133</c:v>
                </c:pt>
                <c:pt idx="174">
                  <c:v>137</c:v>
                </c:pt>
                <c:pt idx="175">
                  <c:v>117</c:v>
                </c:pt>
                <c:pt idx="176">
                  <c:v>136</c:v>
                </c:pt>
                <c:pt idx="177">
                  <c:v>179</c:v>
                </c:pt>
                <c:pt idx="178">
                  <c:v>89</c:v>
                </c:pt>
                <c:pt idx="179">
                  <c:v>91</c:v>
                </c:pt>
                <c:pt idx="180">
                  <c:v>122</c:v>
                </c:pt>
                <c:pt idx="181">
                  <c:v>114</c:v>
                </c:pt>
                <c:pt idx="182">
                  <c:v>116</c:v>
                </c:pt>
                <c:pt idx="183">
                  <c:v>48</c:v>
                </c:pt>
                <c:pt idx="184">
                  <c:v>94</c:v>
                </c:pt>
                <c:pt idx="185">
                  <c:v>101</c:v>
                </c:pt>
                <c:pt idx="186">
                  <c:v>103</c:v>
                </c:pt>
                <c:pt idx="187">
                  <c:v>137</c:v>
                </c:pt>
                <c:pt idx="188">
                  <c:v>65</c:v>
                </c:pt>
                <c:pt idx="189">
                  <c:v>63</c:v>
                </c:pt>
                <c:pt idx="190">
                  <c:v>95</c:v>
                </c:pt>
                <c:pt idx="191">
                  <c:v>107</c:v>
                </c:pt>
                <c:pt idx="192">
                  <c:v>79</c:v>
                </c:pt>
                <c:pt idx="193">
                  <c:v>92</c:v>
                </c:pt>
                <c:pt idx="194">
                  <c:v>111</c:v>
                </c:pt>
                <c:pt idx="195">
                  <c:v>179</c:v>
                </c:pt>
                <c:pt idx="196">
                  <c:v>110</c:v>
                </c:pt>
                <c:pt idx="197">
                  <c:v>111</c:v>
                </c:pt>
                <c:pt idx="198">
                  <c:v>148</c:v>
                </c:pt>
                <c:pt idx="199">
                  <c:v>109</c:v>
                </c:pt>
                <c:pt idx="200">
                  <c:v>102</c:v>
                </c:pt>
                <c:pt idx="201">
                  <c:v>60</c:v>
                </c:pt>
                <c:pt idx="202">
                  <c:v>79</c:v>
                </c:pt>
                <c:pt idx="203">
                  <c:v>145</c:v>
                </c:pt>
                <c:pt idx="204">
                  <c:v>96</c:v>
                </c:pt>
                <c:pt idx="205">
                  <c:v>149</c:v>
                </c:pt>
                <c:pt idx="206">
                  <c:v>81</c:v>
                </c:pt>
                <c:pt idx="207">
                  <c:v>124</c:v>
                </c:pt>
                <c:pt idx="208">
                  <c:v>97</c:v>
                </c:pt>
                <c:pt idx="209">
                  <c:v>115</c:v>
                </c:pt>
                <c:pt idx="210">
                  <c:v>89</c:v>
                </c:pt>
                <c:pt idx="211">
                  <c:v>102</c:v>
                </c:pt>
                <c:pt idx="212">
                  <c:v>71</c:v>
                </c:pt>
                <c:pt idx="213">
                  <c:v>107</c:v>
                </c:pt>
                <c:pt idx="214">
                  <c:v>70</c:v>
                </c:pt>
                <c:pt idx="215">
                  <c:v>113</c:v>
                </c:pt>
                <c:pt idx="216">
                  <c:v>102</c:v>
                </c:pt>
                <c:pt idx="217">
                  <c:v>101</c:v>
                </c:pt>
                <c:pt idx="218">
                  <c:v>100</c:v>
                </c:pt>
                <c:pt idx="219">
                  <c:v>109</c:v>
                </c:pt>
                <c:pt idx="220">
                  <c:v>133</c:v>
                </c:pt>
                <c:pt idx="221">
                  <c:v>122</c:v>
                </c:pt>
                <c:pt idx="222">
                  <c:v>59</c:v>
                </c:pt>
                <c:pt idx="223">
                  <c:v>97</c:v>
                </c:pt>
                <c:pt idx="224">
                  <c:v>140</c:v>
                </c:pt>
                <c:pt idx="225">
                  <c:v>106</c:v>
                </c:pt>
                <c:pt idx="226">
                  <c:v>66</c:v>
                </c:pt>
                <c:pt idx="227">
                  <c:v>76</c:v>
                </c:pt>
                <c:pt idx="228">
                  <c:v>99</c:v>
                </c:pt>
                <c:pt idx="229">
                  <c:v>89</c:v>
                </c:pt>
                <c:pt idx="230">
                  <c:v>97</c:v>
                </c:pt>
                <c:pt idx="231">
                  <c:v>128</c:v>
                </c:pt>
                <c:pt idx="232">
                  <c:v>112</c:v>
                </c:pt>
                <c:pt idx="233">
                  <c:v>86</c:v>
                </c:pt>
                <c:pt idx="234">
                  <c:v>137</c:v>
                </c:pt>
                <c:pt idx="235">
                  <c:v>103</c:v>
                </c:pt>
                <c:pt idx="236">
                  <c:v>95</c:v>
                </c:pt>
                <c:pt idx="237">
                  <c:v>86</c:v>
                </c:pt>
                <c:pt idx="238">
                  <c:v>96</c:v>
                </c:pt>
                <c:pt idx="239">
                  <c:v>110</c:v>
                </c:pt>
                <c:pt idx="240">
                  <c:v>69</c:v>
                </c:pt>
                <c:pt idx="241">
                  <c:v>93</c:v>
                </c:pt>
                <c:pt idx="242">
                  <c:v>76</c:v>
                </c:pt>
                <c:pt idx="243">
                  <c:v>117</c:v>
                </c:pt>
                <c:pt idx="244">
                  <c:v>90</c:v>
                </c:pt>
                <c:pt idx="245">
                  <c:v>73</c:v>
                </c:pt>
                <c:pt idx="246">
                  <c:v>89</c:v>
                </c:pt>
                <c:pt idx="247">
                  <c:v>57</c:v>
                </c:pt>
                <c:pt idx="248">
                  <c:v>41</c:v>
                </c:pt>
                <c:pt idx="249">
                  <c:v>54</c:v>
                </c:pt>
                <c:pt idx="250">
                  <c:v>94</c:v>
                </c:pt>
                <c:pt idx="251">
                  <c:v>95</c:v>
                </c:pt>
                <c:pt idx="252">
                  <c:v>78</c:v>
                </c:pt>
                <c:pt idx="253">
                  <c:v>88</c:v>
                </c:pt>
                <c:pt idx="254">
                  <c:v>82</c:v>
                </c:pt>
                <c:pt idx="255">
                  <c:v>84</c:v>
                </c:pt>
                <c:pt idx="256">
                  <c:v>78</c:v>
                </c:pt>
                <c:pt idx="257">
                  <c:v>102</c:v>
                </c:pt>
                <c:pt idx="258">
                  <c:v>114</c:v>
                </c:pt>
                <c:pt idx="259">
                  <c:v>120</c:v>
                </c:pt>
                <c:pt idx="260">
                  <c:v>125</c:v>
                </c:pt>
                <c:pt idx="261">
                  <c:v>72</c:v>
                </c:pt>
                <c:pt idx="262">
                  <c:v>67</c:v>
                </c:pt>
                <c:pt idx="263">
                  <c:v>109</c:v>
                </c:pt>
                <c:pt idx="264">
                  <c:v>61</c:v>
                </c:pt>
                <c:pt idx="265">
                  <c:v>100</c:v>
                </c:pt>
                <c:pt idx="266">
                  <c:v>74</c:v>
                </c:pt>
                <c:pt idx="267">
                  <c:v>87</c:v>
                </c:pt>
                <c:pt idx="268">
                  <c:v>72</c:v>
                </c:pt>
                <c:pt idx="269">
                  <c:v>109</c:v>
                </c:pt>
                <c:pt idx="270">
                  <c:v>90</c:v>
                </c:pt>
                <c:pt idx="271">
                  <c:v>81</c:v>
                </c:pt>
                <c:pt idx="272">
                  <c:v>97</c:v>
                </c:pt>
                <c:pt idx="273">
                  <c:v>87</c:v>
                </c:pt>
                <c:pt idx="274">
                  <c:v>97</c:v>
                </c:pt>
                <c:pt idx="275">
                  <c:v>65</c:v>
                </c:pt>
                <c:pt idx="276">
                  <c:v>93</c:v>
                </c:pt>
                <c:pt idx="277">
                  <c:v>114</c:v>
                </c:pt>
                <c:pt idx="278">
                  <c:v>94</c:v>
                </c:pt>
                <c:pt idx="279">
                  <c:v>58</c:v>
                </c:pt>
                <c:pt idx="280">
                  <c:v>66</c:v>
                </c:pt>
                <c:pt idx="281">
                  <c:v>77</c:v>
                </c:pt>
                <c:pt idx="282">
                  <c:v>79</c:v>
                </c:pt>
                <c:pt idx="283">
                  <c:v>77</c:v>
                </c:pt>
                <c:pt idx="284">
                  <c:v>86</c:v>
                </c:pt>
                <c:pt idx="285">
                  <c:v>75</c:v>
                </c:pt>
                <c:pt idx="286">
                  <c:v>110</c:v>
                </c:pt>
                <c:pt idx="287">
                  <c:v>79</c:v>
                </c:pt>
                <c:pt idx="288">
                  <c:v>96</c:v>
                </c:pt>
                <c:pt idx="289">
                  <c:v>95</c:v>
                </c:pt>
                <c:pt idx="290">
                  <c:v>97</c:v>
                </c:pt>
                <c:pt idx="291">
                  <c:v>77</c:v>
                </c:pt>
                <c:pt idx="292">
                  <c:v>78</c:v>
                </c:pt>
                <c:pt idx="293">
                  <c:v>73</c:v>
                </c:pt>
                <c:pt idx="294">
                  <c:v>94</c:v>
                </c:pt>
                <c:pt idx="295">
                  <c:v>119</c:v>
                </c:pt>
                <c:pt idx="296">
                  <c:v>83</c:v>
                </c:pt>
                <c:pt idx="297">
                  <c:v>96</c:v>
                </c:pt>
                <c:pt idx="298">
                  <c:v>77</c:v>
                </c:pt>
                <c:pt idx="299">
                  <c:v>74</c:v>
                </c:pt>
                <c:pt idx="300">
                  <c:v>93</c:v>
                </c:pt>
                <c:pt idx="301">
                  <c:v>102</c:v>
                </c:pt>
                <c:pt idx="302">
                  <c:v>80</c:v>
                </c:pt>
                <c:pt idx="303">
                  <c:v>70</c:v>
                </c:pt>
                <c:pt idx="304">
                  <c:v>83</c:v>
                </c:pt>
                <c:pt idx="305">
                  <c:v>109</c:v>
                </c:pt>
                <c:pt idx="306">
                  <c:v>102</c:v>
                </c:pt>
                <c:pt idx="307">
                  <c:v>95</c:v>
                </c:pt>
                <c:pt idx="308">
                  <c:v>69</c:v>
                </c:pt>
                <c:pt idx="309">
                  <c:v>66</c:v>
                </c:pt>
                <c:pt idx="310">
                  <c:v>91</c:v>
                </c:pt>
                <c:pt idx="311">
                  <c:v>75</c:v>
                </c:pt>
                <c:pt idx="312">
                  <c:v>88</c:v>
                </c:pt>
                <c:pt idx="313">
                  <c:v>107</c:v>
                </c:pt>
                <c:pt idx="314">
                  <c:v>105</c:v>
                </c:pt>
                <c:pt idx="315">
                  <c:v>105</c:v>
                </c:pt>
                <c:pt idx="316">
                  <c:v>86</c:v>
                </c:pt>
                <c:pt idx="317">
                  <c:v>101</c:v>
                </c:pt>
                <c:pt idx="318">
                  <c:v>81</c:v>
                </c:pt>
                <c:pt idx="319">
                  <c:v>91</c:v>
                </c:pt>
                <c:pt idx="320">
                  <c:v>79</c:v>
                </c:pt>
                <c:pt idx="321">
                  <c:v>89</c:v>
                </c:pt>
                <c:pt idx="322">
                  <c:v>80</c:v>
                </c:pt>
                <c:pt idx="323">
                  <c:v>88</c:v>
                </c:pt>
                <c:pt idx="324">
                  <c:v>75</c:v>
                </c:pt>
                <c:pt idx="325">
                  <c:v>75</c:v>
                </c:pt>
                <c:pt idx="326">
                  <c:v>92</c:v>
                </c:pt>
                <c:pt idx="327">
                  <c:v>97</c:v>
                </c:pt>
                <c:pt idx="328">
                  <c:v>60</c:v>
                </c:pt>
                <c:pt idx="329">
                  <c:v>96</c:v>
                </c:pt>
                <c:pt idx="330">
                  <c:v>86</c:v>
                </c:pt>
                <c:pt idx="331">
                  <c:v>94</c:v>
                </c:pt>
                <c:pt idx="332">
                  <c:v>80</c:v>
                </c:pt>
                <c:pt idx="333">
                  <c:v>87</c:v>
                </c:pt>
                <c:pt idx="334">
                  <c:v>70</c:v>
                </c:pt>
                <c:pt idx="335">
                  <c:v>67</c:v>
                </c:pt>
                <c:pt idx="336">
                  <c:v>96</c:v>
                </c:pt>
                <c:pt idx="337">
                  <c:v>87</c:v>
                </c:pt>
                <c:pt idx="338">
                  <c:v>98</c:v>
                </c:pt>
                <c:pt idx="339">
                  <c:v>85</c:v>
                </c:pt>
                <c:pt idx="340">
                  <c:v>69</c:v>
                </c:pt>
                <c:pt idx="341">
                  <c:v>62</c:v>
                </c:pt>
                <c:pt idx="342">
                  <c:v>100</c:v>
                </c:pt>
                <c:pt idx="343">
                  <c:v>57</c:v>
                </c:pt>
                <c:pt idx="344">
                  <c:v>71</c:v>
                </c:pt>
                <c:pt idx="345">
                  <c:v>92</c:v>
                </c:pt>
                <c:pt idx="346">
                  <c:v>90</c:v>
                </c:pt>
                <c:pt idx="347">
                  <c:v>76</c:v>
                </c:pt>
                <c:pt idx="348">
                  <c:v>79</c:v>
                </c:pt>
                <c:pt idx="349">
                  <c:v>47</c:v>
                </c:pt>
                <c:pt idx="350">
                  <c:v>69</c:v>
                </c:pt>
                <c:pt idx="351">
                  <c:v>61</c:v>
                </c:pt>
                <c:pt idx="352">
                  <c:v>70</c:v>
                </c:pt>
                <c:pt idx="353">
                  <c:v>75</c:v>
                </c:pt>
                <c:pt idx="354">
                  <c:v>84</c:v>
                </c:pt>
                <c:pt idx="355">
                  <c:v>67</c:v>
                </c:pt>
                <c:pt idx="356">
                  <c:v>79</c:v>
                </c:pt>
                <c:pt idx="357">
                  <c:v>89</c:v>
                </c:pt>
                <c:pt idx="358">
                  <c:v>78</c:v>
                </c:pt>
                <c:pt idx="359">
                  <c:v>74</c:v>
                </c:pt>
                <c:pt idx="360">
                  <c:v>51</c:v>
                </c:pt>
                <c:pt idx="361">
                  <c:v>112</c:v>
                </c:pt>
                <c:pt idx="362">
                  <c:v>53</c:v>
                </c:pt>
                <c:pt idx="363">
                  <c:v>74</c:v>
                </c:pt>
                <c:pt idx="364">
                  <c:v>50</c:v>
                </c:pt>
                <c:pt idx="365">
                  <c:v>66</c:v>
                </c:pt>
                <c:pt idx="366">
                  <c:v>75</c:v>
                </c:pt>
                <c:pt idx="367">
                  <c:v>72</c:v>
                </c:pt>
                <c:pt idx="368">
                  <c:v>74</c:v>
                </c:pt>
                <c:pt idx="369">
                  <c:v>75</c:v>
                </c:pt>
                <c:pt idx="370">
                  <c:v>70</c:v>
                </c:pt>
                <c:pt idx="371">
                  <c:v>101</c:v>
                </c:pt>
                <c:pt idx="372">
                  <c:v>71</c:v>
                </c:pt>
                <c:pt idx="373">
                  <c:v>67</c:v>
                </c:pt>
                <c:pt idx="374">
                  <c:v>75</c:v>
                </c:pt>
                <c:pt idx="375">
                  <c:v>84</c:v>
                </c:pt>
                <c:pt idx="376">
                  <c:v>52</c:v>
                </c:pt>
                <c:pt idx="377">
                  <c:v>51</c:v>
                </c:pt>
                <c:pt idx="378">
                  <c:v>65</c:v>
                </c:pt>
                <c:pt idx="379">
                  <c:v>55</c:v>
                </c:pt>
                <c:pt idx="380">
                  <c:v>78</c:v>
                </c:pt>
                <c:pt idx="381">
                  <c:v>64</c:v>
                </c:pt>
                <c:pt idx="382">
                  <c:v>92</c:v>
                </c:pt>
                <c:pt idx="383">
                  <c:v>76</c:v>
                </c:pt>
                <c:pt idx="384">
                  <c:v>92</c:v>
                </c:pt>
                <c:pt idx="385">
                  <c:v>64</c:v>
                </c:pt>
                <c:pt idx="386">
                  <c:v>86</c:v>
                </c:pt>
                <c:pt idx="387">
                  <c:v>71</c:v>
                </c:pt>
                <c:pt idx="388">
                  <c:v>68</c:v>
                </c:pt>
                <c:pt idx="389">
                  <c:v>65</c:v>
                </c:pt>
                <c:pt idx="390">
                  <c:v>76</c:v>
                </c:pt>
                <c:pt idx="391">
                  <c:v>46</c:v>
                </c:pt>
                <c:pt idx="392">
                  <c:v>62</c:v>
                </c:pt>
                <c:pt idx="393">
                  <c:v>70</c:v>
                </c:pt>
                <c:pt idx="394">
                  <c:v>54</c:v>
                </c:pt>
                <c:pt idx="395">
                  <c:v>58</c:v>
                </c:pt>
                <c:pt idx="396">
                  <c:v>66</c:v>
                </c:pt>
                <c:pt idx="397">
                  <c:v>59</c:v>
                </c:pt>
                <c:pt idx="398">
                  <c:v>60</c:v>
                </c:pt>
                <c:pt idx="399">
                  <c:v>57</c:v>
                </c:pt>
                <c:pt idx="400">
                  <c:v>63</c:v>
                </c:pt>
                <c:pt idx="401">
                  <c:v>56</c:v>
                </c:pt>
                <c:pt idx="402">
                  <c:v>69</c:v>
                </c:pt>
                <c:pt idx="403">
                  <c:v>69</c:v>
                </c:pt>
                <c:pt idx="404">
                  <c:v>60</c:v>
                </c:pt>
                <c:pt idx="405">
                  <c:v>72</c:v>
                </c:pt>
                <c:pt idx="406">
                  <c:v>63</c:v>
                </c:pt>
                <c:pt idx="407">
                  <c:v>83</c:v>
                </c:pt>
                <c:pt idx="408">
                  <c:v>51</c:v>
                </c:pt>
                <c:pt idx="409">
                  <c:v>73</c:v>
                </c:pt>
                <c:pt idx="410">
                  <c:v>70</c:v>
                </c:pt>
                <c:pt idx="411">
                  <c:v>59</c:v>
                </c:pt>
                <c:pt idx="412">
                  <c:v>60</c:v>
                </c:pt>
                <c:pt idx="413">
                  <c:v>70</c:v>
                </c:pt>
                <c:pt idx="414">
                  <c:v>60</c:v>
                </c:pt>
                <c:pt idx="415">
                  <c:v>58</c:v>
                </c:pt>
                <c:pt idx="416">
                  <c:v>36</c:v>
                </c:pt>
                <c:pt idx="417">
                  <c:v>83</c:v>
                </c:pt>
                <c:pt idx="418">
                  <c:v>54</c:v>
                </c:pt>
                <c:pt idx="419">
                  <c:v>51</c:v>
                </c:pt>
                <c:pt idx="420">
                  <c:v>60</c:v>
                </c:pt>
                <c:pt idx="421">
                  <c:v>77</c:v>
                </c:pt>
                <c:pt idx="422">
                  <c:v>64</c:v>
                </c:pt>
                <c:pt idx="423">
                  <c:v>45</c:v>
                </c:pt>
                <c:pt idx="424">
                  <c:v>72</c:v>
                </c:pt>
                <c:pt idx="425">
                  <c:v>56</c:v>
                </c:pt>
                <c:pt idx="426">
                  <c:v>57</c:v>
                </c:pt>
                <c:pt idx="427">
                  <c:v>47</c:v>
                </c:pt>
                <c:pt idx="428">
                  <c:v>53</c:v>
                </c:pt>
                <c:pt idx="429">
                  <c:v>45</c:v>
                </c:pt>
                <c:pt idx="430">
                  <c:v>41</c:v>
                </c:pt>
                <c:pt idx="431">
                  <c:v>61</c:v>
                </c:pt>
                <c:pt idx="432">
                  <c:v>52</c:v>
                </c:pt>
                <c:pt idx="433">
                  <c:v>42</c:v>
                </c:pt>
                <c:pt idx="434">
                  <c:v>48</c:v>
                </c:pt>
                <c:pt idx="435">
                  <c:v>52</c:v>
                </c:pt>
                <c:pt idx="436">
                  <c:v>53</c:v>
                </c:pt>
                <c:pt idx="437">
                  <c:v>45</c:v>
                </c:pt>
                <c:pt idx="438">
                  <c:v>56</c:v>
                </c:pt>
                <c:pt idx="439">
                  <c:v>54</c:v>
                </c:pt>
                <c:pt idx="440">
                  <c:v>47</c:v>
                </c:pt>
                <c:pt idx="441">
                  <c:v>51</c:v>
                </c:pt>
                <c:pt idx="442">
                  <c:v>58</c:v>
                </c:pt>
                <c:pt idx="443">
                  <c:v>25</c:v>
                </c:pt>
                <c:pt idx="444">
                  <c:v>43</c:v>
                </c:pt>
                <c:pt idx="445">
                  <c:v>42</c:v>
                </c:pt>
                <c:pt idx="446">
                  <c:v>66</c:v>
                </c:pt>
                <c:pt idx="447">
                  <c:v>65</c:v>
                </c:pt>
                <c:pt idx="448">
                  <c:v>41</c:v>
                </c:pt>
                <c:pt idx="449">
                  <c:v>43</c:v>
                </c:pt>
                <c:pt idx="450">
                  <c:v>51</c:v>
                </c:pt>
                <c:pt idx="451">
                  <c:v>44</c:v>
                </c:pt>
                <c:pt idx="452">
                  <c:v>52</c:v>
                </c:pt>
                <c:pt idx="453">
                  <c:v>54</c:v>
                </c:pt>
                <c:pt idx="454">
                  <c:v>40</c:v>
                </c:pt>
                <c:pt idx="455">
                  <c:v>157</c:v>
                </c:pt>
                <c:pt idx="456">
                  <c:v>30</c:v>
                </c:pt>
                <c:pt idx="457">
                  <c:v>34</c:v>
                </c:pt>
                <c:pt idx="458">
                  <c:v>56</c:v>
                </c:pt>
                <c:pt idx="459">
                  <c:v>31</c:v>
                </c:pt>
                <c:pt idx="460">
                  <c:v>49</c:v>
                </c:pt>
                <c:pt idx="461">
                  <c:v>48</c:v>
                </c:pt>
                <c:pt idx="462">
                  <c:v>46</c:v>
                </c:pt>
                <c:pt idx="463">
                  <c:v>37</c:v>
                </c:pt>
                <c:pt idx="464">
                  <c:v>56</c:v>
                </c:pt>
                <c:pt idx="465">
                  <c:v>27</c:v>
                </c:pt>
                <c:pt idx="466">
                  <c:v>44</c:v>
                </c:pt>
                <c:pt idx="467">
                  <c:v>39</c:v>
                </c:pt>
                <c:pt idx="468">
                  <c:v>49</c:v>
                </c:pt>
                <c:pt idx="469">
                  <c:v>46</c:v>
                </c:pt>
                <c:pt idx="470">
                  <c:v>47</c:v>
                </c:pt>
                <c:pt idx="471">
                  <c:v>20</c:v>
                </c:pt>
                <c:pt idx="472">
                  <c:v>28</c:v>
                </c:pt>
                <c:pt idx="473">
                  <c:v>26</c:v>
                </c:pt>
                <c:pt idx="474">
                  <c:v>19</c:v>
                </c:pt>
                <c:pt idx="475">
                  <c:v>13</c:v>
                </c:pt>
                <c:pt idx="476">
                  <c:v>21</c:v>
                </c:pt>
                <c:pt idx="477">
                  <c:v>20</c:v>
                </c:pt>
                <c:pt idx="478">
                  <c:v>50</c:v>
                </c:pt>
                <c:pt idx="479">
                  <c:v>12</c:v>
                </c:pt>
                <c:pt idx="480">
                  <c:v>15</c:v>
                </c:pt>
                <c:pt idx="481">
                  <c:v>21</c:v>
                </c:pt>
                <c:pt idx="482">
                  <c:v>8</c:v>
                </c:pt>
                <c:pt idx="483">
                  <c:v>1</c:v>
                </c:pt>
                <c:pt idx="484">
                  <c:v>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49B-40D9-B44F-F0E994C4BE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4195888"/>
        <c:axId val="10146496"/>
      </c:scatterChart>
      <c:valAx>
        <c:axId val="2114195888"/>
        <c:scaling>
          <c:orientation val="minMax"/>
          <c:max val="15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0146496"/>
        <c:crosses val="autoZero"/>
        <c:crossBetween val="midCat"/>
      </c:valAx>
      <c:valAx>
        <c:axId val="10146496"/>
        <c:scaling>
          <c:orientation val="minMax"/>
          <c:max val="6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114195888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selective_expression_ratio!$A$2:$A$490</cx:f>
        <cx:lvl ptCount="489" formatCode="G/通用格式">
          <cx:pt idx="0">0.18471568272364999</cx:pt>
          <cx:pt idx="1">0.115547489413188</cx:pt>
          <cx:pt idx="2">0.194630872483221</cx:pt>
          <cx:pt idx="3">0.037128712871287099</cx:pt>
          <cx:pt idx="4">0.163157894736842</cx:pt>
          <cx:pt idx="5">0.16490166414523399</cx:pt>
          <cx:pt idx="6">0.084372003835090997</cx:pt>
          <cx:pt idx="7">0.28822733423545299</cx:pt>
          <cx:pt idx="8">0.14839572192513301</cx:pt>
          <cx:pt idx="9">0.199335548172757</cx:pt>
          <cx:pt idx="10">0.21745562130177501</cx:pt>
          <cx:pt idx="11">0.118100128369704</cx:pt>
          <cx:pt idx="12">0.092307692307692299</cx:pt>
          <cx:pt idx="13">0.14387464387464299</cx:pt>
          <cx:pt idx="14">0.141043723554301</cx:pt>
          <cx:pt idx="15">0.14388489208633001</cx:pt>
          <cx:pt idx="16">0.145454545454545</cx:pt>
          <cx:pt idx="17">0.105357142857142</cx:pt>
          <cx:pt idx="18">0.14438502673796699</cx:pt>
          <cx:pt idx="19">0.14768683274021299</cx:pt>
          <cx:pt idx="20">0.111940298507462</cx:pt>
          <cx:pt idx="21">0.15825688073394401</cx:pt>
          <cx:pt idx="22">0.16166281755196299</cx:pt>
          <cx:pt idx="23">0.101910828025477</cx:pt>
          <cx:pt idx="24">0.19354838709677399</cx:pt>
          <cx:pt idx="25">0.22379032258064499</cx:pt>
          <cx:pt idx="26">0.083003952569169898</cx:pt>
          <cx:pt idx="27">0.10874704491725699</cx:pt>
          <cx:pt idx="28">0.28723404255319102</cx:pt>
          <cx:pt idx="29">0.16569200779727</cx:pt>
          <cx:pt idx="30">0.11132437619961599</cx:pt>
          <cx:pt idx="31">0.060465116279069697</cx:pt>
          <cx:pt idx="32">0.11740890688259099</cx:pt>
          <cx:pt idx="33">0.012500000000000001</cx:pt>
          <cx:pt idx="34">0.0804597701149425</cx:pt>
          <cx:pt idx="35">0.22921348314606699</cx:pt>
          <cx:pt idx="36">0.112941176470588</cx:pt>
          <cx:pt idx="37">0.10000000000000001</cx:pt>
          <cx:pt idx="38">0.213675213675213</cx:pt>
          <cx:pt idx="39">0.12634408602150499</cx:pt>
          <cx:pt idx="40">0.114718614718614</cx:pt>
          <cx:pt idx="41">0.121761658031088</cx:pt>
          <cx:pt idx="42">0.13477088948787</cx:pt>
          <cx:pt idx="43">0.14506172839506101</cx:pt>
          <cx:pt idx="44">0.060773480662983402</cx:pt>
          <cx:pt idx="45">0.11</cx:pt>
          <cx:pt idx="46">0.13032581453634001</cx:pt>
          <cx:pt idx="47">0.123563218390804</cx:pt>
          <cx:pt idx="48">0.121495327102803</cx:pt>
          <cx:pt idx="49">0.066496163682864401</cx:pt>
          <cx:pt idx="50">0.028213166144200601</cx:pt>
          <cx:pt idx="51">0.12650602409638501</cx:pt>
          <cx:pt idx="52">0.17142857142857101</cx:pt>
          <cx:pt idx="53">0.089456869009584605</cx:pt>
          <cx:pt idx="54">0.28571428571428498</cx:pt>
          <cx:pt idx="55">0.121739130434782</cx:pt>
          <cx:pt idx="56">0.19081272084805601</cx:pt>
          <cx:pt idx="57">0.123287671232876</cx:pt>
          <cx:pt idx="58">0.050295857988165597</cx:pt>
          <cx:pt idx="59">0.24561403508771901</cx:pt>
          <cx:pt idx="60">0.056994818652849701</cx:pt>
          <cx:pt idx="61">0.211805555555555</cx:pt>
          <cx:pt idx="62">0.079470198675496595</cx:pt>
          <cx:pt idx="63">0.125</cx:pt>
          <cx:pt idx="64">0.076158940397350994</cx:pt>
          <cx:pt idx="65">0.12883435582822</cx:pt>
          <cx:pt idx="66">0.20882352941176399</cx:pt>
          <cx:pt idx="67">0.145454545454545</cx:pt>
          <cx:pt idx="68">0.0294117647058823</cx:pt>
          <cx:pt idx="69">0.13355048859934801</cx:pt>
          <cx:pt idx="70">0.103658536585365</cx:pt>
          <cx:pt idx="71">0.18974358974358899</cx:pt>
          <cx:pt idx="72">0.064935064935064901</cx:pt>
          <cx:pt idx="73">0.071197411003236205</cx:pt>
          <cx:pt idx="74">0.18411552346570301</cx:pt>
          <cx:pt idx="75">0.102990033222591</cx:pt>
          <cx:pt idx="76">0.147798742138364</cx:pt>
          <cx:pt idx="77">0.098540145985401395</cx:pt>
          <cx:pt idx="78">0.118773946360153</cx:pt>
          <cx:pt idx="79">0.12711864406779599</cx:pt>
          <cx:pt idx="80">0.054878048780487798</cx:pt>
          <cx:pt idx="81">0.10344827586206801</cx:pt>
          <cx:pt idx="82">0.090909090909090898</cx:pt>
          <cx:pt idx="83">0.115894039735099</cx:pt>
          <cx:pt idx="84">0.085245901639344202</cx:pt>
          <cx:pt idx="85">0.164835164835164</cx:pt>
          <cx:pt idx="86">0.21153846153846101</cx:pt>
          <cx:pt idx="87">0.178137651821862</cx:pt>
          <cx:pt idx="88">0.061290322580645103</cx:pt>
          <cx:pt idx="89">0.073943661971830901</cx:pt>
          <cx:pt idx="90">0.067415730337078594</cx:pt>
          <cx:pt idx="91">0.20618556701030899</cx:pt>
          <cx:pt idx="92">0.11504424778760999</cx:pt>
          <cx:pt idx="93">0.10033444816053499</cx:pt>
          <cx:pt idx="94">0.133858267716535</cx:pt>
          <cx:pt idx="95">0.085106382978723402</cx:pt>
          <cx:pt idx="96">0.095785440613026795</cx:pt>
          <cx:pt idx="97">0.073578595317725703</cx:pt>
          <cx:pt idx="98">0.05859375</cx:pt>
          <cx:pt idx="99">0.11888111888111801</cx:pt>
          <cx:pt idx="100">0.19157088122605301</cx:pt>
          <cx:pt idx="101">0.140794223826714</cx:pt>
          <cx:pt idx="102">0.10408921933085501</cx:pt>
          <cx:pt idx="103">0.16872427983539001</cx:pt>
          <cx:pt idx="104">0.124481327800829</cx:pt>
          <cx:pt idx="105">0.10472972972972899</cx:pt>
          <cx:pt idx="106">0.14336917562724</cx:pt>
          <cx:pt idx="107">0.135245901639344</cx:pt>
          <cx:pt idx="108">0.27340823970037398</cx:pt>
          <cx:pt idx="109">0.098939929328621903</cx:pt>
          <cx:pt idx="110">0.109929078014184</cx:pt>
          <cx:pt idx="111">0.093862815884476494</cx:pt>
          <cx:pt idx="112">0.10034602076124501</cx:pt>
          <cx:pt idx="113">0.045936395759717301</cx:pt>
          <cx:pt idx="114">0.0289256198347107</cx:pt>
          <cx:pt idx="115">0.040880503144654003</cx:pt>
          <cx:pt idx="116">0.069565217391304293</cx:pt>
          <cx:pt idx="117">0.213592233009708</cx:pt>
          <cx:pt idx="118">0.31277533039647498</cx:pt>
          <cx:pt idx="119">0.117117117117117</cx:pt>
          <cx:pt idx="120">0.14170040485829899</cx:pt>
          <cx:pt idx="121">0.059288537549407098</cx:pt>
          <cx:pt idx="122">0.12589928057553901</cx:pt>
          <cx:pt idx="123">0.17692307692307599</cx:pt>
          <cx:pt idx="124">0.20754716981131999</cx:pt>
          <cx:pt idx="125">0.122270742358078</cx:pt>
          <cx:pt idx="126">0.152</cx:pt>
          <cx:pt idx="127">0.155462184873949</cx:pt>
          <cx:pt idx="128">0.139917695473251</cx:pt>
          <cx:pt idx="129">0.077551020408163196</cx:pt>
          <cx:pt idx="130">0.059574468085106302</cx:pt>
          <cx:pt idx="131">0.11023622047244</cx:pt>
          <cx:pt idx="132">0.202380952380952</cx:pt>
          <cx:pt idx="133">0.125</cx:pt>
          <cx:pt idx="134">0.11244979919678701</cx:pt>
          <cx:pt idx="135">0.23958333333333301</cx:pt>
          <cx:pt idx="136">0.096069868995633106</cx:pt>
          <cx:pt idx="137">0.157894736842105</cx:pt>
          <cx:pt idx="138">0.046332046332046302</cx:pt>
          <cx:pt idx="139">0.179372197309417</cx:pt>
          <cx:pt idx="140">0.052631578947368397</cx:pt>
          <cx:pt idx="141">0.18518518518518501</cx:pt>
          <cx:pt idx="142">0.067796610169491497</cx:pt>
          <cx:pt idx="143">0.21610169491525399</cx:pt>
          <cx:pt idx="144">0.11600000000000001</cx:pt>
          <cx:pt idx="145">0.13438735177865599</cx:pt>
          <cx:pt idx="146">0.17622950819672101</cx:pt>
          <cx:pt idx="147">0.100806451612903</cx:pt>
          <cx:pt idx="148">0.13559322033898299</cx:pt>
          <cx:pt idx="149">0.112554112554112</cx:pt>
          <cx:pt idx="150">0.156950672645739</cx:pt>
          <cx:pt idx="151">0.099502487562189004</cx:pt>
          <cx:pt idx="152">0.080321285140562207</cx:pt>
          <cx:pt idx="153">0.172839506172839</cx:pt>
          <cx:pt idx="154">0.20164609053497901</cx:pt>
          <cx:pt idx="155">0.27225130890052301</cx:pt>
          <cx:pt idx="156">0.13636363636363599</cx:pt>
          <cx:pt idx="157">0.0816326530612244</cx:pt>
          <cx:pt idx="158">0.18181818181818099</cx:pt>
          <cx:pt idx="159">0.103896103896103</cx:pt>
          <cx:pt idx="160">0.077586206896551699</cx:pt>
          <cx:pt idx="161">0.144859813084112</cx:pt>
          <cx:pt idx="162">0.090476190476190405</cx:pt>
          <cx:pt idx="163">0.084821428571428506</cx:pt>
          <cx:pt idx="164">0.15566037735849</cx:pt>
          <cx:pt idx="165">0.106976744186046</cx:pt>
          <cx:pt idx="166">0.133333333333333</cx:pt>
          <cx:pt idx="167">0.126637554585152</cx:pt>
          <cx:pt idx="168">0.10576923076923</cx:pt>
          <cx:pt idx="169">0.082125603864734303</cx:pt>
          <cx:pt idx="170">0.133333333333333</cx:pt>
          <cx:pt idx="171">0.25510204081632598</cx:pt>
          <cx:pt idx="172">0.069498069498069498</cx:pt>
          <cx:pt idx="173">0.077625570776255703</cx:pt>
          <cx:pt idx="174">0.052173913043478203</cx:pt>
          <cx:pt idx="175">0.109523809523809</cx:pt>
          <cx:pt idx="176">0.107758620689655</cx:pt>
          <cx:pt idx="177">0.0985915492957746</cx:pt>
          <cx:pt idx="178">0.163265306122448</cx:pt>
          <cx:pt idx="179">0.22222222222222199</cx:pt>
          <cx:pt idx="180">0.20297029702970201</cx:pt>
          <cx:pt idx="181">0.25</cx:pt>
          <cx:pt idx="182">0.18974358974358899</cx:pt>
          <cx:pt idx="183">0.096069868995633106</cx:pt>
          <cx:pt idx="184">0.114427860696517</cx:pt>
          <cx:pt idx="185">0.22222222222222199</cx:pt>
          <cx:pt idx="186">0.056994818652849701</cx:pt>
          <cx:pt idx="187">0.15706806282722499</cx:pt>
          <cx:pt idx="188">0.048672566371681401</cx:pt>
          <cx:pt idx="189">0.119834710743801</cx:pt>
          <cx:pt idx="190">0.114285714285714</cx:pt>
          <cx:pt idx="191">0.30932203389830498</cx:pt>
          <cx:pt idx="192">0.097938144329896906</cx:pt>
          <cx:pt idx="193">0.232472324723247</cx:pt>
          <cx:pt idx="194">0.127962085308056</cx:pt>
          <cx:pt idx="195">0.050458715596330202</cx:pt>
          <cx:pt idx="196">0.20535714285714199</cx:pt>
          <cx:pt idx="197">0.088105726872246701</cx:pt>
          <cx:pt idx="198">0.13242009132419999</cx:pt>
          <cx:pt idx="199">0.237179487179487</cx:pt>
          <cx:pt idx="200">0.073529411764705802</cx:pt>
          <cx:pt idx="201">0.111764705882352</cx:pt>
          <cx:pt idx="202">0.111570247933884</cx:pt>
          <cx:pt idx="203">0.12804878048780399</cx:pt>
          <cx:pt idx="204">0.092783505154639095</cx:pt>
          <cx:pt idx="205">0.195945945945945</cx:pt>
          <cx:pt idx="206">0.218274111675126</cx:pt>
          <cx:pt idx="207">0.15023474178403701</cx:pt>
          <cx:pt idx="208">0.13131313131313099</cx:pt>
          <cx:pt idx="209">0.13684210526315699</cx:pt>
          <cx:pt idx="210">0.0277777777777777</cx:pt>
          <cx:pt idx="211">0.074712643678160898</cx:pt>
          <cx:pt idx="212">0.17910447761194001</cx:pt>
          <cx:pt idx="213">0.17889908256880699</cx:pt>
          <cx:pt idx="214">0.109375</cx:pt>
          <cx:pt idx="215">0.29255319148936099</cx:pt>
          <cx:pt idx="216">0.113207547169811</cx:pt>
          <cx:pt idx="217">0.086538461538461495</cx:pt>
          <cx:pt idx="218">0.15602836879432599</cx:pt>
          <cx:pt idx="219">0.12698412698412601</cx:pt>
          <cx:pt idx="220">0.27411167512690299</cx:pt>
          <cx:pt idx="221">0.162162162162162</cx:pt>
          <cx:pt idx="222">0.17391304347826</cx:pt>
          <cx:pt idx="223">0.0710900473933649</cx:pt>
          <cx:pt idx="224">0.063218390804597693</cx:pt>
          <cx:pt idx="225">0.066298342541436406</cx:pt>
          <cx:pt idx="226">0.212643678160919</cx:pt>
          <cx:pt idx="227">0.142045454545454</cx:pt>
          <cx:pt idx="228">0.13793103448275801</cx:pt>
          <cx:pt idx="229">0.074285714285714205</cx:pt>
          <cx:pt idx="230">0.25824175824175799</cx:pt>
          <cx:pt idx="231">0.0769230769230769</cx:pt>
          <cx:pt idx="232">0.20571428571428499</cx:pt>
          <cx:pt idx="233">0.15819209039547999</cx:pt>
          <cx:pt idx="234">0.096938775510203995</cx:pt>
          <cx:pt idx="235">0.134615384615384</cx:pt>
          <cx:pt idx="236">0.177215189873417</cx:pt>
          <cx:pt idx="237">0.087209302325581398</cx:pt>
          <cx:pt idx="238">0.171875</cx:pt>
          <cx:pt idx="239">0.165680473372781</cx:pt>
          <cx:pt idx="240">0.16860465116279</cx:pt>
          <cx:pt idx="241">0.242937853107344</cx:pt>
          <cx:pt idx="242">0.154471544715447</cx:pt>
          <cx:pt idx="243">0.209580838323353</cx:pt>
          <cx:pt idx="244">0.068062827225130795</cx:pt>
          <cx:pt idx="245">0.089552238805970102</cx:pt>
          <cx:pt idx="246">0.15819209039547999</cx:pt>
          <cx:pt idx="247">0.233333333333333</cx:pt>
          <cx:pt idx="248">0.070063694267515894</cx:pt>
          <cx:pt idx="249">0.139072847682119</cx:pt>
          <cx:pt idx="250">0.14594594594594501</cx:pt>
          <cx:pt idx="251">0.17499999999999999</cx:pt>
          <cx:pt idx="252">0.16666666666666599</cx:pt>
          <cx:pt idx="253">0.17777777777777701</cx:pt>
          <cx:pt idx="254">0.15384615384615299</cx:pt>
          <cx:pt idx="255">0.17006802721088399</cx:pt>
          <cx:pt idx="256">0.068750000000000006</cx:pt>
          <cx:pt idx="257">0.077922077922077906</cx:pt>
          <cx:pt idx="258">0.044554455445544497</cx:pt>
          <cx:pt idx="259">0.17613636363636301</cx:pt>
          <cx:pt idx="260">0.093922651933701598</cx:pt>
          <cx:pt idx="261">0.088235294117646995</cx:pt>
          <cx:pt idx="262">0.13294797687861201</cx:pt>
          <cx:pt idx="263">0.22099447513812101</cx:pt>
          <cx:pt idx="264">0.14388489208633001</cx:pt>
          <cx:pt idx="265">0.14691943127962001</cx:pt>
          <cx:pt idx="266">0.15107913669064699</cx:pt>
          <cx:pt idx="267">0.20261437908496699</cx:pt>
          <cx:pt idx="268">0.22099447513812101</cx:pt>
          <cx:pt idx="269">0.12666666666666601</cx:pt>
          <cx:pt idx="270">0.17808219178082099</cx:pt>
          <cx:pt idx="271">0.11111111111111099</cx:pt>
          <cx:pt idx="272">0.122222222222222</cx:pt>
          <cx:pt idx="273">0.12849162011173099</cx:pt>
          <cx:pt idx="274">0.105263157894736</cx:pt>
          <cx:pt idx="275">0.188571428571428</cx:pt>
          <cx:pt idx="276">0.10344827586206801</cx:pt>
          <cx:pt idx="277">0.14049586776859499</cx:pt>
          <cx:pt idx="278">0.26415094339622602</cx:pt>
          <cx:pt idx="279">0.088709677419354802</cx:pt>
          <cx:pt idx="280">0.158730158730158</cx:pt>
          <cx:pt idx="281">0.0866666666666666</cx:pt>
          <cx:pt idx="282">0.17687074829931901</cx:pt>
          <cx:pt idx="283">0.18666666666666601</cx:pt>
          <cx:pt idx="284">0.210191082802547</cx:pt>
          <cx:pt idx="285">0.1875</cx:pt>
          <cx:pt idx="286">0.25547445255474399</cx:pt>
          <cx:pt idx="287">0.117283950617283</cx:pt>
          <cx:pt idx="288">0.077922077922077906</cx:pt>
          <cx:pt idx="289">0.17714285714285699</cx:pt>
          <cx:pt idx="290">0.23684210526315699</cx:pt>
          <cx:pt idx="291">0.050632911392405</cx:pt>
          <cx:pt idx="292">0.0843373493975903</cx:pt>
          <cx:pt idx="293">0.105263157894736</cx:pt>
          <cx:pt idx="294">0.084745762711864403</cx:pt>
          <cx:pt idx="295">0.21052631578947301</cx:pt>
          <cx:pt idx="296">0.15172413793103401</cx:pt>
          <cx:pt idx="297">0.105960264900662</cx:pt>
          <cx:pt idx="298">0.24489795918367299</cx:pt>
          <cx:pt idx="299">0.14876033057851201</cx:pt>
          <cx:pt idx="300">0.136904761904761</cx:pt>
          <cx:pt idx="301">0.185430463576158</cx:pt>
          <cx:pt idx="302">0.265822784810126</cx:pt>
          <cx:pt idx="303">0.29577464788732299</cx:pt>
          <cx:pt idx="304">0.058139534883720902</cx:pt>
          <cx:pt idx="305">0.22222222222222199</cx:pt>
          <cx:pt idx="306">0.15853658536585299</cx:pt>
          <cx:pt idx="307">0.24503311258278099</cx:pt>
          <cx:pt idx="308">0.189393939393939</cx:pt>
          <cx:pt idx="309">0.317647058823529</cx:pt>
          <cx:pt idx="310">0.18181818181818099</cx:pt>
          <cx:pt idx="311">0.164383561643835</cx:pt>
          <cx:pt idx="312">0.18461538461538399</cx:pt>
          <cx:pt idx="313">0.13698630136986301</cx:pt>
          <cx:pt idx="314">0.31884057971014401</cx:pt>
          <cx:pt idx="315">0.16911764705882301</cx:pt>
          <cx:pt idx="316">0.103896103896103</cx:pt>
          <cx:pt idx="317">0.118518518518518</cx:pt>
          <cx:pt idx="318">0.085889570552147201</cx:pt>
          <cx:pt idx="319">0.103658536585365</cx:pt>
          <cx:pt idx="320">0.067567567567567502</cx:pt>
          <cx:pt idx="321">0.11764705882352899</cx:pt>
          <cx:pt idx="322">0.24347826086956501</cx:pt>
          <cx:pt idx="323">0.068965517241379296</cx:pt>
          <cx:pt idx="324">0.10655737704918</cx:pt>
          <cx:pt idx="325">0.107692307692307</cx:pt>
          <cx:pt idx="326">0.057142857142857099</cx:pt>
          <cx:pt idx="327">0.26315789473684198</cx:pt>
          <cx:pt idx="328">0.12903225806451599</cx:pt>
          <cx:pt idx="329">0.157480314960629</cx:pt>
          <cx:pt idx="330">0.19658119658119599</cx:pt>
          <cx:pt idx="331">0.206611570247933</cx:pt>
          <cx:pt idx="332">0.19871794871794801</cx:pt>
          <cx:pt idx="333">0.18897637795275499</cx:pt>
          <cx:pt idx="334">0.084848484848484798</cx:pt>
          <cx:pt idx="335">0.192</cx:pt>
          <cx:pt idx="336">0.10000000000000001</cx:pt>
          <cx:pt idx="337">0.17142857142857101</cx:pt>
          <cx:pt idx="338">0.109243697478991</cx:pt>
          <cx:pt idx="339">0.068702290076335798</cx:pt>
          <cx:pt idx="340">0.37419354838709601</cx:pt>
          <cx:pt idx="341">0.13669064748201401</cx:pt>
          <cx:pt idx="342">0.066666666666666596</cx:pt>
          <cx:pt idx="343">0.20915032679738499</cx:pt>
          <cx:pt idx="344">0.18965517241379301</cx:pt>
          <cx:pt idx="345">0.048275862068965503</cx:pt>
          <cx:pt idx="346">0.174242424242424</cx:pt>
          <cx:pt idx="347">0.1171875</cx:pt>
          <cx:pt idx="348">0.16935483870967699</cx:pt>
          <cx:pt idx="349">0.13868613138686101</cx:pt>
          <cx:pt idx="350">0.25</cx:pt>
          <cx:pt idx="351">0.28378378378378299</cx:pt>
          <cx:pt idx="352">0.21641791044776101</cx:pt>
          <cx:pt idx="353">0.125</cx:pt>
          <cx:pt idx="354">0.105691056910569</cx:pt>
          <cx:pt idx="355">0.201834862385321</cx:pt>
          <cx:pt idx="356">0.194915254237288</cx:pt>
          <cx:pt idx="357">0.16239316239316201</cx:pt>
          <cx:pt idx="358">0.132867132867132</cx:pt>
          <cx:pt idx="359">0.20000000000000001</cx:pt>
          <cx:pt idx="360">0.146496815286624</cx:pt>
          <cx:pt idx="361">0.097744360902255606</cx:pt>
          <cx:pt idx="362">0.116666666666666</cx:pt>
          <cx:pt idx="363">0.23489932885906001</cx:pt>
          <cx:pt idx="364">0.16793893129770901</cx:pt>
          <cx:pt idx="365">0.141666666666666</cx:pt>
          <cx:pt idx="366">0.105263157894736</cx:pt>
          <cx:pt idx="367">0.22881355932203301</cx:pt>
          <cx:pt idx="368">0.14285714285714199</cx:pt>
          <cx:pt idx="369">0.157142857142857</cx:pt>
          <cx:pt idx="370">0.21774193548387</cx:pt>
          <cx:pt idx="371">0.119658119658119</cx:pt>
          <cx:pt idx="372">0.18918918918918901</cx:pt>
          <cx:pt idx="373">0.14912280701754299</cx:pt>
          <cx:pt idx="374">0.066666666666666596</cx:pt>
          <cx:pt idx="375">0.15454545454545399</cx:pt>
          <cx:pt idx="376">0.13559322033898299</cx:pt>
          <cx:pt idx="377">0.170212765957446</cx:pt>
          <cx:pt idx="378">0.12903225806451599</cx:pt>
          <cx:pt idx="379">0.21917808219178</cx:pt>
          <cx:pt idx="380">0.066037735849056603</cx:pt>
          <cx:pt idx="381">0.19767441860465099</cx:pt>
          <cx:pt idx="382">0.049586776859504099</cx:pt>
          <cx:pt idx="383">0.10377358490565999</cx:pt>
          <cx:pt idx="384">0.154929577464788</cx:pt>
          <cx:pt idx="385">0.13559322033898299</cx:pt>
          <cx:pt idx="386">0.34146341463414598</cx:pt>
          <cx:pt idx="387">0.10000000000000001</cx:pt>
          <cx:pt idx="388">0.035714285714285698</cx:pt>
          <cx:pt idx="389">0.086206896551724102</cx:pt>
          <cx:pt idx="390">0.17460317460317401</cx:pt>
          <cx:pt idx="391">0.161904761904761</cx:pt>
          <cx:pt idx="392">0.116504854368932</cx:pt>
          <cx:pt idx="393">0.15126050420168</cx:pt>
          <cx:pt idx="394">0.10344827586206801</cx:pt>
          <cx:pt idx="395">0.20588235294117599</cx:pt>
          <cx:pt idx="396">0.238938053097345</cx:pt>
          <cx:pt idx="397">0.063636363636363602</cx:pt>
          <cx:pt idx="398">0.13131313131313099</cx:pt>
          <cx:pt idx="399">0.13138686131386801</cx:pt>
          <cx:pt idx="400">0.122807017543859</cx:pt>
          <cx:pt idx="401">0.14999999999999999</cx:pt>
          <cx:pt idx="402">0.14876033057851201</cx:pt>
          <cx:pt idx="403">0.12037037037037</cx:pt>
          <cx:pt idx="404">0.15686274509803899</cx:pt>
          <cx:pt idx="405">0.095744680851063801</cx:pt>
          <cx:pt idx="406">0.147826086956521</cx:pt>
          <cx:pt idx="407">0.14285714285714199</cx:pt>
          <cx:pt idx="408">0.25688073394495398</cx:pt>
          <cx:pt idx="409">0.19607843137254899</cx:pt>
          <cx:pt idx="410">0.069767441860465101</cx:pt>
          <cx:pt idx="411">0.123711340206185</cx:pt>
          <cx:pt idx="412">0.092783505154639095</cx:pt>
          <cx:pt idx="413">0.25663716814159199</cx:pt>
          <cx:pt idx="414">0.056074766355140103</cx:pt>
          <cx:pt idx="415">0.10344827586206801</cx:pt>
          <cx:pt idx="416">0.134020618556701</cx:pt>
          <cx:pt idx="417">0.063291139240506306</cx:pt>
          <cx:pt idx="418">0.026315789473684199</cx:pt>
          <cx:pt idx="419">0.15151515151515099</cx:pt>
          <cx:pt idx="420">0.15384615384615299</cx:pt>
          <cx:pt idx="421">0.0769230769230769</cx:pt>
          <cx:pt idx="422">0.20000000000000001</cx:pt>
          <cx:pt idx="423">0.066666666666666596</cx:pt>
          <cx:pt idx="424">0.11340206185567001</cx:pt>
          <cx:pt idx="425">0.12765957446808501</cx:pt>
          <cx:pt idx="426">0.080000000000000002</cx:pt>
          <cx:pt idx="427">0.102272727272727</cx:pt>
          <cx:pt idx="428">0.17307692307692299</cx:pt>
          <cx:pt idx="429">0.047619047619047603</cx:pt>
          <cx:pt idx="430">0.28409090909090901</cx:pt>
          <cx:pt idx="431">0.22641509433962201</cx:pt>
          <cx:pt idx="432">0.17204301075268799</cx:pt>
          <cx:pt idx="433">0.214285714285714</cx:pt>
          <cx:pt idx="434">0.22222222222222199</cx:pt>
          <cx:pt idx="435">0.10752688172043</cx:pt>
          <cx:pt idx="436">0.0898876404494382</cx:pt>
          <cx:pt idx="437">0.041237113402061799</cx:pt>
          <cx:pt idx="438">0.113924050632911</cx:pt>
          <cx:pt idx="439">0.0163934426229508</cx:pt>
          <cx:pt idx="440">0.15384615384615299</cx:pt>
          <cx:pt idx="441">0.17582417582417501</cx:pt>
          <cx:pt idx="442">0.133333333333333</cx:pt>
          <cx:pt idx="443">0.10000000000000001</cx:pt>
          <cx:pt idx="444">0.040540540540540501</cx:pt>
          <cx:pt idx="445">0.051282051282051197</cx:pt>
          <cx:pt idx="446">0.084210526315789402</cx:pt>
          <cx:pt idx="447">0.105882352941176</cx:pt>
          <cx:pt idx="448">0.12345679012345601</cx:pt>
          <cx:pt idx="449">0</cx:pt>
          <cx:pt idx="450">0.329670329670329</cx:pt>
          <cx:pt idx="451">0.16250000000000001</cx:pt>
          <cx:pt idx="452">0.27000000000000002</cx:pt>
          <cx:pt idx="453">0.096774193548387094</cx:pt>
          <cx:pt idx="454">0.12727272727272701</cx:pt>
          <cx:pt idx="455">0.15942028985507201</cx:pt>
          <cx:pt idx="456">0.20895522388059701</cx:pt>
          <cx:pt idx="457">0.114285714285714</cx:pt>
          <cx:pt idx="458">0.121621621621621</cx:pt>
          <cx:pt idx="459">0.23611111111111099</cx:pt>
          <cx:pt idx="460">0.0138888888888888</cx:pt>
          <cx:pt idx="461">0.10000000000000001</cx:pt>
          <cx:pt idx="462">0.092592592592592504</cx:pt>
          <cx:pt idx="463">0.186440677966101</cx:pt>
          <cx:pt idx="464">0.15094339622641501</cx:pt>
          <cx:pt idx="465">0.256410256410256</cx:pt>
          <cx:pt idx="466">0.069444444444444406</cx:pt>
          <cx:pt idx="467">0.15151515151515099</cx:pt>
          <cx:pt idx="468">0.074626865671641701</cx:pt>
          <cx:pt idx="469">0.25</cx:pt>
          <cx:pt idx="470">0.025000000000000001</cx:pt>
          <cx:pt idx="471">0.23214285714285701</cx:pt>
          <cx:pt idx="472">0.17241379310344801</cx:pt>
          <cx:pt idx="473">0.24590163934426201</cx:pt>
          <cx:pt idx="474">0.29729729729729698</cx:pt>
          <cx:pt idx="475">0.265306122448979</cx:pt>
          <cx:pt idx="476">0.20512820512820501</cx:pt>
          <cx:pt idx="477">0.16666666666666599</cx:pt>
          <cx:pt idx="478">0.20000000000000001</cx:pt>
          <cx:pt idx="479">0.35483870967741898</cx:pt>
          <cx:pt idx="480">0.12903225806451599</cx:pt>
          <cx:pt idx="481">0.20833333333333301</cx:pt>
          <cx:pt idx="482">0.33333333333333298</cx:pt>
          <cx:pt idx="483">0.33333333333333298</cx:pt>
          <cx:pt idx="484">0</cx:pt>
          <cx:pt idx="485">0</cx:pt>
          <cx:pt idx="486">1</cx:pt>
          <cx:pt idx="487">0.20000000000000001</cx:pt>
          <cx:pt idx="488">0</cx:pt>
        </cx:lvl>
      </cx:numDim>
    </cx:data>
    <cx:data id="1">
      <cx:numDim type="val">
        <cx:f>selective_expression_ratio!$B$2:$B$490</cx:f>
        <cx:lvl ptCount="489" formatCode="G/通用格式">
          <cx:pt idx="0">0.17065408252853301</cx:pt>
          <cx:pt idx="1">0.27175572519083901</cx:pt>
          <cx:pt idx="2">0.21003134796238199</cx:pt>
          <cx:pt idx="3">0.19387755102040799</cx:pt>
          <cx:pt idx="4">0.156626506024096</cx:pt>
          <cx:pt idx="5">0.17948717948717899</cx:pt>
          <cx:pt idx="6">0.066666666666666596</cx:pt>
          <cx:pt idx="7">0.20000000000000001</cx:pt>
          <cx:pt idx="8">0.22500000000000001</cx:pt>
          <cx:pt idx="9">0.21917808219178</cx:pt>
          <cx:pt idx="10">0.23728813559322001</cx:pt>
          <cx:pt idx="11">0.33846153846153798</cx:pt>
          <cx:pt idx="12">0.30434782608695599</cx:pt>
          <cx:pt idx="13">0.30769230769230699</cx:pt>
          <cx:pt idx="14">0.18181818181818099</cx:pt>
          <cx:pt idx="15">0.080645161290322495</cx:pt>
          <cx:pt idx="16">0.169491525423728</cx:pt>
          <cx:pt idx="17">0.13636363636363599</cx:pt>
          <cx:pt idx="18">0.125</cx:pt>
          <cx:pt idx="19">0.134615384615384</cx:pt>
          <cx:pt idx="20">0.107142857142857</cx:pt>
          <cx:pt idx="21">0.21052631578947301</cx:pt>
          <cx:pt idx="22">0.12</cx:pt>
          <cx:pt idx="23">0.157894736842105</cx:pt>
          <cx:pt idx="24">0.18032786885245899</cx:pt>
          <cx:pt idx="25">0.33333333333333298</cx:pt>
          <cx:pt idx="26">0.125</cx:pt>
          <cx:pt idx="27">0.12698412698412601</cx:pt>
          <cx:pt idx="28">0.145454545454545</cx:pt>
          <cx:pt idx="29">0.105263157894736</cx:pt>
          <cx:pt idx="30">0.186440677966101</cx:pt>
          <cx:pt idx="31">0.14583333333333301</cx:pt>
          <cx:pt idx="32">0.13636363636363599</cx:pt>
          <cx:pt idx="33">0.15686274509803899</cx:pt>
          <cx:pt idx="34">0.105263157894736</cx:pt>
          <cx:pt idx="35">0.068965517241379296</cx:pt>
          <cx:pt idx="36">0.28888888888888797</cx:pt>
          <cx:pt idx="37">0.22916666666666599</cx:pt>
          <cx:pt idx="38">0.13725490196078399</cx:pt>
          <cx:pt idx="39">0.107142857142857</cx:pt>
          <cx:pt idx="40">0.12962962962962901</cx:pt>
          <cx:pt idx="41">0.19642857142857101</cx:pt>
          <cx:pt idx="42">0.13953488372093001</cx:pt>
          <cx:pt idx="43">0.055555555555555497</cx:pt>
          <cx:pt idx="44">0.256410256410256</cx:pt>
          <cx:pt idx="45">0.019607843137254902</cx:pt>
          <cx:pt idx="46">0.21568627450980299</cx:pt>
          <cx:pt idx="47">0.12765957446808501</cx:pt>
          <cx:pt idx="48">0.115384615384615</cx:pt>
          <cx:pt idx="49">0.083333333333333301</cx:pt>
          <cx:pt idx="50">0.33333333333333298</cx:pt>
          <cx:pt idx="51">0.13636363636363599</cx:pt>
          <cx:pt idx="52">0.17948717948717899</cx:pt>
          <cx:pt idx="53">0.10638297872340401</cx:pt>
          <cx:pt idx="54">0.20512820512820501</cx:pt>
          <cx:pt idx="55">0.096153846153846104</cx:pt>
          <cx:pt idx="56">0.256410256410256</cx:pt>
          <cx:pt idx="57">0.085106382978723402</cx:pt>
          <cx:pt idx="58">0.083333333333333301</cx:pt>
          <cx:pt idx="59">0.116279069767441</cx:pt>
          <cx:pt idx="60">0.088888888888888795</cx:pt>
          <cx:pt idx="61">0.085714285714285701</cx:pt>
          <cx:pt idx="62">0.20512820512820501</cx:pt>
          <cx:pt idx="63">0.12195121951219499</cx:pt>
          <cx:pt idx="64">0.10416666666666601</cx:pt>
          <cx:pt idx="65">0.19565217391304299</cx:pt>
          <cx:pt idx="66">0.093023255813953404</cx:pt>
          <cx:pt idx="67">0.17777777777777701</cx:pt>
          <cx:pt idx="68">0.10000000000000001</cx:pt>
          <cx:pt idx="69">0.157894736842105</cx:pt>
          <cx:pt idx="70">0.25</cx:pt>
          <cx:pt idx="71">0.086956521739130405</cx:pt>
          <cx:pt idx="72">0.27027027027027001</cx:pt>
          <cx:pt idx="73">0.27500000000000002</cx:pt>
          <cx:pt idx="74">0.21621621621621601</cx:pt>
          <cx:pt idx="75">0.23076923076923</cx:pt>
          <cx:pt idx="76">0.26315789473684198</cx:pt>
          <cx:pt idx="77">0.026315789473684199</cx:pt>
          <cx:pt idx="78">0.21052631578947301</cx:pt>
          <cx:pt idx="79">0.093023255813953404</cx:pt>
          <cx:pt idx="80">0</cx:pt>
          <cx:pt idx="81">0.219512195121951</cx:pt>
          <cx:pt idx="82">0.14285714285714199</cx:pt>
          <cx:pt idx="83">0.114285714285714</cx:pt>
          <cx:pt idx="84">0.157894736842105</cx:pt>
          <cx:pt idx="85">0.14999999999999999</cx:pt>
          <cx:pt idx="86">0.186046511627906</cx:pt>
          <cx:pt idx="87">0.097560975609756101</cx:pt>
          <cx:pt idx="88">0.040000000000000001</cx:pt>
          <cx:pt idx="89">0.071428571428571397</cx:pt>
          <cx:pt idx="90">0.17073170731707299</cx:pt>
          <cx:pt idx="91">0.1875</cx:pt>
          <cx:pt idx="92">0.12195121951219499</cx:pt>
          <cx:pt idx="93">0.25806451612903197</cx:pt>
          <cx:pt idx="94">0.21621621621621601</cx:pt>
          <cx:pt idx="95">0.20000000000000001</cx:pt>
          <cx:pt idx="96">0.125</cx:pt>
          <cx:pt idx="97">0.090909090909090898</cx:pt>
          <cx:pt idx="98">0.186046511627906</cx:pt>
          <cx:pt idx="99">0.125</cx:pt>
          <cx:pt idx="100">0.15151515151515099</cx:pt>
          <cx:pt idx="101">0.1875</cx:pt>
          <cx:pt idx="102">0</cx:pt>
          <cx:pt idx="103">0.13043478260869501</cx:pt>
          <cx:pt idx="104">0.088235294117646995</cx:pt>
          <cx:pt idx="105">0.21052631578947301</cx:pt>
          <cx:pt idx="106">0.108108108108108</cx:pt>
          <cx:pt idx="107">0.064516129032257993</cx:pt>
          <cx:pt idx="108">0.21212121212121199</cx:pt>
          <cx:pt idx="109">0.095238095238095205</cx:pt>
          <cx:pt idx="110">0.20000000000000001</cx:pt>
          <cx:pt idx="111">0.081081081081081002</cx:pt>
          <cx:pt idx="112">0.125</cx:pt>
          <cx:pt idx="113">0.17857142857142799</cx:pt>
          <cx:pt idx="114">0.071428571428571397</cx:pt>
          <cx:pt idx="115">0.15151515151515099</cx:pt>
          <cx:pt idx="116">0.28571428571428498</cx:pt>
          <cx:pt idx="117">0.12195121951219499</cx:pt>
          <cx:pt idx="118">0.34482758620689602</cx:pt>
          <cx:pt idx="119">0.085714285714285701</cx:pt>
          <cx:pt idx="120">0.105263157894736</cx:pt>
          <cx:pt idx="121">0.16666666666666599</cx:pt>
          <cx:pt idx="122">0.15151515151515099</cx:pt>
          <cx:pt idx="123">0.16</cx:pt>
          <cx:pt idx="124">0.34782608695652101</cx:pt>
          <cx:pt idx="125">0.09375</cx:pt>
          <cx:pt idx="126">0.14285714285714199</cx:pt>
          <cx:pt idx="127">0.20689655172413701</cx:pt>
          <cx:pt idx="128">0.407407407407407</cx:pt>
          <cx:pt idx="129">0.14285714285714199</cx:pt>
          <cx:pt idx="130">0.22222222222222199</cx:pt>
          <cx:pt idx="131">0.19230769230769201</cx:pt>
          <cx:pt idx="132">0.16666666666666599</cx:pt>
          <cx:pt idx="133">0.125</cx:pt>
          <cx:pt idx="134">0.238095238095238</cx:pt>
          <cx:pt idx="135">0.31818181818181801</cx:pt>
          <cx:pt idx="136">0.055555555555555497</cx:pt>
          <cx:pt idx="137">0.38888888888888801</cx:pt>
          <cx:pt idx="138">0.24137931034482701</cx:pt>
          <cx:pt idx="139">0.035714285714285698</cx:pt>
          <cx:pt idx="140">0.14285714285714199</cx:pt>
          <cx:pt idx="141">0.13043478260869501</cx:pt>
          <cx:pt idx="142">0.34615384615384598</cx:pt>
          <cx:pt idx="143">0.25</cx:pt>
          <cx:pt idx="144">0</cx:pt>
          <cx:pt idx="145">0.26315789473684198</cx:pt>
          <cx:pt idx="146">0.27272727272727199</cx:pt>
          <cx:pt idx="147">0.29999999999999999</cx:pt>
          <cx:pt idx="148">0.125</cx:pt>
          <cx:pt idx="149">0.40000000000000002</cx:pt>
        </cx:lvl>
      </cx:numDim>
    </cx:data>
    <cx:data id="2">
      <cx:numDim type="val">
        <cx:f>selective_expression_ratio!$C$2:$C$490</cx:f>
        <cx:lvl ptCount="489" formatCode="G/通用格式">
          <cx:pt idx="0">0.033626173886701</cx:pt>
          <cx:pt idx="1">0.18815592203897999</cx:pt>
          <cx:pt idx="2">0.069154774972557606</cx:pt>
          <cx:pt idx="3">0.174882629107981</cx:pt>
          <cx:pt idx="4">0.080143540669856406</cx:pt>
          <cx:pt idx="5">0.087267525035765306</cx:pt>
          <cx:pt idx="6">0.14858096828046699</cx:pt>
          <cx:pt idx="7">0.060413354531001502</cx:pt>
          <cx:pt idx="8">0.15771230502599601</cx:pt>
          <cx:pt idx="9">0.107078039927404</cx:pt>
          <cx:pt idx="10">0.104302477183833</cx:pt>
          <cx:pt idx="11">0.075892857142857095</cx:pt>
          <cx:pt idx="12">0.12202380952380899</cx:pt>
          <cx:pt idx="13">0.29007633587786202</cx:pt>
          <cx:pt idx="14">0.097178683385579903</cx:pt>
          <cx:pt idx="15">0.18421052631578899</cx:pt>
          <cx:pt idx="16">0.073921971252566707</cx:pt>
          <cx:pt idx="17">0.15733333333333299</cx:pt>
          <cx:pt idx="18">0.092224231464737794</cx:pt>
          <cx:pt idx="19">0.14596949891067501</cx:pt>
          <cx:pt idx="20">0.062397372742200301</cx:pt>
          <cx:pt idx="21">0.091428571428571401</cx:pt>
          <cx:pt idx="22">0.13207547169811301</cx:pt>
          <cx:pt idx="23">0.120967741935483</cx:pt>
          <cx:pt idx="24">0.10018552875695701</cx:pt>
          <cx:pt idx="25">0.097560975609756101</cx:pt>
          <cx:pt idx="26">0.049034175334323901</cx:pt>
          <cx:pt idx="27">0.066371681415929196</cx:pt>
          <cx:pt idx="28">0.093023255813953404</cx:pt>
          <cx:pt idx="29">0.17585301837270301</cx:pt>
          <cx:pt idx="30">0.185840707964601</cx:pt>
          <cx:pt idx="31">0.060218978102189701</cx:pt>
          <cx:pt idx="32">0.12747875354107599</cx:pt>
          <cx:pt idx="33">0.119891008174386</cx:pt>
          <cx:pt idx="34">0.075593952483801297</cx:pt>
          <cx:pt idx="35">0.107476635514018</cx:pt>
          <cx:pt idx="36">0.077205882352941096</cx:pt>
          <cx:pt idx="37">0.119354838709677</cx:pt>
          <cx:pt idx="38">0.104651162790697</cx:pt>
          <cx:pt idx="39">0.28571428571428498</cx:pt>
          <cx:pt idx="40">0.12074303405572701</cx:pt>
          <cx:pt idx="41">0.032640949554896097</cx:pt>
          <cx:pt idx="42">0.067415730337078594</cx:pt>
          <cx:pt idx="43">0.14285714285714199</cx:pt>
          <cx:pt idx="44">0.18023255813953401</cx:pt>
          <cx:pt idx="45">0.094202898550724598</cx:pt>
          <cx:pt idx="46">0.178137651821862</cx:pt>
          <cx:pt idx="47">0.107692307692307</cx:pt>
          <cx:pt idx="48">0.085714285714285701</cx:pt>
          <cx:pt idx="49">0.041062801932367103</cx:pt>
          <cx:pt idx="50">0.18461538461538399</cx:pt>
          <cx:pt idx="51">0.055762081784386602</cx:pt>
          <cx:pt idx="52">0.083916083916083906</cx:pt>
          <cx:pt idx="53">0.157894736842105</cx:pt>
          <cx:pt idx="54">0.13953488372093001</cx:pt>
          <cx:pt idx="55">0.18205804749340301</cx:pt>
          <cx:pt idx="56">0.112</cx:pt>
          <cx:pt idx="57">0.161654135338345</cx:pt>
          <cx:pt idx="58">0.106122448979591</cx:pt>
          <cx:pt idx="59">0.16993464052287499</cx:pt>
          <cx:pt idx="60">0.12</cx:pt>
          <cx:pt idx="61">0.164383561643835</cx:pt>
          <cx:pt idx="62">0.120192307692307</cx:pt>
          <cx:pt idx="63">0.16800000000000001</cx:pt>
          <cx:pt idx="64">0.13953488372093001</cx:pt>
          <cx:pt idx="65">0.058394160583941597</cx:pt>
          <cx:pt idx="66">0.107806691449814</cx:pt>
          <cx:pt idx="67">0.19087136929460499</cx:pt>
          <cx:pt idx="68">0.214285714285714</cx:pt>
          <cx:pt idx="69">0.111888111888111</cx:pt>
          <cx:pt idx="70">0.12738853503184699</cx:pt>
          <cx:pt idx="71">0.13636363636363599</cx:pt>
          <cx:pt idx="72">0.18359375</cx:pt>
          <cx:pt idx="73">0.29999999999999999</cx:pt>
          <cx:pt idx="74">0.24662162162162099</cx:pt>
          <cx:pt idx="75">0.10784313725490099</cx:pt>
          <cx:pt idx="76">0.0625</cx:pt>
          <cx:pt idx="77">0.117886178861788</cx:pt>
          <cx:pt idx="78">0.133603238866396</cx:pt>
          <cx:pt idx="79">0.23605150214592199</cx:pt>
          <cx:pt idx="80">0.21393034825870599</cx:pt>
          <cx:pt idx="81">0.144295302013422</cx:pt>
          <cx:pt idx="82">0.055793991416309002</cx:pt>
          <cx:pt idx="83">0.071672354948805403</cx:pt>
          <cx:pt idx="84">0.146666666666666</cx:pt>
          <cx:pt idx="85">0.059040590405904002</cx:pt>
          <cx:pt idx="86">0.20253164556962</cx:pt>
          <cx:pt idx="87">0.133333333333333</cx:pt>
          <cx:pt idx="88">0.052325581395348798</cx:pt>
          <cx:pt idx="89">0.21461187214611799</cx:pt>
          <cx:pt idx="90">0.071428571428571397</cx:pt>
          <cx:pt idx="91">0.18143459915611801</cx:pt>
          <cx:pt idx="92">0.36666666666666597</cx:pt>
          <cx:pt idx="93">0.069124423963133605</cx:pt>
          <cx:pt idx="94">0.13775510204081601</cx:pt>
          <cx:pt idx="95">0.11616161616161599</cx:pt>
          <cx:pt idx="96">0.184782608695652</cx:pt>
          <cx:pt idx="97">0.055299539170506902</cx:pt>
          <cx:pt idx="98">0.114583333333333</cx:pt>
          <cx:pt idx="99">0.099476439790575896</cx:pt>
          <cx:pt idx="100">0.11111111111111099</cx:pt>
          <cx:pt idx="101">0.085409252669039107</cx:pt>
          <cx:pt idx="102">0.093264248704663197</cx:pt>
          <cx:pt idx="103">0.15584415584415501</cx:pt>
          <cx:pt idx="104">0.125523012552301</cx:pt>
          <cx:pt idx="105">0.048458149779735601</cx:pt>
          <cx:pt idx="106">0.13270142180094699</cx:pt>
          <cx:pt idx="107">0.0360824742268041</cx:pt>
          <cx:pt idx="108">0.038732394366197097</cx:pt>
          <cx:pt idx="109">0.27586206896551702</cx:pt>
          <cx:pt idx="110">0.144736842105263</cx:pt>
          <cx:pt idx="111">0.138364779874213</cx:pt>
          <cx:pt idx="112">0.200980392156862</cx:pt>
          <cx:pt idx="113">0.088050314465408799</cx:pt>
          <cx:pt idx="114">0.114427860696517</cx:pt>
          <cx:pt idx="115">0.079069767441860395</cx:pt>
          <cx:pt idx="116">0.152709359605911</cx:pt>
          <cx:pt idx="117">0.16666666666666599</cx:pt>
          <cx:pt idx="118">0.189873417721519</cx:pt>
          <cx:pt idx="119">0.0607476635514018</cx:pt>
          <cx:pt idx="120">0.122699386503067</cx:pt>
          <cx:pt idx="121">0.12849162011173099</cx:pt>
          <cx:pt idx="122">0.204166666666666</cx:pt>
          <cx:pt idx="123">0.21608040201004999</cx:pt>
          <cx:pt idx="124">0.105590062111801</cx:pt>
          <cx:pt idx="125">0.067357512953367796</cx:pt>
          <cx:pt idx="126">0.25668449197860899</cx:pt>
          <cx:pt idx="127">0.013986013986013899</cx:pt>
          <cx:pt idx="128">0.12666666666666601</cx:pt>
          <cx:pt idx="129">0.20588235294117599</cx:pt>
          <cx:pt idx="130">0.096385542168674704</cx:pt>
          <cx:pt idx="131">0.18918918918918901</cx:pt>
          <cx:pt idx="132">0.21666666666666601</cx:pt>
          <cx:pt idx="133">0.073770491803278604</cx:pt>
          <cx:pt idx="134">0.14754098360655701</cx:pt>
          <cx:pt idx="135">0.095890410958904104</cx:pt>
          <cx:pt idx="136">0.22222222222222199</cx:pt>
          <cx:pt idx="137">0.37383177570093401</cx:pt>
          <cx:pt idx="138">0.071428571428571397</cx:pt>
          <cx:pt idx="139">0.10344827586206801</cx:pt>
          <cx:pt idx="140">0.141975308641975</cx:pt>
          <cx:pt idx="141">0.041176470588235203</cx:pt>
          <cx:pt idx="142">0.051724137931034399</cx:pt>
          <cx:pt idx="143">0.0254777070063694</cx:pt>
          <cx:pt idx="144">0.126436781609195</cx:pt>
          <cx:pt idx="145">0.048484848484848402</cx:pt>
          <cx:pt idx="146">0.23529411764705799</cx:pt>
          <cx:pt idx="147">0.148148148148148</cx:pt>
          <cx:pt idx="148">0.14285714285714199</cx:pt>
          <cx:pt idx="149">0.145454545454545</cx:pt>
          <cx:pt idx="150">0.098360655737704902</cx:pt>
          <cx:pt idx="151">0.16250000000000001</cx:pt>
          <cx:pt idx="152">0.098484848484848397</cx:pt>
          <cx:pt idx="153">0.153153153153153</cx:pt>
          <cx:pt idx="154">0.136054421768707</cx:pt>
          <cx:pt idx="155">0.11267605633802801</cx:pt>
          <cx:pt idx="156">0.12</cx:pt>
          <cx:pt idx="157">0.24698795180722799</cx:pt>
          <cx:pt idx="158">0.0614035087719298</cx:pt>
          <cx:pt idx="159">0.13970588235294101</cx:pt>
          <cx:pt idx="160">0.15384615384615299</cx:pt>
          <cx:pt idx="161">0.0311111111111111</cx:pt>
          <cx:pt idx="162">0.15172413793103401</cx:pt>
          <cx:pt idx="163">0.086092715231788006</cx:pt>
          <cx:pt idx="164">0.207100591715976</cx:pt>
          <cx:pt idx="165">0.101941747572815</cx:pt>
          <cx:pt idx="166">0.15463917525773099</cx:pt>
          <cx:pt idx="167">0.225806451612903</cx:pt>
          <cx:pt idx="168">0.14110429447852699</cx:pt>
          <cx:pt idx="169">0.0941176470588235</cx:pt>
          <cx:pt idx="170">0.095238095238095205</cx:pt>
          <cx:pt idx="171">0.22794117647058801</cx:pt>
          <cx:pt idx="172">0.18699186991869901</cx:pt>
          <cx:pt idx="173">0.119205298013245</cx:pt>
          <cx:pt idx="174">0.15827338129496399</cx:pt>
          <cx:pt idx="175">0.139240506329113</cx:pt>
          <cx:pt idx="176">0.106796116504854</cx:pt>
          <cx:pt idx="177">0.10126582278481</cx:pt>
          <cx:pt idx="178">0.17499999999999999</cx:pt>
          <cx:pt idx="179">0.11184210526315699</cx:pt>
          <cx:pt idx="180">0.18421052631578899</cx:pt>
          <cx:pt idx="181">0.114503816793893</cx:pt>
          <cx:pt idx="182">0.109375</cx:pt>
          <cx:pt idx="183">0.087301587301587297</cx:pt>
          <cx:pt idx="184">0.11764705882352899</cx:pt>
          <cx:pt idx="185">0.21568627450980299</cx:pt>
          <cx:pt idx="186">0.13375796178343899</cx:pt>
          <cx:pt idx="187">0.090361445783132502</cx:pt>
          <cx:pt idx="188">0.29605263157894701</cx:pt>
          <cx:pt idx="189">0.13008130081300801</cx:pt>
          <cx:pt idx="190">0.098360655737704902</cx:pt>
          <cx:pt idx="191">0.135135135135135</cx:pt>
          <cx:pt idx="192">0.133333333333333</cx:pt>
          <cx:pt idx="193">0.212389380530973</cx:pt>
          <cx:pt idx="194">0.074999999999999997</cx:pt>
          <cx:pt idx="195">0.118518518518518</cx:pt>
          <cx:pt idx="196">0.077519379844961198</cx:pt>
          <cx:pt idx="197">0.13675213675213599</cx:pt>
          <cx:pt idx="198">0.18181818181818099</cx:pt>
          <cx:pt idx="199">0.064935064935064901</cx:pt>
          <cx:pt idx="200">0.083969465648854894</cx:pt>
          <cx:pt idx="201">0.206611570247933</cx:pt>
          <cx:pt idx="202">0.148148148148148</cx:pt>
          <cx:pt idx="203">0.125</cx:pt>
          <cx:pt idx="204">0.35416666666666602</cx:pt>
          <cx:pt idx="205">0.26373626373626302</cx:pt>
          <cx:pt idx="206">0.16666666666666599</cx:pt>
          <cx:pt idx="207">0.098214285714285698</cx:pt>
          <cx:pt idx="208">0.088888888888888795</cx:pt>
          <cx:pt idx="209">0.19327731092436901</cx:pt>
          <cx:pt idx="210">0.117117117117117</cx:pt>
          <cx:pt idx="211">0.049180327868852403</cx:pt>
          <cx:pt idx="212">0.068181818181818094</cx:pt>
          <cx:pt idx="213">0.063829787234042507</cx:pt>
          <cx:pt idx="214">0.097560975609756101</cx:pt>
          <cx:pt idx="215">0.17829457364341</cx:pt>
          <cx:pt idx="216">0.094736842105263105</cx:pt>
          <cx:pt idx="217">0.080808080808080801</cx:pt>
          <cx:pt idx="218">0.218487394957983</cx:pt>
          <cx:pt idx="219">0.097560975609756101</cx:pt>
          <cx:pt idx="220">0.122807017543859</cx:pt>
          <cx:pt idx="221">0.0769230769230769</cx:pt>
          <cx:pt idx="222">0.060344827586206899</cx:pt>
          <cx:pt idx="223">0.17894736842105199</cx:pt>
          <cx:pt idx="224">0.18811881188118801</cx:pt>
          <cx:pt idx="225">0.075757575757575704</cx:pt>
          <cx:pt idx="226">0.15517241379310301</cx:pt>
          <cx:pt idx="227">0.161016949152542</cx:pt>
          <cx:pt idx="228">0.089285714285714204</cx:pt>
          <cx:pt idx="229">0.26618705035971202</cx:pt>
          <cx:pt idx="230">0.31034482758620602</cx:pt>
          <cx:pt idx="231">0.072072072072072002</cx:pt>
          <cx:pt idx="232">0.132653061224489</cx:pt>
          <cx:pt idx="233">0.16279069767441801</cx:pt>
          <cx:pt idx="234">0.23076923076923</cx:pt>
          <cx:pt idx="235">0.19191919191919099</cx:pt>
          <cx:pt idx="236">0.065693430656934296</cx:pt>
          <cx:pt idx="237">0.25961538461538403</cx:pt>
          <cx:pt idx="238">0.164383561643835</cx:pt>
          <cx:pt idx="239">0.0454545454545454</cx:pt>
          <cx:pt idx="240">0.0804597701149425</cx:pt>
          <cx:pt idx="241">0.219512195121951</cx:pt>
          <cx:pt idx="242">0.10784313725490099</cx:pt>
          <cx:pt idx="243">0.051546391752577303</cx:pt>
          <cx:pt idx="244">0.119658119658119</cx:pt>
          <cx:pt idx="245">0.103092783505154</cx:pt>
          <cx:pt idx="246">0.15384615384615299</cx:pt>
          <cx:pt idx="247">0.14285714285714199</cx:pt>
          <cx:pt idx="248">0.094339622641509399</cx:pt>
          <cx:pt idx="249">0.12121212121212099</cx:pt>
          <cx:pt idx="250">0.13043478260869501</cx:pt>
          <cx:pt idx="251">0.23076923076923</cx:pt>
          <cx:pt idx="252">0.0816326530612244</cx:pt>
          <cx:pt idx="253">0.104651162790697</cx:pt>
          <cx:pt idx="254">0.085106382978723402</cx:pt>
          <cx:pt idx="255">0.18181818181818099</cx:pt>
          <cx:pt idx="256">0.115942028985507</cx:pt>
          <cx:pt idx="257">0.080000000000000002</cx:pt>
          <cx:pt idx="258">0.036496350364963501</cx:pt>
          <cx:pt idx="259">0.11340206185567001</cx:pt>
          <cx:pt idx="260">0.128205128205128</cx:pt>
          <cx:pt idx="261">0.24175824175824101</cx:pt>
          <cx:pt idx="262">0.17307692307692299</cx:pt>
          <cx:pt idx="263">0.077669902912621297</cx:pt>
          <cx:pt idx="264">0.0595238095238095</cx:pt>
          <cx:pt idx="265">0.0816326530612244</cx:pt>
          <cx:pt idx="266">0.081081081081081002</cx:pt>
          <cx:pt idx="267">0.113924050632911</cx:pt>
          <cx:pt idx="268">0.041095890410958902</cx:pt>
          <cx:pt idx="269">0.077669902912621297</cx:pt>
          <cx:pt idx="270">0.1125</cx:pt>
          <cx:pt idx="271">0.076086956521739094</cx:pt>
          <cx:pt idx="272">0.066666666666666596</cx:pt>
          <cx:pt idx="273">0.20481927710843301</cx:pt>
          <cx:pt idx="274">0.115384615384615</cx:pt>
          <cx:pt idx="275">0.068965517241379296</cx:pt>
          <cx:pt idx="276">0.123595505617977</cx:pt>
          <cx:pt idx="277">0.18421052631578899</cx:pt>
          <cx:pt idx="278">0.17708333333333301</cx:pt>
          <cx:pt idx="279">0.265822784810126</cx:pt>
          <cx:pt idx="280">0.052631578947368397</cx:pt>
          <cx:pt idx="281">0.107142857142857</cx:pt>
          <cx:pt idx="282">0.092592592592592504</cx:pt>
          <cx:pt idx="283">0.069306930693069299</cx:pt>
          <cx:pt idx="284">0.047619047619047603</cx:pt>
          <cx:pt idx="285">0.056603773584905599</cx:pt>
          <cx:pt idx="286">0.087499999999999994</cx:pt>
          <cx:pt idx="287">0.065420560747663503</cx:pt>
          <cx:pt idx="288">0.27272727272727199</cx:pt>
          <cx:pt idx="289">0.29411764705882298</cx:pt>
          <cx:pt idx="290">0.195402298850574</cx:pt>
          <cx:pt idx="291">0.20000000000000001</cx:pt>
          <cx:pt idx="292">0.20270270270270199</cx:pt>
          <cx:pt idx="293">0.151898734177215</cx:pt>
          <cx:pt idx="294">0.26086956521739102</cx:pt>
          <cx:pt idx="295">0.025974025974025899</cx:pt>
          <cx:pt idx="296">0.128571428571428</cx:pt>
          <cx:pt idx="297">0.081081081081081002</cx:pt>
          <cx:pt idx="298">0.21052631578947301</cx:pt>
          <cx:pt idx="299">0.056338028169014003</cx:pt>
          <cx:pt idx="300">0.40845070422535201</cx:pt>
          <cx:pt idx="301">0.125</cx:pt>
          <cx:pt idx="302">0.093023255813953404</cx:pt>
          <cx:pt idx="303">0.17647058823529399</cx:pt>
          <cx:pt idx="304">0.0769230769230769</cx:pt>
          <cx:pt idx="305">0.043478260869565202</cx:pt>
          <cx:pt idx="306">0.014492753623188401</cx:pt>
          <cx:pt idx="307">0.34722222222222199</cx:pt>
          <cx:pt idx="308">0.086956521739130405</cx:pt>
          <cx:pt idx="309">0.065573770491803199</cx:pt>
          <cx:pt idx="310">0.23076923076923</cx:pt>
          <cx:pt idx="311">0.028169014084507001</cx:pt>
          <cx:pt idx="312">0.123076923076923</cx:pt>
          <cx:pt idx="313">0.0945945945945946</cx:pt>
          <cx:pt idx="314">0.14492753623188401</cx:pt>
          <cx:pt idx="315">0.22535211267605601</cx:pt>
          <cx:pt idx="316">0.123076923076923</cx:pt>
          <cx:pt idx="317">0.150684931506849</cx:pt>
          <cx:pt idx="318">0.040540540540540501</cx:pt>
          <cx:pt idx="319">0.28000000000000003</cx:pt>
          <cx:pt idx="320">0.13559322033898299</cx:pt>
          <cx:pt idx="321">0.063291139240506306</cx:pt>
          <cx:pt idx="322">0.13793103448275801</cx:pt>
          <cx:pt idx="323">0.16666666666666599</cx:pt>
          <cx:pt idx="324">0.095890410958904104</cx:pt>
          <cx:pt idx="325">0.20000000000000001</cx:pt>
          <cx:pt idx="326">0.011904761904761901</cx:pt>
          <cx:pt idx="327">0.040000000000000001</cx:pt>
          <cx:pt idx="328">0.096774193548387094</cx:pt>
          <cx:pt idx="329">0.140350877192982</cx:pt>
          <cx:pt idx="330">0.121621621621621</cx:pt>
          <cx:pt idx="331">0.16</cx:pt>
          <cx:pt idx="332">0.18333333333333299</cx:pt>
          <cx:pt idx="333">0.068965517241379296</cx:pt>
          <cx:pt idx="334">0.20000000000000001</cx:pt>
          <cx:pt idx="335">0.18421052631578899</cx:pt>
          <cx:pt idx="336">0.068965517241379296</cx:pt>
          <cx:pt idx="337">0.125</cx:pt>
          <cx:pt idx="338">0.021739130434782601</cx:pt>
          <cx:pt idx="339">0.058823529411764698</cx:pt>
          <cx:pt idx="340">0.17307692307692299</cx:pt>
          <cx:pt idx="341">0.146341463414634</cx:pt>
          <cx:pt idx="342">0.14999999999999999</cx:pt>
          <cx:pt idx="343">0.20338983050847401</cx:pt>
          <cx:pt idx="344">0.078125</cx:pt>
          <cx:pt idx="345">0.125</cx:pt>
          <cx:pt idx="346">0.040540540540540501</cx:pt>
          <cx:pt idx="347">0.098039215686274495</cx:pt>
          <cx:pt idx="348">0.18181818181818099</cx:pt>
          <cx:pt idx="349">0.12</cx:pt>
          <cx:pt idx="350">0.18918918918918901</cx:pt>
          <cx:pt idx="351">0.057692307692307598</cx:pt>
          <cx:pt idx="352">0.13636363636363599</cx:pt>
          <cx:pt idx="353">0</cx:pt>
          <cx:pt idx="354">0.0454545454545454</cx:pt>
          <cx:pt idx="355">0.11111111111111099</cx:pt>
          <cx:pt idx="356">0.085714285714285701</cx:pt>
          <cx:pt idx="357">0.092307692307692299</cx:pt>
          <cx:pt idx="358">0.109090909090909</cx:pt>
          <cx:pt idx="359">0.10638297872340401</cx:pt>
          <cx:pt idx="360">0.17948717948717899</cx:pt>
          <cx:pt idx="361">0.0625</cx:pt>
          <cx:pt idx="362">0.093023255813953404</cx:pt>
          <cx:pt idx="363">0.074999999999999997</cx:pt>
          <cx:pt idx="364">0.066666666666666596</cx:pt>
          <cx:pt idx="365">0.075471698113207503</cx:pt>
          <cx:pt idx="366">0.050000000000000003</cx:pt>
          <cx:pt idx="367">0.0816326530612244</cx:pt>
          <cx:pt idx="368">0.10256410256410201</cx:pt>
          <cx:pt idx="369">0.0408163265306122</cx:pt>
          <cx:pt idx="370">0.075471698113207503</cx:pt>
          <cx:pt idx="371">0.0204081632653061</cx:pt>
          <cx:pt idx="372">0.042553191489361701</cx:pt>
          <cx:pt idx="373">0.12698412698412601</cx:pt>
          <cx:pt idx="374">0.135135135135135</cx:pt>
          <cx:pt idx="375">0.046511627906976702</cx:pt>
          <cx:pt idx="376">0.14285714285714199</cx:pt>
          <cx:pt idx="377">0.073170731707316999</cx:pt>
          <cx:pt idx="378">0.024390243902439001</cx:pt>
          <cx:pt idx="379">0.21052631578947301</cx:pt>
          <cx:pt idx="380">0.028571428571428501</cx:pt>
          <cx:pt idx="381">0.24324324324324301</cx:pt>
          <cx:pt idx="382">0.13888888888888801</cx:pt>
          <cx:pt idx="383">0.214285714285714</cx:pt>
          <cx:pt idx="384">0.17647058823529399</cx:pt>
          <cx:pt idx="385">0.054054054054054002</cx:pt>
          <cx:pt idx="386">0.09375</cx:pt>
          <cx:pt idx="387">0.080000000000000002</cx:pt>
          <cx:pt idx="388">0.055555555555555497</cx:pt>
          <cx:pt idx="389">0.060606060606060601</cx:pt>
          <cx:pt idx="390">0.18181818181818099</cx:pt>
          <cx:pt idx="391">0.24242424242424199</cx:pt>
          <cx:pt idx="392">0.14999999999999999</cx:pt>
          <cx:pt idx="393">0.5</cx:pt>
          <cx:pt idx="394">0.31578947368421001</cx:pt>
          <cx:pt idx="395">0.47058823529411697</cx:pt>
          <cx:pt idx="396">0.105263157894736</cx:pt>
          <cx:pt idx="397">0.28000000000000003</cx:pt>
          <cx:pt idx="398">0.052631578947368397</cx:pt>
          <cx:pt idx="399">0.13043478260869501</cx:pt>
          <cx:pt idx="400">0.105263157894736</cx:pt>
          <cx:pt idx="401">0.11111111111111099</cx:pt>
          <cx:pt idx="402">0.11111111111111099</cx:pt>
          <cx:pt idx="403">0.38461538461538403</cx:pt>
          <cx:pt idx="404">0.41666666666666602</cx:pt>
          <cx:pt idx="405">0.20000000000000001</cx:pt>
          <cx:pt idx="406">0.33333333333333298</cx:pt>
          <cx:pt idx="407">0.5</cx:pt>
        </cx:lvl>
      </cx:numDim>
    </cx:data>
  </cx:chartData>
  <cx:chart>
    <cx:plotArea>
      <cx:plotAreaRegion>
        <cx:plotSurface>
          <cx:spPr>
            <a:ln w="15875">
              <a:solidFill>
                <a:schemeClr val="tx1"/>
              </a:solidFill>
            </a:ln>
          </cx:spPr>
        </cx:plotSurface>
        <cx:series layoutId="boxWhisker" uniqueId="{36985C46-DD4C-4478-989A-5BD6036FB6E5}">
          <cx:tx>
            <cx:txData>
              <cx:f>selective_expression_ratio!$A$1</cx:f>
              <cx:v>LUSC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FA8026DA-56F6-4309-B095-A4495B5F1578}">
          <cx:tx>
            <cx:txData>
              <cx:f>selective_expression_ratio!$B$1</cx:f>
              <cx:v>GBM</cx:v>
            </cx:txData>
          </cx:tx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FD1EB3D5-6272-484B-949C-AF74A83F6EA7}">
          <cx:tx>
            <cx:txData>
              <cx:f>selective_expression_ratio!$C$1</cx:f>
              <cx:v>BLCA</cx:v>
            </cx:txData>
          </cx:tx>
          <cx:dataId val="2"/>
          <cx:layoutPr>
            <cx:visibility meanLine="0" meanMarker="1" nonoutliers="0" outliers="1"/>
            <cx:statistics quartileMethod="exclusive"/>
          </cx:layoutPr>
        </cx:series>
      </cx:plotAreaRegion>
      <cx:axis id="0" hidden="1">
        <cx:catScaling gapWidth="0.300000012"/>
        <cx:tickLabels/>
      </cx:axis>
      <cx:axis id="1">
        <cx:valScaling max="0.60000000000000009"/>
        <cx:majorTickMarks type="out"/>
        <cx:tickLabels/>
        <cx:spPr>
          <a:ln w="3175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800">
                <a:solidFill>
                  <a:schemeClr val="tx1"/>
                </a:solidFill>
              </a:defRPr>
            </a:pPr>
            <a:endParaRPr lang="zh-CN" altLang="en-US" sz="800" b="0" i="0" u="none" strike="noStrike" baseline="0">
              <a:solidFill>
                <a:schemeClr val="tx1"/>
              </a:solidFill>
              <a:latin typeface="Calibri" panose="020F0502020204030204"/>
              <a:ea typeface="等线" panose="02010600030101010101" pitchFamily="2" charset="-122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6124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7620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0754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3296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0587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6304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577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0543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5961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2735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6456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759EDD-B4FC-442C-9153-BE4B4F8F14CD}" type="datetimeFigureOut">
              <a:rPr lang="zh-CN" altLang="en-US" smtClean="0"/>
              <a:t>2022/0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8839B-668B-45C4-BCD3-C76530D2E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0413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sv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sv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microsoft.com/office/2014/relationships/chartEx" Target="../charts/chartEx1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EB01E280-162E-491E-BB70-B7437570B277}"/>
              </a:ext>
            </a:extLst>
          </p:cNvPr>
          <p:cNvSpPr/>
          <p:nvPr/>
        </p:nvSpPr>
        <p:spPr>
          <a:xfrm>
            <a:off x="1540839" y="5465055"/>
            <a:ext cx="3570137" cy="8236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. Evaluation metrics for multi-filtering strategy within three validation datasets (LUSC, BLCA and GBM)</a:t>
            </a:r>
          </a:p>
        </p:txBody>
      </p:sp>
      <p:pic>
        <p:nvPicPr>
          <p:cNvPr id="95" name="图片 94">
            <a:extLst>
              <a:ext uri="{FF2B5EF4-FFF2-40B4-BE49-F238E27FC236}">
                <a16:creationId xmlns:a16="http://schemas.microsoft.com/office/drawing/2014/main" id="{07F14610-6CFA-42C8-BD6F-4233DE839D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V="1">
            <a:off x="3975851" y="4037426"/>
            <a:ext cx="1013807" cy="179267"/>
          </a:xfrm>
          <a:prstGeom prst="rect">
            <a:avLst/>
          </a:prstGeom>
        </p:spPr>
      </p:pic>
      <p:pic>
        <p:nvPicPr>
          <p:cNvPr id="96" name="图片 95">
            <a:extLst>
              <a:ext uri="{FF2B5EF4-FFF2-40B4-BE49-F238E27FC236}">
                <a16:creationId xmlns:a16="http://schemas.microsoft.com/office/drawing/2014/main" id="{2AAAB80E-B6C1-4090-A053-F580A59A6F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72130" y="3118333"/>
            <a:ext cx="1013171" cy="52310"/>
          </a:xfrm>
          <a:prstGeom prst="rect">
            <a:avLst/>
          </a:prstGeom>
        </p:spPr>
      </p:pic>
      <p:grpSp>
        <p:nvGrpSpPr>
          <p:cNvPr id="97" name="组合 96">
            <a:extLst>
              <a:ext uri="{FF2B5EF4-FFF2-40B4-BE49-F238E27FC236}">
                <a16:creationId xmlns:a16="http://schemas.microsoft.com/office/drawing/2014/main" id="{3EC67DF6-77D6-4759-8428-784865F3E490}"/>
              </a:ext>
            </a:extLst>
          </p:cNvPr>
          <p:cNvGrpSpPr/>
          <p:nvPr/>
        </p:nvGrpSpPr>
        <p:grpSpPr>
          <a:xfrm>
            <a:off x="1375047" y="2715789"/>
            <a:ext cx="3689084" cy="2474586"/>
            <a:chOff x="-565682" y="3017547"/>
            <a:chExt cx="3689084" cy="2474586"/>
          </a:xfrm>
        </p:grpSpPr>
        <p:pic>
          <p:nvPicPr>
            <p:cNvPr id="98" name="图片 97">
              <a:extLst>
                <a:ext uri="{FF2B5EF4-FFF2-40B4-BE49-F238E27FC236}">
                  <a16:creationId xmlns:a16="http://schemas.microsoft.com/office/drawing/2014/main" id="{69F00231-6DD7-4DFE-B5F5-5FC87090AA1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52531" y="3196236"/>
              <a:ext cx="1025453" cy="275371"/>
            </a:xfrm>
            <a:prstGeom prst="rect">
              <a:avLst/>
            </a:prstGeom>
          </p:spPr>
        </p:pic>
        <p:pic>
          <p:nvPicPr>
            <p:cNvPr id="99" name="图片 98">
              <a:extLst>
                <a:ext uri="{FF2B5EF4-FFF2-40B4-BE49-F238E27FC236}">
                  <a16:creationId xmlns:a16="http://schemas.microsoft.com/office/drawing/2014/main" id="{9F0C38D8-5BC6-4E96-B7C5-AFA66A40E5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83562"/>
            <a:stretch/>
          </p:blipFill>
          <p:spPr>
            <a:xfrm flipV="1">
              <a:off x="852530" y="4062221"/>
              <a:ext cx="1025453" cy="198105"/>
            </a:xfrm>
            <a:prstGeom prst="rect">
              <a:avLst/>
            </a:prstGeom>
          </p:spPr>
        </p:pic>
        <p:sp>
          <p:nvSpPr>
            <p:cNvPr id="100" name="矩形 99">
              <a:extLst>
                <a:ext uri="{FF2B5EF4-FFF2-40B4-BE49-F238E27FC236}">
                  <a16:creationId xmlns:a16="http://schemas.microsoft.com/office/drawing/2014/main" id="{CF10B78C-154F-4DF7-88A6-F3AE74935715}"/>
                </a:ext>
              </a:extLst>
            </p:cNvPr>
            <p:cNvSpPr/>
            <p:nvPr/>
          </p:nvSpPr>
          <p:spPr>
            <a:xfrm rot="16200000">
              <a:off x="780703" y="3677207"/>
              <a:ext cx="355252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w</a:t>
              </a:r>
            </a:p>
          </p:txBody>
        </p:sp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7A688126-2508-468D-8394-9F8DC7B4DEB5}"/>
                </a:ext>
              </a:extLst>
            </p:cNvPr>
            <p:cNvSpPr/>
            <p:nvPr/>
          </p:nvSpPr>
          <p:spPr>
            <a:xfrm rot="16200000">
              <a:off x="861294" y="3679801"/>
              <a:ext cx="590334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-allelic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DB6A88F6-5E9D-4980-913F-B7618726520B}"/>
                </a:ext>
              </a:extLst>
            </p:cNvPr>
            <p:cNvSpPr/>
            <p:nvPr/>
          </p:nvSpPr>
          <p:spPr>
            <a:xfrm rot="16200000">
              <a:off x="1087910" y="3677207"/>
              <a:ext cx="530018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edit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id="{A0775730-B9AD-40A1-AA33-6A6A49A2E775}"/>
                </a:ext>
              </a:extLst>
            </p:cNvPr>
            <p:cNvSpPr/>
            <p:nvPr/>
          </p:nvSpPr>
          <p:spPr>
            <a:xfrm rot="16200000">
              <a:off x="1198412" y="3677207"/>
              <a:ext cx="751118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munoglobulin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矩形 103">
              <a:extLst>
                <a:ext uri="{FF2B5EF4-FFF2-40B4-BE49-F238E27FC236}">
                  <a16:creationId xmlns:a16="http://schemas.microsoft.com/office/drawing/2014/main" id="{771620B8-2E31-4D9A-9805-295FF6478AD6}"/>
                </a:ext>
              </a:extLst>
            </p:cNvPr>
            <p:cNvSpPr/>
            <p:nvPr/>
          </p:nvSpPr>
          <p:spPr>
            <a:xfrm rot="16200000">
              <a:off x="1578716" y="3645799"/>
              <a:ext cx="413869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LA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5" name="图片 104">
              <a:extLst>
                <a:ext uri="{FF2B5EF4-FFF2-40B4-BE49-F238E27FC236}">
                  <a16:creationId xmlns:a16="http://schemas.microsoft.com/office/drawing/2014/main" id="{69FF8CFC-0F62-4AE9-B83D-6960FABCA3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37071"/>
            <a:stretch/>
          </p:blipFill>
          <p:spPr>
            <a:xfrm flipV="1">
              <a:off x="852530" y="4404982"/>
              <a:ext cx="1025453" cy="758395"/>
            </a:xfrm>
            <a:prstGeom prst="rect">
              <a:avLst/>
            </a:prstGeom>
          </p:spPr>
        </p:pic>
        <p:pic>
          <p:nvPicPr>
            <p:cNvPr id="106" name="图片 105">
              <a:extLst>
                <a:ext uri="{FF2B5EF4-FFF2-40B4-BE49-F238E27FC236}">
                  <a16:creationId xmlns:a16="http://schemas.microsoft.com/office/drawing/2014/main" id="{0C5813A2-12B5-4C77-96E5-D75400978AE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921773" y="4269897"/>
              <a:ext cx="49793" cy="130594"/>
            </a:xfrm>
            <a:prstGeom prst="rect">
              <a:avLst/>
            </a:prstGeom>
          </p:spPr>
        </p:pic>
        <p:pic>
          <p:nvPicPr>
            <p:cNvPr id="107" name="图片 106">
              <a:extLst>
                <a:ext uri="{FF2B5EF4-FFF2-40B4-BE49-F238E27FC236}">
                  <a16:creationId xmlns:a16="http://schemas.microsoft.com/office/drawing/2014/main" id="{DBFB3A0A-4AF1-40FD-A660-3DC318255A2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1128669" y="4267801"/>
              <a:ext cx="49793" cy="130594"/>
            </a:xfrm>
            <a:prstGeom prst="rect">
              <a:avLst/>
            </a:prstGeom>
          </p:spPr>
        </p:pic>
        <p:pic>
          <p:nvPicPr>
            <p:cNvPr id="108" name="图片 107">
              <a:extLst>
                <a:ext uri="{FF2B5EF4-FFF2-40B4-BE49-F238E27FC236}">
                  <a16:creationId xmlns:a16="http://schemas.microsoft.com/office/drawing/2014/main" id="{F44EDA28-3B89-4915-BA44-28CEB51C694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1340360" y="4265706"/>
              <a:ext cx="49793" cy="130594"/>
            </a:xfrm>
            <a:prstGeom prst="rect">
              <a:avLst/>
            </a:prstGeom>
          </p:spPr>
        </p:pic>
        <p:pic>
          <p:nvPicPr>
            <p:cNvPr id="109" name="图片 108">
              <a:extLst>
                <a:ext uri="{FF2B5EF4-FFF2-40B4-BE49-F238E27FC236}">
                  <a16:creationId xmlns:a16="http://schemas.microsoft.com/office/drawing/2014/main" id="{D94E28F9-DE05-49B2-8961-3C89BBB6324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1545613" y="4264226"/>
              <a:ext cx="49793" cy="130594"/>
            </a:xfrm>
            <a:prstGeom prst="rect">
              <a:avLst/>
            </a:prstGeom>
          </p:spPr>
        </p:pic>
        <p:pic>
          <p:nvPicPr>
            <p:cNvPr id="110" name="图片 109">
              <a:extLst>
                <a:ext uri="{FF2B5EF4-FFF2-40B4-BE49-F238E27FC236}">
                  <a16:creationId xmlns:a16="http://schemas.microsoft.com/office/drawing/2014/main" id="{BD737531-C5F7-40A7-9816-D88CD11E2C0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1749120" y="4264225"/>
              <a:ext cx="49793" cy="130594"/>
            </a:xfrm>
            <a:prstGeom prst="rect">
              <a:avLst/>
            </a:prstGeom>
          </p:spPr>
        </p:pic>
        <p:sp>
          <p:nvSpPr>
            <p:cNvPr id="111" name="矩形 110">
              <a:extLst>
                <a:ext uri="{FF2B5EF4-FFF2-40B4-BE49-F238E27FC236}">
                  <a16:creationId xmlns:a16="http://schemas.microsoft.com/office/drawing/2014/main" id="{A2E169E7-E342-4F83-A8B0-D55FF71E38D4}"/>
                </a:ext>
              </a:extLst>
            </p:cNvPr>
            <p:cNvSpPr/>
            <p:nvPr/>
          </p:nvSpPr>
          <p:spPr>
            <a:xfrm>
              <a:off x="1146567" y="3017547"/>
              <a:ext cx="413869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CA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矩形 111">
              <a:extLst>
                <a:ext uri="{FF2B5EF4-FFF2-40B4-BE49-F238E27FC236}">
                  <a16:creationId xmlns:a16="http://schemas.microsoft.com/office/drawing/2014/main" id="{2864CAE9-ABF3-4E81-ACE3-FF39BA8593A0}"/>
                </a:ext>
              </a:extLst>
            </p:cNvPr>
            <p:cNvSpPr/>
            <p:nvPr/>
          </p:nvSpPr>
          <p:spPr>
            <a:xfrm rot="16200000">
              <a:off x="-923720" y="3657039"/>
              <a:ext cx="900741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-filtering status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矩形 112">
              <a:extLst>
                <a:ext uri="{FF2B5EF4-FFF2-40B4-BE49-F238E27FC236}">
                  <a16:creationId xmlns:a16="http://schemas.microsoft.com/office/drawing/2014/main" id="{DC5A9532-09EB-4C58-957A-8FEDB71FA169}"/>
                </a:ext>
              </a:extLst>
            </p:cNvPr>
            <p:cNvSpPr/>
            <p:nvPr/>
          </p:nvSpPr>
          <p:spPr>
            <a:xfrm>
              <a:off x="-399890" y="3162897"/>
              <a:ext cx="3523292" cy="232923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矩形 113">
              <a:extLst>
                <a:ext uri="{FF2B5EF4-FFF2-40B4-BE49-F238E27FC236}">
                  <a16:creationId xmlns:a16="http://schemas.microsoft.com/office/drawing/2014/main" id="{EF672D19-A7C5-4272-A39F-C36DD58F3CCD}"/>
                </a:ext>
              </a:extLst>
            </p:cNvPr>
            <p:cNvSpPr/>
            <p:nvPr/>
          </p:nvSpPr>
          <p:spPr>
            <a:xfrm>
              <a:off x="782788" y="3162898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582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矩形 114">
              <a:extLst>
                <a:ext uri="{FF2B5EF4-FFF2-40B4-BE49-F238E27FC236}">
                  <a16:creationId xmlns:a16="http://schemas.microsoft.com/office/drawing/2014/main" id="{55A29BA1-73C6-419C-8F83-40051B945FC2}"/>
                </a:ext>
              </a:extLst>
            </p:cNvPr>
            <p:cNvSpPr/>
            <p:nvPr/>
          </p:nvSpPr>
          <p:spPr>
            <a:xfrm>
              <a:off x="991376" y="3182755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572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矩形 115">
              <a:extLst>
                <a:ext uri="{FF2B5EF4-FFF2-40B4-BE49-F238E27FC236}">
                  <a16:creationId xmlns:a16="http://schemas.microsoft.com/office/drawing/2014/main" id="{159FD05D-CFE3-4AE3-8DCB-668654645C9E}"/>
                </a:ext>
              </a:extLst>
            </p:cNvPr>
            <p:cNvSpPr/>
            <p:nvPr/>
          </p:nvSpPr>
          <p:spPr>
            <a:xfrm>
              <a:off x="1196907" y="3215679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557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矩形 116">
              <a:extLst>
                <a:ext uri="{FF2B5EF4-FFF2-40B4-BE49-F238E27FC236}">
                  <a16:creationId xmlns:a16="http://schemas.microsoft.com/office/drawing/2014/main" id="{106B9B36-B7EC-42A5-AF51-CB95E45B12C8}"/>
                </a:ext>
              </a:extLst>
            </p:cNvPr>
            <p:cNvSpPr/>
            <p:nvPr/>
          </p:nvSpPr>
          <p:spPr>
            <a:xfrm>
              <a:off x="1405495" y="3248923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541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矩形 117">
              <a:extLst>
                <a:ext uri="{FF2B5EF4-FFF2-40B4-BE49-F238E27FC236}">
                  <a16:creationId xmlns:a16="http://schemas.microsoft.com/office/drawing/2014/main" id="{70B450D4-EFE9-428E-8D9C-8E2B362CD131}"/>
                </a:ext>
              </a:extLst>
            </p:cNvPr>
            <p:cNvSpPr/>
            <p:nvPr/>
          </p:nvSpPr>
          <p:spPr>
            <a:xfrm>
              <a:off x="1611026" y="3324741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502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矩形 118">
              <a:extLst>
                <a:ext uri="{FF2B5EF4-FFF2-40B4-BE49-F238E27FC236}">
                  <a16:creationId xmlns:a16="http://schemas.microsoft.com/office/drawing/2014/main" id="{F94D20A4-6AF4-4B5A-A964-CE29D1BFCE28}"/>
                </a:ext>
              </a:extLst>
            </p:cNvPr>
            <p:cNvSpPr/>
            <p:nvPr/>
          </p:nvSpPr>
          <p:spPr>
            <a:xfrm>
              <a:off x="767404" y="5085412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45650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矩形 119">
              <a:extLst>
                <a:ext uri="{FF2B5EF4-FFF2-40B4-BE49-F238E27FC236}">
                  <a16:creationId xmlns:a16="http://schemas.microsoft.com/office/drawing/2014/main" id="{E34F41CC-2ABE-4E7B-9BA4-930002171B4B}"/>
                </a:ext>
              </a:extLst>
            </p:cNvPr>
            <p:cNvSpPr/>
            <p:nvPr/>
          </p:nvSpPr>
          <p:spPr>
            <a:xfrm>
              <a:off x="976167" y="5034555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22696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矩形 120">
              <a:extLst>
                <a:ext uri="{FF2B5EF4-FFF2-40B4-BE49-F238E27FC236}">
                  <a16:creationId xmlns:a16="http://schemas.microsoft.com/office/drawing/2014/main" id="{EFA9769A-AFF3-4B87-9B8E-4ECB688A9987}"/>
                </a:ext>
              </a:extLst>
            </p:cNvPr>
            <p:cNvSpPr/>
            <p:nvPr/>
          </p:nvSpPr>
          <p:spPr>
            <a:xfrm>
              <a:off x="1184345" y="4905733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44783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矩形 121">
              <a:extLst>
                <a:ext uri="{FF2B5EF4-FFF2-40B4-BE49-F238E27FC236}">
                  <a16:creationId xmlns:a16="http://schemas.microsoft.com/office/drawing/2014/main" id="{765DAAA9-0696-4A79-81D0-7C31EF24CD13}"/>
                </a:ext>
              </a:extLst>
            </p:cNvPr>
            <p:cNvSpPr/>
            <p:nvPr/>
          </p:nvSpPr>
          <p:spPr>
            <a:xfrm>
              <a:off x="1386853" y="4495558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4707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矩形 122">
              <a:extLst>
                <a:ext uri="{FF2B5EF4-FFF2-40B4-BE49-F238E27FC236}">
                  <a16:creationId xmlns:a16="http://schemas.microsoft.com/office/drawing/2014/main" id="{A1F61F43-C040-4D9B-8FD1-D7816F26F050}"/>
                </a:ext>
              </a:extLst>
            </p:cNvPr>
            <p:cNvSpPr/>
            <p:nvPr/>
          </p:nvSpPr>
          <p:spPr>
            <a:xfrm>
              <a:off x="1598607" y="4424958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72821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4" name="组合 123">
            <a:extLst>
              <a:ext uri="{FF2B5EF4-FFF2-40B4-BE49-F238E27FC236}">
                <a16:creationId xmlns:a16="http://schemas.microsoft.com/office/drawing/2014/main" id="{5FA7F8EC-0383-4C05-BAED-12D51AC238A5}"/>
              </a:ext>
            </a:extLst>
          </p:cNvPr>
          <p:cNvGrpSpPr/>
          <p:nvPr/>
        </p:nvGrpSpPr>
        <p:grpSpPr>
          <a:xfrm>
            <a:off x="3878182" y="2720035"/>
            <a:ext cx="1232794" cy="1620397"/>
            <a:chOff x="767039" y="3021793"/>
            <a:chExt cx="1232794" cy="1620397"/>
          </a:xfrm>
        </p:grpSpPr>
        <p:pic>
          <p:nvPicPr>
            <p:cNvPr id="125" name="图片 124">
              <a:extLst>
                <a:ext uri="{FF2B5EF4-FFF2-40B4-BE49-F238E27FC236}">
                  <a16:creationId xmlns:a16="http://schemas.microsoft.com/office/drawing/2014/main" id="{A7EFC9E5-3433-4814-A7F1-4DE88DBB26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83562"/>
            <a:stretch/>
          </p:blipFill>
          <p:spPr>
            <a:xfrm flipV="1">
              <a:off x="858656" y="4077261"/>
              <a:ext cx="1025453" cy="118498"/>
            </a:xfrm>
            <a:prstGeom prst="rect">
              <a:avLst/>
            </a:prstGeom>
          </p:spPr>
        </p:pic>
        <p:sp>
          <p:nvSpPr>
            <p:cNvPr id="126" name="矩形 125">
              <a:extLst>
                <a:ext uri="{FF2B5EF4-FFF2-40B4-BE49-F238E27FC236}">
                  <a16:creationId xmlns:a16="http://schemas.microsoft.com/office/drawing/2014/main" id="{68DBDAEF-D858-4889-B075-DCB29EE54AB4}"/>
                </a:ext>
              </a:extLst>
            </p:cNvPr>
            <p:cNvSpPr/>
            <p:nvPr/>
          </p:nvSpPr>
          <p:spPr>
            <a:xfrm rot="16200000">
              <a:off x="780703" y="3677207"/>
              <a:ext cx="355252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w</a:t>
              </a:r>
            </a:p>
          </p:txBody>
        </p:sp>
        <p:sp>
          <p:nvSpPr>
            <p:cNvPr id="127" name="矩形 126">
              <a:extLst>
                <a:ext uri="{FF2B5EF4-FFF2-40B4-BE49-F238E27FC236}">
                  <a16:creationId xmlns:a16="http://schemas.microsoft.com/office/drawing/2014/main" id="{3B8880C6-3A76-46A3-8A4C-11EB708D02E3}"/>
                </a:ext>
              </a:extLst>
            </p:cNvPr>
            <p:cNvSpPr/>
            <p:nvPr/>
          </p:nvSpPr>
          <p:spPr>
            <a:xfrm rot="16200000">
              <a:off x="861294" y="3679801"/>
              <a:ext cx="590334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-allelic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矩形 127">
              <a:extLst>
                <a:ext uri="{FF2B5EF4-FFF2-40B4-BE49-F238E27FC236}">
                  <a16:creationId xmlns:a16="http://schemas.microsoft.com/office/drawing/2014/main" id="{435C1445-BCA2-4447-8FA4-6938B60B9703}"/>
                </a:ext>
              </a:extLst>
            </p:cNvPr>
            <p:cNvSpPr/>
            <p:nvPr/>
          </p:nvSpPr>
          <p:spPr>
            <a:xfrm rot="16200000">
              <a:off x="1087910" y="3677207"/>
              <a:ext cx="530018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edit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矩形 128">
              <a:extLst>
                <a:ext uri="{FF2B5EF4-FFF2-40B4-BE49-F238E27FC236}">
                  <a16:creationId xmlns:a16="http://schemas.microsoft.com/office/drawing/2014/main" id="{C4075F59-6F87-4E5E-B7CC-273B98F48615}"/>
                </a:ext>
              </a:extLst>
            </p:cNvPr>
            <p:cNvSpPr/>
            <p:nvPr/>
          </p:nvSpPr>
          <p:spPr>
            <a:xfrm rot="16200000">
              <a:off x="1198412" y="3677207"/>
              <a:ext cx="751118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munoglobulin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矩形 129">
              <a:extLst>
                <a:ext uri="{FF2B5EF4-FFF2-40B4-BE49-F238E27FC236}">
                  <a16:creationId xmlns:a16="http://schemas.microsoft.com/office/drawing/2014/main" id="{A451BB4B-A385-474E-AFCF-D7B170CF9589}"/>
                </a:ext>
              </a:extLst>
            </p:cNvPr>
            <p:cNvSpPr/>
            <p:nvPr/>
          </p:nvSpPr>
          <p:spPr>
            <a:xfrm rot="16200000">
              <a:off x="1578716" y="3645799"/>
              <a:ext cx="413869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LA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1" name="图片 130">
              <a:extLst>
                <a:ext uri="{FF2B5EF4-FFF2-40B4-BE49-F238E27FC236}">
                  <a16:creationId xmlns:a16="http://schemas.microsoft.com/office/drawing/2014/main" id="{CEF5F6EE-E835-4555-AA83-F8495932340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929744" y="4210959"/>
              <a:ext cx="49793" cy="130594"/>
            </a:xfrm>
            <a:prstGeom prst="rect">
              <a:avLst/>
            </a:prstGeom>
          </p:spPr>
        </p:pic>
        <p:pic>
          <p:nvPicPr>
            <p:cNvPr id="132" name="图片 131">
              <a:extLst>
                <a:ext uri="{FF2B5EF4-FFF2-40B4-BE49-F238E27FC236}">
                  <a16:creationId xmlns:a16="http://schemas.microsoft.com/office/drawing/2014/main" id="{81BCDCE3-55EE-4892-856B-428A2FB0283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1136640" y="4208863"/>
              <a:ext cx="49793" cy="130594"/>
            </a:xfrm>
            <a:prstGeom prst="rect">
              <a:avLst/>
            </a:prstGeom>
          </p:spPr>
        </p:pic>
        <p:pic>
          <p:nvPicPr>
            <p:cNvPr id="133" name="图片 132">
              <a:extLst>
                <a:ext uri="{FF2B5EF4-FFF2-40B4-BE49-F238E27FC236}">
                  <a16:creationId xmlns:a16="http://schemas.microsoft.com/office/drawing/2014/main" id="{46D31161-2C09-4F41-B3AA-EC5209848BD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1348331" y="4206768"/>
              <a:ext cx="49793" cy="130594"/>
            </a:xfrm>
            <a:prstGeom prst="rect">
              <a:avLst/>
            </a:prstGeom>
          </p:spPr>
        </p:pic>
        <p:pic>
          <p:nvPicPr>
            <p:cNvPr id="134" name="图片 133">
              <a:extLst>
                <a:ext uri="{FF2B5EF4-FFF2-40B4-BE49-F238E27FC236}">
                  <a16:creationId xmlns:a16="http://schemas.microsoft.com/office/drawing/2014/main" id="{947BB866-5FEF-46AA-AC05-375E47744B1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1553584" y="4205288"/>
              <a:ext cx="49793" cy="130594"/>
            </a:xfrm>
            <a:prstGeom prst="rect">
              <a:avLst/>
            </a:prstGeom>
          </p:spPr>
        </p:pic>
        <p:pic>
          <p:nvPicPr>
            <p:cNvPr id="135" name="图片 134">
              <a:extLst>
                <a:ext uri="{FF2B5EF4-FFF2-40B4-BE49-F238E27FC236}">
                  <a16:creationId xmlns:a16="http://schemas.microsoft.com/office/drawing/2014/main" id="{5CA6FA4D-1D16-449A-AA15-D73DF6CD11E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10484329" flipV="1">
              <a:off x="1757091" y="4205287"/>
              <a:ext cx="49793" cy="130594"/>
            </a:xfrm>
            <a:prstGeom prst="rect">
              <a:avLst/>
            </a:prstGeom>
          </p:spPr>
        </p:pic>
        <p:sp>
          <p:nvSpPr>
            <p:cNvPr id="136" name="矩形 135">
              <a:extLst>
                <a:ext uri="{FF2B5EF4-FFF2-40B4-BE49-F238E27FC236}">
                  <a16:creationId xmlns:a16="http://schemas.microsoft.com/office/drawing/2014/main" id="{EB53F10F-EACF-4584-BE28-72182E832F94}"/>
                </a:ext>
              </a:extLst>
            </p:cNvPr>
            <p:cNvSpPr/>
            <p:nvPr/>
          </p:nvSpPr>
          <p:spPr>
            <a:xfrm>
              <a:off x="1184407" y="3021793"/>
              <a:ext cx="413869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BM</a:t>
              </a:r>
              <a:endParaRPr lang="zh-CN" alt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矩形 136">
              <a:extLst>
                <a:ext uri="{FF2B5EF4-FFF2-40B4-BE49-F238E27FC236}">
                  <a16:creationId xmlns:a16="http://schemas.microsoft.com/office/drawing/2014/main" id="{065287BC-9F5A-449A-BB97-4158075F4CC4}"/>
                </a:ext>
              </a:extLst>
            </p:cNvPr>
            <p:cNvSpPr/>
            <p:nvPr/>
          </p:nvSpPr>
          <p:spPr>
            <a:xfrm>
              <a:off x="786877" y="3293854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18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矩形 137">
              <a:extLst>
                <a:ext uri="{FF2B5EF4-FFF2-40B4-BE49-F238E27FC236}">
                  <a16:creationId xmlns:a16="http://schemas.microsoft.com/office/drawing/2014/main" id="{67B449B1-4166-41C3-973F-40E0403C4C2E}"/>
                </a:ext>
              </a:extLst>
            </p:cNvPr>
            <p:cNvSpPr/>
            <p:nvPr/>
          </p:nvSpPr>
          <p:spPr>
            <a:xfrm>
              <a:off x="989496" y="3298142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18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矩形 138">
              <a:extLst>
                <a:ext uri="{FF2B5EF4-FFF2-40B4-BE49-F238E27FC236}">
                  <a16:creationId xmlns:a16="http://schemas.microsoft.com/office/drawing/2014/main" id="{198585BE-38DE-4616-8BEC-F80FB59209B9}"/>
                </a:ext>
              </a:extLst>
            </p:cNvPr>
            <p:cNvSpPr/>
            <p:nvPr/>
          </p:nvSpPr>
          <p:spPr>
            <a:xfrm>
              <a:off x="1194193" y="3298859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16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矩形 139">
              <a:extLst>
                <a:ext uri="{FF2B5EF4-FFF2-40B4-BE49-F238E27FC236}">
                  <a16:creationId xmlns:a16="http://schemas.microsoft.com/office/drawing/2014/main" id="{5F6D7A2A-A64D-4471-B878-F9615F21632B}"/>
                </a:ext>
              </a:extLst>
            </p:cNvPr>
            <p:cNvSpPr/>
            <p:nvPr/>
          </p:nvSpPr>
          <p:spPr>
            <a:xfrm>
              <a:off x="1405602" y="3323802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07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矩形 140">
              <a:extLst>
                <a:ext uri="{FF2B5EF4-FFF2-40B4-BE49-F238E27FC236}">
                  <a16:creationId xmlns:a16="http://schemas.microsoft.com/office/drawing/2014/main" id="{D1C5FD6E-10EE-47A5-B48F-A040AD4D02FF}"/>
                </a:ext>
              </a:extLst>
            </p:cNvPr>
            <p:cNvSpPr/>
            <p:nvPr/>
          </p:nvSpPr>
          <p:spPr>
            <a:xfrm>
              <a:off x="1610164" y="3334600"/>
              <a:ext cx="34282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00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矩形 141">
              <a:extLst>
                <a:ext uri="{FF2B5EF4-FFF2-40B4-BE49-F238E27FC236}">
                  <a16:creationId xmlns:a16="http://schemas.microsoft.com/office/drawing/2014/main" id="{B6BC9E12-0AB7-473F-9544-DC159826CD81}"/>
                </a:ext>
              </a:extLst>
            </p:cNvPr>
            <p:cNvSpPr/>
            <p:nvPr/>
          </p:nvSpPr>
          <p:spPr>
            <a:xfrm>
              <a:off x="767039" y="4472913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4060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矩形 142">
              <a:extLst>
                <a:ext uri="{FF2B5EF4-FFF2-40B4-BE49-F238E27FC236}">
                  <a16:creationId xmlns:a16="http://schemas.microsoft.com/office/drawing/2014/main" id="{4E0B37FB-08E0-4599-BC18-422D1279ACBA}"/>
                </a:ext>
              </a:extLst>
            </p:cNvPr>
            <p:cNvSpPr/>
            <p:nvPr/>
          </p:nvSpPr>
          <p:spPr>
            <a:xfrm>
              <a:off x="973893" y="4452563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2066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矩形 143">
              <a:extLst>
                <a:ext uri="{FF2B5EF4-FFF2-40B4-BE49-F238E27FC236}">
                  <a16:creationId xmlns:a16="http://schemas.microsoft.com/office/drawing/2014/main" id="{3EDF7C71-8323-4FB7-8B90-B021906A6CF2}"/>
                </a:ext>
              </a:extLst>
            </p:cNvPr>
            <p:cNvSpPr/>
            <p:nvPr/>
          </p:nvSpPr>
          <p:spPr>
            <a:xfrm>
              <a:off x="1183634" y="4443988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9767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矩形 144">
              <a:extLst>
                <a:ext uri="{FF2B5EF4-FFF2-40B4-BE49-F238E27FC236}">
                  <a16:creationId xmlns:a16="http://schemas.microsoft.com/office/drawing/2014/main" id="{41C2BA9E-73CD-4247-A76D-48726CB47805}"/>
                </a:ext>
              </a:extLst>
            </p:cNvPr>
            <p:cNvSpPr/>
            <p:nvPr/>
          </p:nvSpPr>
          <p:spPr>
            <a:xfrm>
              <a:off x="1390471" y="4424077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2131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矩形 145">
              <a:extLst>
                <a:ext uri="{FF2B5EF4-FFF2-40B4-BE49-F238E27FC236}">
                  <a16:creationId xmlns:a16="http://schemas.microsoft.com/office/drawing/2014/main" id="{D0E92B9D-A8F9-45FA-ABE2-D87EE8E31464}"/>
                </a:ext>
              </a:extLst>
            </p:cNvPr>
            <p:cNvSpPr/>
            <p:nvPr/>
          </p:nvSpPr>
          <p:spPr>
            <a:xfrm>
              <a:off x="1598276" y="4400951"/>
              <a:ext cx="40155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5349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7" name="组合 146">
            <a:extLst>
              <a:ext uri="{FF2B5EF4-FFF2-40B4-BE49-F238E27FC236}">
                <a16:creationId xmlns:a16="http://schemas.microsoft.com/office/drawing/2014/main" id="{97B2F105-45AE-43EB-9228-F103A46533AD}"/>
              </a:ext>
            </a:extLst>
          </p:cNvPr>
          <p:cNvGrpSpPr/>
          <p:nvPr/>
        </p:nvGrpSpPr>
        <p:grpSpPr>
          <a:xfrm>
            <a:off x="1508275" y="2714321"/>
            <a:ext cx="1244017" cy="2497914"/>
            <a:chOff x="4903234" y="3026295"/>
            <a:chExt cx="1244017" cy="2497914"/>
          </a:xfrm>
        </p:grpSpPr>
        <p:pic>
          <p:nvPicPr>
            <p:cNvPr id="148" name="图片 147">
              <a:extLst>
                <a:ext uri="{FF2B5EF4-FFF2-40B4-BE49-F238E27FC236}">
                  <a16:creationId xmlns:a16="http://schemas.microsoft.com/office/drawing/2014/main" id="{DDA49CD5-C794-43E2-A09C-1BB6A1CEBAC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flipV="1">
              <a:off x="5000525" y="4400679"/>
              <a:ext cx="1024546" cy="1008543"/>
            </a:xfrm>
            <a:prstGeom prst="rect">
              <a:avLst/>
            </a:prstGeom>
          </p:spPr>
        </p:pic>
        <p:pic>
          <p:nvPicPr>
            <p:cNvPr id="149" name="图片 148">
              <a:extLst>
                <a:ext uri="{FF2B5EF4-FFF2-40B4-BE49-F238E27FC236}">
                  <a16:creationId xmlns:a16="http://schemas.microsoft.com/office/drawing/2014/main" id="{0E5197B2-7292-4F75-B6B8-5F3EA097256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07119" y="3192971"/>
              <a:ext cx="1021414" cy="281350"/>
            </a:xfrm>
            <a:prstGeom prst="rect">
              <a:avLst/>
            </a:prstGeom>
          </p:spPr>
        </p:pic>
        <p:grpSp>
          <p:nvGrpSpPr>
            <p:cNvPr id="150" name="组合 149">
              <a:extLst>
                <a:ext uri="{FF2B5EF4-FFF2-40B4-BE49-F238E27FC236}">
                  <a16:creationId xmlns:a16="http://schemas.microsoft.com/office/drawing/2014/main" id="{2D186315-C79D-404E-9DF5-24B41262377F}"/>
                </a:ext>
              </a:extLst>
            </p:cNvPr>
            <p:cNvGrpSpPr/>
            <p:nvPr/>
          </p:nvGrpSpPr>
          <p:grpSpPr>
            <a:xfrm>
              <a:off x="4903234" y="3026295"/>
              <a:ext cx="1244017" cy="2497914"/>
              <a:chOff x="756147" y="3016617"/>
              <a:chExt cx="1244017" cy="2497914"/>
            </a:xfrm>
          </p:grpSpPr>
          <p:pic>
            <p:nvPicPr>
              <p:cNvPr id="151" name="图片 150">
                <a:extLst>
                  <a:ext uri="{FF2B5EF4-FFF2-40B4-BE49-F238E27FC236}">
                    <a16:creationId xmlns:a16="http://schemas.microsoft.com/office/drawing/2014/main" id="{5975A82D-DF06-40D9-B16C-C8F6144DB5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83562"/>
              <a:stretch/>
            </p:blipFill>
            <p:spPr>
              <a:xfrm flipV="1">
                <a:off x="852530" y="4062221"/>
                <a:ext cx="1025453" cy="198105"/>
              </a:xfrm>
              <a:prstGeom prst="rect">
                <a:avLst/>
              </a:prstGeom>
            </p:spPr>
          </p:pic>
          <p:sp>
            <p:nvSpPr>
              <p:cNvPr id="152" name="矩形 151">
                <a:extLst>
                  <a:ext uri="{FF2B5EF4-FFF2-40B4-BE49-F238E27FC236}">
                    <a16:creationId xmlns:a16="http://schemas.microsoft.com/office/drawing/2014/main" id="{A02BFFC4-0499-43F4-AE88-83FA59A7DD78}"/>
                  </a:ext>
                </a:extLst>
              </p:cNvPr>
              <p:cNvSpPr/>
              <p:nvPr/>
            </p:nvSpPr>
            <p:spPr>
              <a:xfrm rot="16200000">
                <a:off x="780703" y="3677207"/>
                <a:ext cx="355252" cy="18466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</a:t>
                </a:r>
                <a:r>
                  <a:rPr lang="zh-CN" alt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w</a:t>
                </a:r>
              </a:p>
            </p:txBody>
          </p:sp>
          <p:sp>
            <p:nvSpPr>
              <p:cNvPr id="153" name="矩形 152">
                <a:extLst>
                  <a:ext uri="{FF2B5EF4-FFF2-40B4-BE49-F238E27FC236}">
                    <a16:creationId xmlns:a16="http://schemas.microsoft.com/office/drawing/2014/main" id="{5F267CB0-3FF1-4893-B864-2EDEAD7BC147}"/>
                  </a:ext>
                </a:extLst>
              </p:cNvPr>
              <p:cNvSpPr/>
              <p:nvPr/>
            </p:nvSpPr>
            <p:spPr>
              <a:xfrm rot="16200000">
                <a:off x="861294" y="3679801"/>
                <a:ext cx="590334" cy="18466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lti-allelic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矩形 153">
                <a:extLst>
                  <a:ext uri="{FF2B5EF4-FFF2-40B4-BE49-F238E27FC236}">
                    <a16:creationId xmlns:a16="http://schemas.microsoft.com/office/drawing/2014/main" id="{4F5B010D-BF06-43F4-B701-61ECD58E8D80}"/>
                  </a:ext>
                </a:extLst>
              </p:cNvPr>
              <p:cNvSpPr/>
              <p:nvPr/>
            </p:nvSpPr>
            <p:spPr>
              <a:xfrm rot="16200000">
                <a:off x="1087910" y="3677207"/>
                <a:ext cx="530018" cy="18466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NA-edit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矩形 154">
                <a:extLst>
                  <a:ext uri="{FF2B5EF4-FFF2-40B4-BE49-F238E27FC236}">
                    <a16:creationId xmlns:a16="http://schemas.microsoft.com/office/drawing/2014/main" id="{5B376A68-E708-4DDA-8088-C982CE2CA4B2}"/>
                  </a:ext>
                </a:extLst>
              </p:cNvPr>
              <p:cNvSpPr/>
              <p:nvPr/>
            </p:nvSpPr>
            <p:spPr>
              <a:xfrm rot="16200000">
                <a:off x="1198412" y="3677207"/>
                <a:ext cx="751118" cy="18466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mmunoglobulin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矩形 155">
                <a:extLst>
                  <a:ext uri="{FF2B5EF4-FFF2-40B4-BE49-F238E27FC236}">
                    <a16:creationId xmlns:a16="http://schemas.microsoft.com/office/drawing/2014/main" id="{13BA5285-397B-45EB-82B7-19E1EDF598B5}"/>
                  </a:ext>
                </a:extLst>
              </p:cNvPr>
              <p:cNvSpPr/>
              <p:nvPr/>
            </p:nvSpPr>
            <p:spPr>
              <a:xfrm rot="16200000">
                <a:off x="1578716" y="3645799"/>
                <a:ext cx="413869" cy="18466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LA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57" name="图片 156">
                <a:extLst>
                  <a:ext uri="{FF2B5EF4-FFF2-40B4-BE49-F238E27FC236}">
                    <a16:creationId xmlns:a16="http://schemas.microsoft.com/office/drawing/2014/main" id="{39705E0D-9579-4237-A11E-128182B458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10484329" flipV="1">
                <a:off x="921773" y="4269897"/>
                <a:ext cx="49793" cy="130594"/>
              </a:xfrm>
              <a:prstGeom prst="rect">
                <a:avLst/>
              </a:prstGeom>
            </p:spPr>
          </p:pic>
          <p:pic>
            <p:nvPicPr>
              <p:cNvPr id="158" name="图片 157">
                <a:extLst>
                  <a:ext uri="{FF2B5EF4-FFF2-40B4-BE49-F238E27FC236}">
                    <a16:creationId xmlns:a16="http://schemas.microsoft.com/office/drawing/2014/main" id="{16408DB8-F969-4588-8241-39DD256446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10484329" flipV="1">
                <a:off x="1128669" y="4267801"/>
                <a:ext cx="49793" cy="130594"/>
              </a:xfrm>
              <a:prstGeom prst="rect">
                <a:avLst/>
              </a:prstGeom>
            </p:spPr>
          </p:pic>
          <p:pic>
            <p:nvPicPr>
              <p:cNvPr id="159" name="图片 158">
                <a:extLst>
                  <a:ext uri="{FF2B5EF4-FFF2-40B4-BE49-F238E27FC236}">
                    <a16:creationId xmlns:a16="http://schemas.microsoft.com/office/drawing/2014/main" id="{CA1CE330-16ED-4261-B363-9203BC9A5F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10484329" flipV="1">
                <a:off x="1340360" y="4265706"/>
                <a:ext cx="49793" cy="130594"/>
              </a:xfrm>
              <a:prstGeom prst="rect">
                <a:avLst/>
              </a:prstGeom>
            </p:spPr>
          </p:pic>
          <p:pic>
            <p:nvPicPr>
              <p:cNvPr id="160" name="图片 159">
                <a:extLst>
                  <a:ext uri="{FF2B5EF4-FFF2-40B4-BE49-F238E27FC236}">
                    <a16:creationId xmlns:a16="http://schemas.microsoft.com/office/drawing/2014/main" id="{49D1CBB7-66AE-4F54-AD2E-4E5F56821B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10484329" flipV="1">
                <a:off x="1545613" y="4264226"/>
                <a:ext cx="49793" cy="130594"/>
              </a:xfrm>
              <a:prstGeom prst="rect">
                <a:avLst/>
              </a:prstGeom>
            </p:spPr>
          </p:pic>
          <p:pic>
            <p:nvPicPr>
              <p:cNvPr id="161" name="图片 160">
                <a:extLst>
                  <a:ext uri="{FF2B5EF4-FFF2-40B4-BE49-F238E27FC236}">
                    <a16:creationId xmlns:a16="http://schemas.microsoft.com/office/drawing/2014/main" id="{1CD47366-5E24-4746-BA51-20ACF157AF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10484329" flipV="1">
                <a:off x="1749120" y="4264225"/>
                <a:ext cx="49793" cy="130594"/>
              </a:xfrm>
              <a:prstGeom prst="rect">
                <a:avLst/>
              </a:prstGeom>
            </p:spPr>
          </p:pic>
          <p:sp>
            <p:nvSpPr>
              <p:cNvPr id="162" name="矩形 161">
                <a:extLst>
                  <a:ext uri="{FF2B5EF4-FFF2-40B4-BE49-F238E27FC236}">
                    <a16:creationId xmlns:a16="http://schemas.microsoft.com/office/drawing/2014/main" id="{5CA618D3-DD6F-4BE6-9D90-FD6E2EB29A28}"/>
                  </a:ext>
                </a:extLst>
              </p:cNvPr>
              <p:cNvSpPr/>
              <p:nvPr/>
            </p:nvSpPr>
            <p:spPr>
              <a:xfrm>
                <a:off x="1164865" y="3016617"/>
                <a:ext cx="413869" cy="18466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USC</a:t>
                </a:r>
                <a:endParaRPr lang="zh-CN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矩形 162">
                <a:extLst>
                  <a:ext uri="{FF2B5EF4-FFF2-40B4-BE49-F238E27FC236}">
                    <a16:creationId xmlns:a16="http://schemas.microsoft.com/office/drawing/2014/main" id="{E2B3BAF5-98CD-4F19-B67A-C4343FC0780F}"/>
                  </a:ext>
                </a:extLst>
              </p:cNvPr>
              <p:cNvSpPr/>
              <p:nvPr/>
            </p:nvSpPr>
            <p:spPr>
              <a:xfrm>
                <a:off x="788711" y="3134243"/>
                <a:ext cx="342823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504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矩形 163">
                <a:extLst>
                  <a:ext uri="{FF2B5EF4-FFF2-40B4-BE49-F238E27FC236}">
                    <a16:creationId xmlns:a16="http://schemas.microsoft.com/office/drawing/2014/main" id="{69129B24-5853-409C-8E38-EE133476BD62}"/>
                  </a:ext>
                </a:extLst>
              </p:cNvPr>
              <p:cNvSpPr/>
              <p:nvPr/>
            </p:nvSpPr>
            <p:spPr>
              <a:xfrm>
                <a:off x="994696" y="3177434"/>
                <a:ext cx="342823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478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矩形 164">
                <a:extLst>
                  <a:ext uri="{FF2B5EF4-FFF2-40B4-BE49-F238E27FC236}">
                    <a16:creationId xmlns:a16="http://schemas.microsoft.com/office/drawing/2014/main" id="{1981B632-26AE-4672-BD7B-3573CD5367EF}"/>
                  </a:ext>
                </a:extLst>
              </p:cNvPr>
              <p:cNvSpPr/>
              <p:nvPr/>
            </p:nvSpPr>
            <p:spPr>
              <a:xfrm>
                <a:off x="1201979" y="3223143"/>
                <a:ext cx="342823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450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6" name="矩形 165">
                <a:extLst>
                  <a:ext uri="{FF2B5EF4-FFF2-40B4-BE49-F238E27FC236}">
                    <a16:creationId xmlns:a16="http://schemas.microsoft.com/office/drawing/2014/main" id="{8BE8E158-CE18-45F9-B9CF-EF854B99CFD5}"/>
                  </a:ext>
                </a:extLst>
              </p:cNvPr>
              <p:cNvSpPr/>
              <p:nvPr/>
            </p:nvSpPr>
            <p:spPr>
              <a:xfrm>
                <a:off x="1406609" y="3267326"/>
                <a:ext cx="342823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428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矩形 166">
                <a:extLst>
                  <a:ext uri="{FF2B5EF4-FFF2-40B4-BE49-F238E27FC236}">
                    <a16:creationId xmlns:a16="http://schemas.microsoft.com/office/drawing/2014/main" id="{D678EBFA-35CA-4A24-8B12-DED5EA549D71}"/>
                  </a:ext>
                </a:extLst>
              </p:cNvPr>
              <p:cNvSpPr/>
              <p:nvPr/>
            </p:nvSpPr>
            <p:spPr>
              <a:xfrm>
                <a:off x="1613892" y="3307545"/>
                <a:ext cx="342823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400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矩形 167">
                <a:extLst>
                  <a:ext uri="{FF2B5EF4-FFF2-40B4-BE49-F238E27FC236}">
                    <a16:creationId xmlns:a16="http://schemas.microsoft.com/office/drawing/2014/main" id="{0AD1B5F4-295B-4405-839A-39B1DD5D995E}"/>
                  </a:ext>
                </a:extLst>
              </p:cNvPr>
              <p:cNvSpPr/>
              <p:nvPr/>
            </p:nvSpPr>
            <p:spPr>
              <a:xfrm>
                <a:off x="756147" y="5345254"/>
                <a:ext cx="434575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15897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矩形 168">
                <a:extLst>
                  <a:ext uri="{FF2B5EF4-FFF2-40B4-BE49-F238E27FC236}">
                    <a16:creationId xmlns:a16="http://schemas.microsoft.com/office/drawing/2014/main" id="{BE449E79-D74E-4195-B10B-EABED53E27A0}"/>
                  </a:ext>
                </a:extLst>
              </p:cNvPr>
              <p:cNvSpPr/>
              <p:nvPr/>
            </p:nvSpPr>
            <p:spPr>
              <a:xfrm>
                <a:off x="958329" y="5275684"/>
                <a:ext cx="430442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17377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矩形 169">
                <a:extLst>
                  <a:ext uri="{FF2B5EF4-FFF2-40B4-BE49-F238E27FC236}">
                    <a16:creationId xmlns:a16="http://schemas.microsoft.com/office/drawing/2014/main" id="{2945EB14-0FF6-497B-9A8E-8E2EEEA5739F}"/>
                  </a:ext>
                </a:extLst>
              </p:cNvPr>
              <p:cNvSpPr/>
              <p:nvPr/>
            </p:nvSpPr>
            <p:spPr>
              <a:xfrm>
                <a:off x="1169060" y="5165597"/>
                <a:ext cx="429547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03074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矩形 170">
                <a:extLst>
                  <a:ext uri="{FF2B5EF4-FFF2-40B4-BE49-F238E27FC236}">
                    <a16:creationId xmlns:a16="http://schemas.microsoft.com/office/drawing/2014/main" id="{9F502333-725F-437E-8405-BE3E83A31C6A}"/>
                  </a:ext>
                </a:extLst>
              </p:cNvPr>
              <p:cNvSpPr/>
              <p:nvPr/>
            </p:nvSpPr>
            <p:spPr>
              <a:xfrm>
                <a:off x="1383833" y="4782503"/>
                <a:ext cx="401557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17348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矩形 171">
                <a:extLst>
                  <a:ext uri="{FF2B5EF4-FFF2-40B4-BE49-F238E27FC236}">
                    <a16:creationId xmlns:a16="http://schemas.microsoft.com/office/drawing/2014/main" id="{2FB45E00-55AC-41C1-82C3-B28431760453}"/>
                  </a:ext>
                </a:extLst>
              </p:cNvPr>
              <p:cNvSpPr/>
              <p:nvPr/>
            </p:nvSpPr>
            <p:spPr>
              <a:xfrm>
                <a:off x="1598607" y="4748840"/>
                <a:ext cx="401557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65834</a:t>
                </a:r>
                <a:endParaRPr lang="zh-CN" alt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id="{52E1B4AE-8E63-40C2-BC24-C58CAB938C38}"/>
              </a:ext>
            </a:extLst>
          </p:cNvPr>
          <p:cNvCxnSpPr/>
          <p:nvPr/>
        </p:nvCxnSpPr>
        <p:spPr>
          <a:xfrm>
            <a:off x="3896150" y="2861139"/>
            <a:ext cx="0" cy="2329236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直接连接符 173">
            <a:extLst>
              <a:ext uri="{FF2B5EF4-FFF2-40B4-BE49-F238E27FC236}">
                <a16:creationId xmlns:a16="http://schemas.microsoft.com/office/drawing/2014/main" id="{6259D7A4-4DEF-4B9A-B631-13560FDD8E85}"/>
              </a:ext>
            </a:extLst>
          </p:cNvPr>
          <p:cNvCxnSpPr/>
          <p:nvPr/>
        </p:nvCxnSpPr>
        <p:spPr>
          <a:xfrm>
            <a:off x="2719899" y="2861139"/>
            <a:ext cx="0" cy="2329236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859773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图表 14">
            <a:extLst>
              <a:ext uri="{FF2B5EF4-FFF2-40B4-BE49-F238E27FC236}">
                <a16:creationId xmlns:a16="http://schemas.microsoft.com/office/drawing/2014/main" id="{7074CF25-A738-4222-B2AC-F7FE64EB2AE1}"/>
              </a:ext>
            </a:extLst>
          </p:cNvPr>
          <p:cNvGraphicFramePr/>
          <p:nvPr>
            <p:extLst/>
          </p:nvPr>
        </p:nvGraphicFramePr>
        <p:xfrm>
          <a:off x="2438150" y="3432646"/>
          <a:ext cx="2299063" cy="16083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7" name="矩形 16">
            <a:extLst>
              <a:ext uri="{FF2B5EF4-FFF2-40B4-BE49-F238E27FC236}">
                <a16:creationId xmlns:a16="http://schemas.microsoft.com/office/drawing/2014/main" id="{EFE06137-320C-442C-BCCA-E004C3A04A50}"/>
              </a:ext>
            </a:extLst>
          </p:cNvPr>
          <p:cNvSpPr/>
          <p:nvPr/>
        </p:nvSpPr>
        <p:spPr>
          <a:xfrm>
            <a:off x="2987169" y="4925606"/>
            <a:ext cx="126188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utation counts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AA82F8C3-857E-466C-879C-B8837E8D517C}"/>
              </a:ext>
            </a:extLst>
          </p:cNvPr>
          <p:cNvSpPr/>
          <p:nvPr/>
        </p:nvSpPr>
        <p:spPr>
          <a:xfrm rot="16200000">
            <a:off x="1759338" y="4069166"/>
            <a:ext cx="126188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mutation counts</a:t>
            </a: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AF1ECBCF-4F7A-4D62-B2A5-B0FCDDDBAF0A}"/>
              </a:ext>
            </a:extLst>
          </p:cNvPr>
          <p:cNvSpPr/>
          <p:nvPr/>
        </p:nvSpPr>
        <p:spPr>
          <a:xfrm>
            <a:off x="3390389" y="3340313"/>
            <a:ext cx="588742" cy="2308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CA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0FF532B1-97C4-4209-9254-24AD67DDF499}"/>
              </a:ext>
            </a:extLst>
          </p:cNvPr>
          <p:cNvSpPr/>
          <p:nvPr/>
        </p:nvSpPr>
        <p:spPr>
          <a:xfrm>
            <a:off x="5597806" y="3340313"/>
            <a:ext cx="568319" cy="2308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BM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D13DB861-6A5B-417B-9638-92E9C4697D7B}"/>
              </a:ext>
            </a:extLst>
          </p:cNvPr>
          <p:cNvSpPr/>
          <p:nvPr/>
        </p:nvSpPr>
        <p:spPr>
          <a:xfrm>
            <a:off x="1077785" y="3340313"/>
            <a:ext cx="568319" cy="2308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SC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" name="图表 25">
            <a:extLst>
              <a:ext uri="{FF2B5EF4-FFF2-40B4-BE49-F238E27FC236}">
                <a16:creationId xmlns:a16="http://schemas.microsoft.com/office/drawing/2014/main" id="{71325B4A-9A00-424D-BF56-EDDBE2AA5225}"/>
              </a:ext>
            </a:extLst>
          </p:cNvPr>
          <p:cNvGraphicFramePr/>
          <p:nvPr>
            <p:extLst/>
          </p:nvPr>
        </p:nvGraphicFramePr>
        <p:xfrm>
          <a:off x="4730525" y="3432646"/>
          <a:ext cx="2231516" cy="16083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7" name="矩形 26">
            <a:extLst>
              <a:ext uri="{FF2B5EF4-FFF2-40B4-BE49-F238E27FC236}">
                <a16:creationId xmlns:a16="http://schemas.microsoft.com/office/drawing/2014/main" id="{7C0BBE80-B9A2-4F27-9310-EC4F448657A4}"/>
              </a:ext>
            </a:extLst>
          </p:cNvPr>
          <p:cNvSpPr/>
          <p:nvPr/>
        </p:nvSpPr>
        <p:spPr>
          <a:xfrm rot="16200000">
            <a:off x="4060212" y="4069166"/>
            <a:ext cx="126188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mutation counts</a:t>
            </a: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45194232-F465-40E0-B13D-E9B0EDD58244}"/>
              </a:ext>
            </a:extLst>
          </p:cNvPr>
          <p:cNvSpPr/>
          <p:nvPr/>
        </p:nvSpPr>
        <p:spPr>
          <a:xfrm>
            <a:off x="5313695" y="4925606"/>
            <a:ext cx="126188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utation counts</a:t>
            </a:r>
          </a:p>
        </p:txBody>
      </p:sp>
      <p:graphicFrame>
        <p:nvGraphicFramePr>
          <p:cNvPr id="29" name="图表 28">
            <a:extLst>
              <a:ext uri="{FF2B5EF4-FFF2-40B4-BE49-F238E27FC236}">
                <a16:creationId xmlns:a16="http://schemas.microsoft.com/office/drawing/2014/main" id="{E4E65D1D-F8CD-4B4D-9C2C-EFE27983F6FA}"/>
              </a:ext>
            </a:extLst>
          </p:cNvPr>
          <p:cNvGraphicFramePr/>
          <p:nvPr>
            <p:extLst/>
          </p:nvPr>
        </p:nvGraphicFramePr>
        <p:xfrm>
          <a:off x="135689" y="3432646"/>
          <a:ext cx="2299063" cy="16083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0" name="矩形 29">
            <a:extLst>
              <a:ext uri="{FF2B5EF4-FFF2-40B4-BE49-F238E27FC236}">
                <a16:creationId xmlns:a16="http://schemas.microsoft.com/office/drawing/2014/main" id="{E36D34FF-EFB0-4C17-9E72-FC560C666FE9}"/>
              </a:ext>
            </a:extLst>
          </p:cNvPr>
          <p:cNvSpPr/>
          <p:nvPr/>
        </p:nvSpPr>
        <p:spPr>
          <a:xfrm rot="16200000">
            <a:off x="-513136" y="4069166"/>
            <a:ext cx="126188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mutation counts</a:t>
            </a: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0FA91EEA-AD30-4D5E-85BF-0D6AC0C82FF5}"/>
              </a:ext>
            </a:extLst>
          </p:cNvPr>
          <p:cNvSpPr/>
          <p:nvPr/>
        </p:nvSpPr>
        <p:spPr>
          <a:xfrm>
            <a:off x="787125" y="4925606"/>
            <a:ext cx="126188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mutation counts</a:t>
            </a: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15F19F09-CA21-478D-A66D-5FCA6BA983AA}"/>
              </a:ext>
            </a:extLst>
          </p:cNvPr>
          <p:cNvSpPr/>
          <p:nvPr/>
        </p:nvSpPr>
        <p:spPr>
          <a:xfrm>
            <a:off x="1329173" y="5729724"/>
            <a:ext cx="4199654" cy="13315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2. DNA and RNA somatic mutation counts for each case of three cancer types. </a:t>
            </a: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catter plot of DNA and RNA somatic mutation counts for each case across three types of cancer (LUSC, BLCA and GBM). Regression lines were fitted. </a:t>
            </a:r>
            <a:endParaRPr lang="zh-CN" altLang="zh-CN" sz="11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53374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EB01E280-162E-491E-BB70-B7437570B277}"/>
              </a:ext>
            </a:extLst>
          </p:cNvPr>
          <p:cNvSpPr/>
          <p:nvPr/>
        </p:nvSpPr>
        <p:spPr>
          <a:xfrm>
            <a:off x="3154680" y="5212235"/>
            <a:ext cx="3192780" cy="13315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3. Feature effects on predicted probabilities. </a:t>
            </a: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nsity scatter plot of SHAP values for training dataset. SHAP values represented the impact level for predicted probabilities. </a:t>
            </a:r>
            <a:endParaRPr lang="zh-CN" altLang="zh-CN" sz="11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6" name="图形 1">
            <a:extLst>
              <a:ext uri="{FF2B5EF4-FFF2-40B4-BE49-F238E27FC236}">
                <a16:creationId xmlns:a16="http://schemas.microsoft.com/office/drawing/2014/main" id="{C0E03731-4728-49A4-BB9C-1CE16D4796F4}"/>
              </a:ext>
            </a:extLst>
          </p:cNvPr>
          <p:cNvPicPr/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67640" y="3512821"/>
            <a:ext cx="2987040" cy="4476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71314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EB01E280-162E-491E-BB70-B7437570B277}"/>
              </a:ext>
            </a:extLst>
          </p:cNvPr>
          <p:cNvSpPr/>
          <p:nvPr/>
        </p:nvSpPr>
        <p:spPr>
          <a:xfrm>
            <a:off x="1017270" y="8122920"/>
            <a:ext cx="4823460" cy="569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4. Venn diagrams describing the relationship between DNA somatic mutations and RNA-SSNV predicted RNA somatic mutations. 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53B7917A-B78E-4E8F-B70C-6ABFB62E2A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7270" y="3947160"/>
            <a:ext cx="4823460" cy="4175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32031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EB01E280-162E-491E-BB70-B7437570B277}"/>
              </a:ext>
            </a:extLst>
          </p:cNvPr>
          <p:cNvSpPr/>
          <p:nvPr/>
        </p:nvSpPr>
        <p:spPr>
          <a:xfrm>
            <a:off x="1217755" y="5212235"/>
            <a:ext cx="4422489" cy="569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5. SHAP value contributions for top 10 features of false negative predictions in LUSC. </a:t>
            </a:r>
          </a:p>
        </p:txBody>
      </p:sp>
      <p:pic>
        <p:nvPicPr>
          <p:cNvPr id="4" name="图形 3">
            <a:extLst>
              <a:ext uri="{FF2B5EF4-FFF2-40B4-BE49-F238E27FC236}">
                <a16:creationId xmlns:a16="http://schemas.microsoft.com/office/drawing/2014/main" id="{EAEDA42B-C2CE-41EE-B6B7-D4F4A525A1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217755" y="2309015"/>
            <a:ext cx="4422490" cy="29032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13260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EB01E280-162E-491E-BB70-B7437570B277}"/>
              </a:ext>
            </a:extLst>
          </p:cNvPr>
          <p:cNvSpPr/>
          <p:nvPr/>
        </p:nvSpPr>
        <p:spPr>
          <a:xfrm>
            <a:off x="1780679" y="5323956"/>
            <a:ext cx="3192780" cy="8236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6. Distribution of selective expression ratios in DNA-only mutations for three types of cancer</a:t>
            </a: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AC7792ED-78DA-48D2-8803-DADA748CBB0A}"/>
              </a:ext>
            </a:extLst>
          </p:cNvPr>
          <p:cNvSpPr/>
          <p:nvPr/>
        </p:nvSpPr>
        <p:spPr>
          <a:xfrm rot="16200000">
            <a:off x="1209898" y="4042763"/>
            <a:ext cx="139172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ive Expression Ratio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7" name="图表 6">
                <a:extLst>
                  <a:ext uri="{FF2B5EF4-FFF2-40B4-BE49-F238E27FC236}">
                    <a16:creationId xmlns:a16="http://schemas.microsoft.com/office/drawing/2014/main" id="{36286848-776D-4C60-A786-06A9401B099D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90420326"/>
                  </p:ext>
                </p:extLst>
              </p:nvPr>
            </p:nvGraphicFramePr>
            <p:xfrm>
              <a:off x="1967123" y="3267308"/>
              <a:ext cx="2601170" cy="1766355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7" name="图表 6">
                <a:extLst>
                  <a:ext uri="{FF2B5EF4-FFF2-40B4-BE49-F238E27FC236}">
                    <a16:creationId xmlns:a16="http://schemas.microsoft.com/office/drawing/2014/main" id="{36286848-776D-4C60-A786-06A9401B099D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967123" y="3267308"/>
                <a:ext cx="2601170" cy="1766355"/>
              </a:xfrm>
              <a:prstGeom prst="rect">
                <a:avLst/>
              </a:prstGeom>
            </p:spPr>
          </p:pic>
        </mc:Fallback>
      </mc:AlternateContent>
      <p:sp>
        <p:nvSpPr>
          <p:cNvPr id="8" name="矩形 7">
            <a:extLst>
              <a:ext uri="{FF2B5EF4-FFF2-40B4-BE49-F238E27FC236}">
                <a16:creationId xmlns:a16="http://schemas.microsoft.com/office/drawing/2014/main" id="{8FA5F3FA-093F-44EE-AFA1-315EDA473F80}"/>
              </a:ext>
            </a:extLst>
          </p:cNvPr>
          <p:cNvSpPr/>
          <p:nvPr/>
        </p:nvSpPr>
        <p:spPr>
          <a:xfrm>
            <a:off x="3725553" y="4922224"/>
            <a:ext cx="588742" cy="20005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CA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05A897AA-8B34-422E-BCFC-DA5D0D190E81}"/>
              </a:ext>
            </a:extLst>
          </p:cNvPr>
          <p:cNvSpPr/>
          <p:nvPr/>
        </p:nvSpPr>
        <p:spPr>
          <a:xfrm>
            <a:off x="3157234" y="4933635"/>
            <a:ext cx="568319" cy="20005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BM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D63EB8FA-2E4C-41DF-8A66-91652CD1048E}"/>
              </a:ext>
            </a:extLst>
          </p:cNvPr>
          <p:cNvSpPr/>
          <p:nvPr/>
        </p:nvSpPr>
        <p:spPr>
          <a:xfrm>
            <a:off x="2588915" y="4933635"/>
            <a:ext cx="568319" cy="20005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SC</a:t>
            </a: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6B804F96-1432-4FF3-8B1C-1A19661BFFF8}"/>
              </a:ext>
            </a:extLst>
          </p:cNvPr>
          <p:cNvCxnSpPr>
            <a:cxnSpLocks/>
          </p:cNvCxnSpPr>
          <p:nvPr/>
        </p:nvCxnSpPr>
        <p:spPr>
          <a:xfrm>
            <a:off x="2785135" y="3560933"/>
            <a:ext cx="546683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FFA3321F-CA8C-4CDF-98F7-40462E84F92D}"/>
              </a:ext>
            </a:extLst>
          </p:cNvPr>
          <p:cNvCxnSpPr>
            <a:cxnSpLocks/>
          </p:cNvCxnSpPr>
          <p:nvPr/>
        </p:nvCxnSpPr>
        <p:spPr>
          <a:xfrm flipV="1">
            <a:off x="2789613" y="3561886"/>
            <a:ext cx="0" cy="317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A8D882D0-64FE-4E26-A21F-D07C88F001E0}"/>
              </a:ext>
            </a:extLst>
          </p:cNvPr>
          <p:cNvCxnSpPr>
            <a:cxnSpLocks/>
          </p:cNvCxnSpPr>
          <p:nvPr/>
        </p:nvCxnSpPr>
        <p:spPr>
          <a:xfrm flipV="1">
            <a:off x="3329442" y="3566181"/>
            <a:ext cx="0" cy="317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E6981896-C6E8-442D-8A1D-49100E0FBF63}"/>
              </a:ext>
            </a:extLst>
          </p:cNvPr>
          <p:cNvCxnSpPr>
            <a:cxnSpLocks/>
          </p:cNvCxnSpPr>
          <p:nvPr/>
        </p:nvCxnSpPr>
        <p:spPr>
          <a:xfrm>
            <a:off x="3379467" y="3559262"/>
            <a:ext cx="546683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E82F070E-2A96-4710-948A-9BE0CC0C6082}"/>
              </a:ext>
            </a:extLst>
          </p:cNvPr>
          <p:cNvCxnSpPr>
            <a:cxnSpLocks/>
          </p:cNvCxnSpPr>
          <p:nvPr/>
        </p:nvCxnSpPr>
        <p:spPr>
          <a:xfrm flipV="1">
            <a:off x="3377069" y="3560215"/>
            <a:ext cx="0" cy="317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B8248CF5-004B-4135-AB4C-E962230A0547}"/>
              </a:ext>
            </a:extLst>
          </p:cNvPr>
          <p:cNvCxnSpPr>
            <a:cxnSpLocks/>
          </p:cNvCxnSpPr>
          <p:nvPr/>
        </p:nvCxnSpPr>
        <p:spPr>
          <a:xfrm flipV="1">
            <a:off x="3922722" y="3564510"/>
            <a:ext cx="0" cy="317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99815400-F736-468C-8B17-96A279AF652A}"/>
              </a:ext>
            </a:extLst>
          </p:cNvPr>
          <p:cNvSpPr txBox="1"/>
          <p:nvPr/>
        </p:nvSpPr>
        <p:spPr>
          <a:xfrm>
            <a:off x="3510603" y="3494910"/>
            <a:ext cx="272762" cy="268447"/>
          </a:xfrm>
          <a:prstGeom prst="rect">
            <a:avLst/>
          </a:prstGeom>
          <a:noFill/>
        </p:spPr>
        <p:txBody>
          <a:bodyPr wrap="square" lIns="0" tIns="0" rIns="0" bIns="0" rtlCol="0" anchor="ctr">
            <a:noAutofit/>
          </a:bodyPr>
          <a:lstStyle/>
          <a:p>
            <a:pPr algn="ctr"/>
            <a:r>
              <a:rPr lang="en-US" altLang="zh-CN" sz="600" b="1" dirty="0"/>
              <a:t>5.63E-6</a:t>
            </a:r>
            <a:endParaRPr lang="zh-CN" altLang="en-US" sz="6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32CC06D-2C01-400F-B033-8C5E6D279320}"/>
              </a:ext>
            </a:extLst>
          </p:cNvPr>
          <p:cNvSpPr txBox="1"/>
          <p:nvPr/>
        </p:nvSpPr>
        <p:spPr>
          <a:xfrm>
            <a:off x="2922095" y="3498065"/>
            <a:ext cx="272762" cy="268447"/>
          </a:xfrm>
          <a:prstGeom prst="rect">
            <a:avLst/>
          </a:prstGeom>
          <a:noFill/>
        </p:spPr>
        <p:txBody>
          <a:bodyPr wrap="square" lIns="0" tIns="0" rIns="0" bIns="0" rtlCol="0" anchor="ctr">
            <a:noAutofit/>
          </a:bodyPr>
          <a:lstStyle/>
          <a:p>
            <a:pPr algn="ctr"/>
            <a:r>
              <a:rPr lang="en-US" altLang="zh-CN" sz="600" b="1" dirty="0"/>
              <a:t>3.0E-3</a:t>
            </a:r>
            <a:endParaRPr lang="zh-CN" altLang="en-US" sz="600" b="1" dirty="0"/>
          </a:p>
        </p:txBody>
      </p:sp>
    </p:spTree>
    <p:extLst>
      <p:ext uri="{BB962C8B-B14F-4D97-AF65-F5344CB8AC3E}">
        <p14:creationId xmlns:p14="http://schemas.microsoft.com/office/powerpoint/2010/main" val="15650943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EB01E280-162E-491E-BB70-B7437570B277}"/>
              </a:ext>
            </a:extLst>
          </p:cNvPr>
          <p:cNvSpPr/>
          <p:nvPr/>
        </p:nvSpPr>
        <p:spPr>
          <a:xfrm>
            <a:off x="1062904" y="9734600"/>
            <a:ext cx="4617987" cy="3158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1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7. Model performance for adding extra dataset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ADF8BD8-8F11-4459-A605-2EE07C37610B}"/>
              </a:ext>
            </a:extLst>
          </p:cNvPr>
          <p:cNvSpPr txBox="1"/>
          <p:nvPr/>
        </p:nvSpPr>
        <p:spPr>
          <a:xfrm>
            <a:off x="1747635" y="361376"/>
            <a:ext cx="32485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Performance within testing set</a:t>
            </a:r>
            <a:endParaRPr lang="zh-CN" altLang="en-US" sz="1600" dirty="0"/>
          </a:p>
        </p:txBody>
      </p:sp>
      <p:pic>
        <p:nvPicPr>
          <p:cNvPr id="29" name="Picture 2">
            <a:extLst>
              <a:ext uri="{FF2B5EF4-FFF2-40B4-BE49-F238E27FC236}">
                <a16:creationId xmlns:a16="http://schemas.microsoft.com/office/drawing/2014/main" id="{A940E22B-2026-40BE-AB5F-E5B23719B3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004" y="731049"/>
            <a:ext cx="5122926" cy="36146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1E704A64-1790-4DDC-89F6-A1436FE66EB8}"/>
              </a:ext>
            </a:extLst>
          </p:cNvPr>
          <p:cNvSpPr txBox="1"/>
          <p:nvPr/>
        </p:nvSpPr>
        <p:spPr>
          <a:xfrm>
            <a:off x="155835" y="5571621"/>
            <a:ext cx="4321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Performance within LUSC validation set</a:t>
            </a:r>
            <a:endParaRPr lang="zh-CN" altLang="en-US" sz="160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04AA833A-15AE-4DA9-841A-079BB85A45C7}"/>
              </a:ext>
            </a:extLst>
          </p:cNvPr>
          <p:cNvSpPr txBox="1"/>
          <p:nvPr/>
        </p:nvSpPr>
        <p:spPr>
          <a:xfrm>
            <a:off x="3489385" y="5571621"/>
            <a:ext cx="43210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Performance within BLCA validation set</a:t>
            </a:r>
            <a:endParaRPr lang="zh-CN" altLang="en-US" sz="1600" dirty="0"/>
          </a:p>
        </p:txBody>
      </p:sp>
      <p:pic>
        <p:nvPicPr>
          <p:cNvPr id="35" name="Picture 5">
            <a:extLst>
              <a:ext uri="{FF2B5EF4-FFF2-40B4-BE49-F238E27FC236}">
                <a16:creationId xmlns:a16="http://schemas.microsoft.com/office/drawing/2014/main" id="{D27848BC-A4D2-4A76-AF35-5D80BC4B4A0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079" y="6096000"/>
            <a:ext cx="3044801" cy="24476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7">
            <a:extLst>
              <a:ext uri="{FF2B5EF4-FFF2-40B4-BE49-F238E27FC236}">
                <a16:creationId xmlns:a16="http://schemas.microsoft.com/office/drawing/2014/main" id="{BE796F58-B93F-4CA5-BC7A-5F844DE3F1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6140" y="6096000"/>
            <a:ext cx="3044801" cy="24476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12B365CC-0C3A-4BD0-A87D-C990B37AFF6C}"/>
              </a:ext>
            </a:extLst>
          </p:cNvPr>
          <p:cNvSpPr txBox="1"/>
          <p:nvPr/>
        </p:nvSpPr>
        <p:spPr>
          <a:xfrm>
            <a:off x="628698" y="4232261"/>
            <a:ext cx="436746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recision: 0.884</a:t>
            </a:r>
          </a:p>
          <a:p>
            <a:r>
              <a:rPr lang="en-US" altLang="zh-CN" dirty="0"/>
              <a:t>Recall: 0.897</a:t>
            </a:r>
          </a:p>
          <a:p>
            <a:r>
              <a:rPr lang="en-US" altLang="zh-CN" dirty="0"/>
              <a:t>P-R AUC: 0.948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123674A-FE28-46CD-B899-AFAE08FF90DA}"/>
              </a:ext>
            </a:extLst>
          </p:cNvPr>
          <p:cNvSpPr txBox="1"/>
          <p:nvPr/>
        </p:nvSpPr>
        <p:spPr>
          <a:xfrm>
            <a:off x="313079" y="8677477"/>
            <a:ext cx="22574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recision: 0.869</a:t>
            </a:r>
          </a:p>
          <a:p>
            <a:r>
              <a:rPr lang="en-US" altLang="zh-CN" dirty="0"/>
              <a:t>Recall: 0.900</a:t>
            </a:r>
          </a:p>
          <a:p>
            <a:r>
              <a:rPr lang="en-US" altLang="zh-CN" dirty="0"/>
              <a:t>P-R AUC: 0.939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D4742708-134E-4159-8928-8859FCF5ED95}"/>
              </a:ext>
            </a:extLst>
          </p:cNvPr>
          <p:cNvSpPr txBox="1"/>
          <p:nvPr/>
        </p:nvSpPr>
        <p:spPr>
          <a:xfrm>
            <a:off x="3606140" y="8669030"/>
            <a:ext cx="436746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recision: 0.869</a:t>
            </a:r>
          </a:p>
          <a:p>
            <a:r>
              <a:rPr lang="en-US" altLang="zh-CN" dirty="0"/>
              <a:t>Recall: 0.879</a:t>
            </a:r>
          </a:p>
          <a:p>
            <a:r>
              <a:rPr lang="en-US" altLang="zh-CN" dirty="0"/>
              <a:t>P-R AUC: 0.937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28089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9</TotalTime>
  <Words>288</Words>
  <Application>Microsoft Office PowerPoint</Application>
  <PresentationFormat>宽屏</PresentationFormat>
  <Paragraphs>85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pz226</dc:creator>
  <cp:lastModifiedBy>Qihan</cp:lastModifiedBy>
  <cp:revision>15</cp:revision>
  <dcterms:created xsi:type="dcterms:W3CDTF">2022-01-16T14:46:28Z</dcterms:created>
  <dcterms:modified xsi:type="dcterms:W3CDTF">2022-03-29T14:52:22Z</dcterms:modified>
</cp:coreProperties>
</file>